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8.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7.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0">
          <p15:clr>
            <a:srgbClr val="A4A3A4"/>
          </p15:clr>
        </p15:guide>
        <p15:guide id="2" pos="495">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009193"/>
    <a:srgbClr val="D82732"/>
    <a:srgbClr val="A5B6D2"/>
    <a:srgbClr val="388CA2"/>
    <a:srgbClr val="664E83"/>
    <a:srgbClr val="7D9844"/>
    <a:srgbClr val="3A6495"/>
  </p:clrMru>
  <p:extLst>
    <p:ext uri="{E76CE94A-603C-4142-B9EB-6D1370010A27}">
      <p14:discardImageEditData xmlns:p14="http://schemas.microsoft.com/office/powerpoint/2010/main" xmlns="" val="0"/>
    </p:ext>
    <p:ext uri="{D31A062A-798A-4329-ABDD-BBA856620510}">
      <p14:defaultImageDpi xmlns:p14="http://schemas.microsoft.com/office/powerpoint/2010/main" xmlns="" val="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811"/>
    <p:restoredTop sz="98762" autoAdjust="0"/>
  </p:normalViewPr>
  <p:slideViewPr>
    <p:cSldViewPr snapToObjects="1">
      <p:cViewPr>
        <p:scale>
          <a:sx n="201" d="100"/>
          <a:sy n="201" d="100"/>
        </p:scale>
        <p:origin x="-84" y="-78"/>
      </p:cViewPr>
      <p:guideLst>
        <p:guide orient="horz" pos="2071"/>
        <p:guide pos="4215"/>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ovcarelab:Desktop:Josh%20Master's%20Files:20181205-LGSC-Combo-STATS-For%20Paper.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ovcarelab:Desktop:Josh%20Master's%20Files:20181205-LGSC-Combo-STATS-For%20Pape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ovcarelab:Desktop:Josh%20Master's%20Files:20181205-LGSC-Combo-STATS-For%20Paper.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ovcarelab:Desktop:Josh%20Master's%20Files:20181205-LGSC-Combo-STATS-For%20Paper.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Macintosh%20HD:Users:ovcarelab:Desktop:Josh%20Master's%20Files:Erlotinib-Sel-Project:MTS%20and%20CV:Incucyte%20Growth%20Curves:Incucyte%20MasterFile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Macintosh%20HD:Users:ovcarelab:Desktop:Josh%20Master's%20Files:Erlotinib-Sel-Project:MTS%20and%20CV:Incucyte%20Growth%20Curves:Incucyte%20MasterFile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Macintosh%20HD:Users:ovcarelab:Desktop:Josh%20Master's%20Files:Erlotinib-Sel-Project:MTS%20and%20CV:Incucyte%20Growth%20Curves:Incucyte%20MasterFile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Macintosh%20HD:Users:ovcarelab:Desktop:Josh%20Master's%20Files:Erlotinib-Sel-Project:MTS%20and%20CV:Incucyte%20Growth%20Curves:Incucyte%20MasterFile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lang val="en-IN"/>
  <c:style val="1"/>
  <c:chart>
    <c:plotArea>
      <c:layout>
        <c:manualLayout>
          <c:layoutTarget val="inner"/>
          <c:xMode val="edge"/>
          <c:yMode val="edge"/>
          <c:x val="0.18385548267235505"/>
          <c:y val="0.19634449823024003"/>
          <c:w val="0.67483288393586005"/>
          <c:h val="0.62295413684605405"/>
        </c:manualLayout>
      </c:layout>
      <c:barChart>
        <c:barDir val="col"/>
        <c:grouping val="clustered"/>
        <c:ser>
          <c:idx val="0"/>
          <c:order val="0"/>
          <c:tx>
            <c:strRef>
              <c:f>'[5]Combined Graphs'!$W$110</c:f>
              <c:strCache>
                <c:ptCount val="1"/>
                <c:pt idx="0">
                  <c:v>MTS</c:v>
                </c:pt>
              </c:strCache>
            </c:strRef>
          </c:tx>
          <c:errBars>
            <c:errBarType val="both"/>
            <c:errValType val="cust"/>
            <c:plus>
              <c:numRef>
                <c:f>'[5]Combined Graphs'!$AC$81:$AC$85</c:f>
                <c:numCache>
                  <c:formatCode>General</c:formatCode>
                  <c:ptCount val="5"/>
                  <c:pt idx="0">
                    <c:v>4.3434049035552968</c:v>
                  </c:pt>
                  <c:pt idx="1">
                    <c:v>4.7486213622704101</c:v>
                  </c:pt>
                  <c:pt idx="2">
                    <c:v>1.3699952937389668</c:v>
                  </c:pt>
                  <c:pt idx="3">
                    <c:v>1.6110111579933759</c:v>
                  </c:pt>
                  <c:pt idx="4">
                    <c:v>1.628602777123046</c:v>
                  </c:pt>
                </c:numCache>
              </c:numRef>
            </c:plus>
            <c:minus>
              <c:numRef>
                <c:f>'[5]Combined Graphs'!$AC$81:$AC$85</c:f>
                <c:numCache>
                  <c:formatCode>General</c:formatCode>
                  <c:ptCount val="5"/>
                  <c:pt idx="0">
                    <c:v>4.3434049035552968</c:v>
                  </c:pt>
                  <c:pt idx="1">
                    <c:v>4.7486213622704101</c:v>
                  </c:pt>
                  <c:pt idx="2">
                    <c:v>1.3699952937389668</c:v>
                  </c:pt>
                  <c:pt idx="3">
                    <c:v>1.6110111579933759</c:v>
                  </c:pt>
                  <c:pt idx="4">
                    <c:v>1.628602777123046</c:v>
                  </c:pt>
                </c:numCache>
              </c:numRef>
            </c:minus>
          </c:errBars>
          <c:cat>
            <c:strRef>
              <c:f>'[5]Combined Graphs'!$V$111:$V$115</c:f>
              <c:strCache>
                <c:ptCount val="5"/>
                <c:pt idx="0">
                  <c:v>_x0004_DMSO</c:v>
                </c:pt>
                <c:pt idx="1">
                  <c:v>_x000f_Erlotinib 2.5µM</c:v>
                </c:pt>
                <c:pt idx="2">
                  <c:v>_x0010_Trametinib 100nM</c:v>
                </c:pt>
                <c:pt idx="3">
                  <c:v>_x000f_Trametinib 50nM</c:v>
                </c:pt>
                <c:pt idx="4">
                  <c:v>_x0014_Erl 2.5µM + Tra 50nM</c:v>
                </c:pt>
              </c:strCache>
            </c:strRef>
          </c:cat>
          <c:val>
            <c:numRef>
              <c:f>'[5]Combined Graphs'!$W$82:$W$86</c:f>
              <c:numCache>
                <c:formatCode>General</c:formatCode>
                <c:ptCount val="5"/>
                <c:pt idx="0">
                  <c:v>100</c:v>
                </c:pt>
                <c:pt idx="1">
                  <c:v>77.607361963190186</c:v>
                </c:pt>
                <c:pt idx="2">
                  <c:v>35.363716038562671</c:v>
                </c:pt>
                <c:pt idx="3">
                  <c:v>42.177914110429448</c:v>
                </c:pt>
                <c:pt idx="4">
                  <c:v>33.238387379491677</c:v>
                </c:pt>
              </c:numCache>
            </c:numRef>
          </c:val>
        </c:ser>
        <c:ser>
          <c:idx val="1"/>
          <c:order val="1"/>
          <c:tx>
            <c:strRef>
              <c:f>'[5]Combined Graphs'!$X$110</c:f>
              <c:strCache>
                <c:ptCount val="1"/>
                <c:pt idx="0">
                  <c:v>CV</c:v>
                </c:pt>
              </c:strCache>
            </c:strRef>
          </c:tx>
          <c:errBars>
            <c:errBarType val="both"/>
            <c:errValType val="cust"/>
            <c:plus>
              <c:numRef>
                <c:f>'[5]Combined Graphs'!$AD$81:$AD$85</c:f>
                <c:numCache>
                  <c:formatCode>General</c:formatCode>
                  <c:ptCount val="5"/>
                  <c:pt idx="0">
                    <c:v>6.9022855376814967</c:v>
                  </c:pt>
                  <c:pt idx="1">
                    <c:v>5.4287391242298879</c:v>
                  </c:pt>
                  <c:pt idx="2">
                    <c:v>0.21911248933584504</c:v>
                  </c:pt>
                  <c:pt idx="3">
                    <c:v>0.29164592205114098</c:v>
                  </c:pt>
                  <c:pt idx="4">
                    <c:v>0.71335248146017005</c:v>
                  </c:pt>
                </c:numCache>
              </c:numRef>
            </c:plus>
            <c:minus>
              <c:numRef>
                <c:f>'[5]Combined Graphs'!$AD$81:$AD$85</c:f>
                <c:numCache>
                  <c:formatCode>General</c:formatCode>
                  <c:ptCount val="5"/>
                  <c:pt idx="0">
                    <c:v>6.9022855376814967</c:v>
                  </c:pt>
                  <c:pt idx="1">
                    <c:v>5.4287391242298879</c:v>
                  </c:pt>
                  <c:pt idx="2">
                    <c:v>0.21911248933584504</c:v>
                  </c:pt>
                  <c:pt idx="3">
                    <c:v>0.29164592205114098</c:v>
                  </c:pt>
                  <c:pt idx="4">
                    <c:v>0.71335248146017005</c:v>
                  </c:pt>
                </c:numCache>
              </c:numRef>
            </c:minus>
          </c:errBars>
          <c:cat>
            <c:strRef>
              <c:f>'[5]Combined Graphs'!$V$111:$V$115</c:f>
              <c:strCache>
                <c:ptCount val="5"/>
                <c:pt idx="0">
                  <c:v>_x0004_DMSO</c:v>
                </c:pt>
                <c:pt idx="1">
                  <c:v>_x000f_Erlotinib 2.5µM</c:v>
                </c:pt>
                <c:pt idx="2">
                  <c:v>_x0010_Trametinib 100nM</c:v>
                </c:pt>
                <c:pt idx="3">
                  <c:v>_x000f_Trametinib 50nM</c:v>
                </c:pt>
                <c:pt idx="4">
                  <c:v>_x0014_Erl 2.5µM + Tra 50nM</c:v>
                </c:pt>
              </c:strCache>
            </c:strRef>
          </c:cat>
          <c:val>
            <c:numRef>
              <c:f>'[5]Combined Graphs'!$X$82:$X$86</c:f>
              <c:numCache>
                <c:formatCode>General</c:formatCode>
                <c:ptCount val="5"/>
                <c:pt idx="0">
                  <c:v>100</c:v>
                </c:pt>
                <c:pt idx="1">
                  <c:v>85.017421602787479</c:v>
                </c:pt>
                <c:pt idx="2">
                  <c:v>29.50058072009293</c:v>
                </c:pt>
                <c:pt idx="3">
                  <c:v>30.429732868757231</c:v>
                </c:pt>
                <c:pt idx="4">
                  <c:v>22.996515679442521</c:v>
                </c:pt>
              </c:numCache>
            </c:numRef>
          </c:val>
        </c:ser>
        <c:dLbls/>
        <c:axId val="99493376"/>
        <c:axId val="99494912"/>
      </c:barChart>
      <c:catAx>
        <c:axId val="99493376"/>
        <c:scaling>
          <c:orientation val="minMax"/>
        </c:scaling>
        <c:delete val="1"/>
        <c:axPos val="b"/>
        <c:tickLblPos val="none"/>
        <c:crossAx val="99494912"/>
        <c:crosses val="autoZero"/>
        <c:auto val="1"/>
        <c:lblAlgn val="ctr"/>
        <c:lblOffset val="100"/>
      </c:catAx>
      <c:valAx>
        <c:axId val="99494912"/>
        <c:scaling>
          <c:orientation val="minMax"/>
        </c:scaling>
        <c:axPos val="l"/>
        <c:majorGridlines/>
        <c:title>
          <c:tx>
            <c:rich>
              <a:bodyPr rot="-5400000" vert="horz"/>
              <a:lstStyle/>
              <a:p>
                <a:pPr>
                  <a:defRPr/>
                </a:pPr>
                <a:r>
                  <a:rPr lang="en-US"/>
                  <a:t>% of DMSO Control</a:t>
                </a:r>
              </a:p>
            </c:rich>
          </c:tx>
          <c:layout>
            <c:manualLayout>
              <c:xMode val="edge"/>
              <c:yMode val="edge"/>
              <c:x val="3.2934414853895991E-2"/>
              <c:y val="0.18836362996529302"/>
            </c:manualLayout>
          </c:layout>
        </c:title>
        <c:numFmt formatCode="General" sourceLinked="1"/>
        <c:tickLblPos val="nextTo"/>
        <c:crossAx val="99493376"/>
        <c:crosses val="autoZero"/>
        <c:crossBetween val="between"/>
      </c:valAx>
    </c:plotArea>
    <c:plotVisOnly val="1"/>
    <c:dispBlanksAs val="gap"/>
  </c:chart>
  <c:txPr>
    <a:bodyPr/>
    <a:lstStyle/>
    <a:p>
      <a:pPr>
        <a:defRPr sz="800"/>
      </a:pPr>
      <a:endParaRPr lang="en-US"/>
    </a:p>
  </c:tx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lang val="en-IN"/>
  <c:style val="1"/>
  <c:chart>
    <c:plotArea>
      <c:layout>
        <c:manualLayout>
          <c:layoutTarget val="inner"/>
          <c:xMode val="edge"/>
          <c:yMode val="edge"/>
          <c:x val="0.205834524991232"/>
          <c:y val="7.1271929824561403E-2"/>
          <c:w val="0.74029910327027615"/>
          <c:h val="0.66720374084394896"/>
        </c:manualLayout>
      </c:layout>
      <c:barChart>
        <c:barDir val="col"/>
        <c:grouping val="clustered"/>
        <c:ser>
          <c:idx val="0"/>
          <c:order val="0"/>
          <c:tx>
            <c:v>MTS</c:v>
          </c:tx>
          <c:errBars>
            <c:errBarType val="both"/>
            <c:errValType val="cust"/>
            <c:plus>
              <c:numRef>
                <c:f>'[6]Combined Graphs'!$Y$53:$Y$57</c:f>
                <c:numCache>
                  <c:formatCode>General</c:formatCode>
                  <c:ptCount val="5"/>
                  <c:pt idx="0">
                    <c:v>1.692681652403212</c:v>
                  </c:pt>
                  <c:pt idx="1">
                    <c:v>3.539975245213193</c:v>
                  </c:pt>
                  <c:pt idx="2">
                    <c:v>3.3110969168361528</c:v>
                  </c:pt>
                  <c:pt idx="3">
                    <c:v>1.7075983474234186</c:v>
                  </c:pt>
                  <c:pt idx="4">
                    <c:v>0.57096172320933303</c:v>
                  </c:pt>
                </c:numCache>
              </c:numRef>
            </c:plus>
            <c:minus>
              <c:numRef>
                <c:f>'[6]Combined Graphs'!$Y$53:$Y$57</c:f>
                <c:numCache>
                  <c:formatCode>General</c:formatCode>
                  <c:ptCount val="5"/>
                  <c:pt idx="0">
                    <c:v>1.692681652403212</c:v>
                  </c:pt>
                  <c:pt idx="1">
                    <c:v>3.539975245213193</c:v>
                  </c:pt>
                  <c:pt idx="2">
                    <c:v>3.3110969168361528</c:v>
                  </c:pt>
                  <c:pt idx="3">
                    <c:v>1.7075983474234186</c:v>
                  </c:pt>
                  <c:pt idx="4">
                    <c:v>0.57096172320933303</c:v>
                  </c:pt>
                </c:numCache>
              </c:numRef>
            </c:minus>
          </c:errBars>
          <c:cat>
            <c:strRef>
              <c:f>'[6]Combined Graphs'!$V$82:$V$86</c:f>
              <c:strCache>
                <c:ptCount val="5"/>
                <c:pt idx="0">
                  <c:v>_x0004_DMSO</c:v>
                </c:pt>
                <c:pt idx="1">
                  <c:v>_x000f_Erlotinib 2.5µM</c:v>
                </c:pt>
                <c:pt idx="2">
                  <c:v>_x0010_Trametinib 100nM</c:v>
                </c:pt>
                <c:pt idx="3">
                  <c:v>_x000f_Trametinib 50nM</c:v>
                </c:pt>
                <c:pt idx="4">
                  <c:v>_x0014_Erl 2.5µM + Tra 50nM</c:v>
                </c:pt>
              </c:strCache>
            </c:strRef>
          </c:cat>
          <c:val>
            <c:numRef>
              <c:f>'[6]Combined Graphs'!$R$53:$R$57</c:f>
              <c:numCache>
                <c:formatCode>General</c:formatCode>
                <c:ptCount val="5"/>
                <c:pt idx="0">
                  <c:v>100</c:v>
                </c:pt>
                <c:pt idx="1">
                  <c:v>54.310590922066801</c:v>
                </c:pt>
                <c:pt idx="2">
                  <c:v>28.254353411361699</c:v>
                </c:pt>
                <c:pt idx="3">
                  <c:v>32.40793605481015</c:v>
                </c:pt>
                <c:pt idx="4">
                  <c:v>12.132457893234371</c:v>
                </c:pt>
              </c:numCache>
            </c:numRef>
          </c:val>
        </c:ser>
        <c:ser>
          <c:idx val="1"/>
          <c:order val="1"/>
          <c:tx>
            <c:v>CV</c:v>
          </c:tx>
          <c:errBars>
            <c:errBarType val="both"/>
            <c:errValType val="cust"/>
            <c:plus>
              <c:numRef>
                <c:f>'[6]Combined Graphs'!$Y$60:$Y$64</c:f>
                <c:numCache>
                  <c:formatCode>General</c:formatCode>
                  <c:ptCount val="5"/>
                  <c:pt idx="0">
                    <c:v>7.4541245596351535</c:v>
                  </c:pt>
                  <c:pt idx="1">
                    <c:v>1.164944642295787</c:v>
                  </c:pt>
                  <c:pt idx="2">
                    <c:v>0.33448378441811905</c:v>
                  </c:pt>
                  <c:pt idx="3">
                    <c:v>0.51368859416443502</c:v>
                  </c:pt>
                  <c:pt idx="4">
                    <c:v>0.28319564924833696</c:v>
                  </c:pt>
                </c:numCache>
              </c:numRef>
            </c:plus>
            <c:minus>
              <c:numRef>
                <c:f>'[6]Combined Graphs'!$Y$60:$Y$64</c:f>
                <c:numCache>
                  <c:formatCode>General</c:formatCode>
                  <c:ptCount val="5"/>
                  <c:pt idx="0">
                    <c:v>7.4541245596351535</c:v>
                  </c:pt>
                  <c:pt idx="1">
                    <c:v>1.164944642295787</c:v>
                  </c:pt>
                  <c:pt idx="2">
                    <c:v>0.33448378441811905</c:v>
                  </c:pt>
                  <c:pt idx="3">
                    <c:v>0.51368859416443502</c:v>
                  </c:pt>
                  <c:pt idx="4">
                    <c:v>0.28319564924833696</c:v>
                  </c:pt>
                </c:numCache>
              </c:numRef>
            </c:minus>
          </c:errBars>
          <c:cat>
            <c:strRef>
              <c:f>'[6]Combined Graphs'!$V$82:$V$86</c:f>
              <c:strCache>
                <c:ptCount val="5"/>
                <c:pt idx="0">
                  <c:v>_x0004_DMSO</c:v>
                </c:pt>
                <c:pt idx="1">
                  <c:v>_x000f_Erlotinib 2.5µM</c:v>
                </c:pt>
                <c:pt idx="2">
                  <c:v>_x0010_Trametinib 100nM</c:v>
                </c:pt>
                <c:pt idx="3">
                  <c:v>_x000f_Trametinib 50nM</c:v>
                </c:pt>
                <c:pt idx="4">
                  <c:v>_x0014_Erl 2.5µM + Tra 50nM</c:v>
                </c:pt>
              </c:strCache>
            </c:strRef>
          </c:cat>
          <c:val>
            <c:numRef>
              <c:f>'[6]Combined Graphs'!$T$53:$T$57</c:f>
              <c:numCache>
                <c:formatCode>General</c:formatCode>
                <c:ptCount val="5"/>
                <c:pt idx="0">
                  <c:v>100</c:v>
                </c:pt>
                <c:pt idx="1">
                  <c:v>27.509293680297386</c:v>
                </c:pt>
                <c:pt idx="2">
                  <c:v>13.777881040892188</c:v>
                </c:pt>
                <c:pt idx="3">
                  <c:v>16.496282527881018</c:v>
                </c:pt>
                <c:pt idx="4">
                  <c:v>8.4107806691449749</c:v>
                </c:pt>
              </c:numCache>
            </c:numRef>
          </c:val>
        </c:ser>
        <c:dLbls/>
        <c:axId val="100012800"/>
        <c:axId val="100014336"/>
      </c:barChart>
      <c:catAx>
        <c:axId val="100012800"/>
        <c:scaling>
          <c:orientation val="minMax"/>
        </c:scaling>
        <c:delete val="1"/>
        <c:axPos val="b"/>
        <c:tickLblPos val="none"/>
        <c:crossAx val="100014336"/>
        <c:crosses val="autoZero"/>
        <c:auto val="1"/>
        <c:lblAlgn val="ctr"/>
        <c:lblOffset val="100"/>
      </c:catAx>
      <c:valAx>
        <c:axId val="100014336"/>
        <c:scaling>
          <c:orientation val="minMax"/>
        </c:scaling>
        <c:axPos val="l"/>
        <c:majorGridlines/>
        <c:title>
          <c:tx>
            <c:rich>
              <a:bodyPr rot="-5400000" vert="horz"/>
              <a:lstStyle/>
              <a:p>
                <a:pPr>
                  <a:defRPr/>
                </a:pPr>
                <a:r>
                  <a:rPr lang="en-US"/>
                  <a:t>% of DMSO Control</a:t>
                </a:r>
              </a:p>
            </c:rich>
          </c:tx>
          <c:layout/>
        </c:title>
        <c:numFmt formatCode="General" sourceLinked="1"/>
        <c:tickLblPos val="nextTo"/>
        <c:crossAx val="100012800"/>
        <c:crosses val="autoZero"/>
        <c:crossBetween val="between"/>
      </c:valAx>
    </c:plotArea>
    <c:plotVisOnly val="1"/>
    <c:dispBlanksAs val="gap"/>
  </c:chart>
  <c:txPr>
    <a:bodyPr/>
    <a:lstStyle/>
    <a:p>
      <a:pPr>
        <a:defRPr sz="800"/>
      </a:pPr>
      <a:endParaRPr lang="en-US"/>
    </a:p>
  </c:txPr>
  <c:externalData r:id="rId1"/>
</c:chartSpace>
</file>

<file path=ppt/charts/chart3.xml><?xml version="1.0" encoding="utf-8"?>
<c:chartSpace xmlns:c="http://schemas.openxmlformats.org/drawingml/2006/chart" xmlns:a="http://schemas.openxmlformats.org/drawingml/2006/main" xmlns:r="http://schemas.openxmlformats.org/officeDocument/2006/relationships">
  <c:lang val="en-IN"/>
  <c:style val="1"/>
  <c:chart>
    <c:plotArea>
      <c:layout>
        <c:manualLayout>
          <c:layoutTarget val="inner"/>
          <c:xMode val="edge"/>
          <c:yMode val="edge"/>
          <c:x val="0.17029145432401002"/>
          <c:y val="0.27842248088977212"/>
          <c:w val="0.72650028877603789"/>
          <c:h val="0.40198044325355009"/>
        </c:manualLayout>
      </c:layout>
      <c:barChart>
        <c:barDir val="col"/>
        <c:grouping val="clustered"/>
        <c:ser>
          <c:idx val="0"/>
          <c:order val="0"/>
          <c:tx>
            <c:strRef>
              <c:f>'[8]Combined Graphs'!$X$60</c:f>
              <c:strCache>
                <c:ptCount val="1"/>
                <c:pt idx="0">
                  <c:v>MTS</c:v>
                </c:pt>
              </c:strCache>
            </c:strRef>
          </c:tx>
          <c:errBars>
            <c:errBarType val="both"/>
            <c:errValType val="cust"/>
            <c:plus>
              <c:numRef>
                <c:f>'[8]Combined Graphs'!$AF$69:$AF$73</c:f>
                <c:numCache>
                  <c:formatCode>General</c:formatCode>
                  <c:ptCount val="5"/>
                  <c:pt idx="0">
                    <c:v>4.4015255606465056</c:v>
                  </c:pt>
                  <c:pt idx="1">
                    <c:v>2.6269415515432861</c:v>
                  </c:pt>
                  <c:pt idx="2">
                    <c:v>0.64127614750218209</c:v>
                  </c:pt>
                  <c:pt idx="3">
                    <c:v>0.73059449628972317</c:v>
                  </c:pt>
                  <c:pt idx="4">
                    <c:v>0.99241225044786685</c:v>
                  </c:pt>
                </c:numCache>
              </c:numRef>
            </c:plus>
            <c:minus>
              <c:numRef>
                <c:f>'[8]Combined Graphs'!$AF$69:$AF$73</c:f>
                <c:numCache>
                  <c:formatCode>General</c:formatCode>
                  <c:ptCount val="5"/>
                  <c:pt idx="0">
                    <c:v>4.4015255606465056</c:v>
                  </c:pt>
                  <c:pt idx="1">
                    <c:v>2.6269415515432861</c:v>
                  </c:pt>
                  <c:pt idx="2">
                    <c:v>0.64127614750218209</c:v>
                  </c:pt>
                  <c:pt idx="3">
                    <c:v>0.73059449628972317</c:v>
                  </c:pt>
                  <c:pt idx="4">
                    <c:v>0.99241225044786685</c:v>
                  </c:pt>
                </c:numCache>
              </c:numRef>
            </c:minus>
          </c:errBars>
          <c:cat>
            <c:strRef>
              <c:f>'[8]Combined Graphs'!$W$61:$W$65</c:f>
              <c:strCache>
                <c:ptCount val="5"/>
                <c:pt idx="0">
                  <c:v>_x0004_DMSO</c:v>
                </c:pt>
                <c:pt idx="1">
                  <c:v>_x000f_Erlotinib 2.5µM</c:v>
                </c:pt>
                <c:pt idx="2">
                  <c:v>_x0010_Trametinib 100nM</c:v>
                </c:pt>
                <c:pt idx="3">
                  <c:v>_x000f_Trametinib 50nM</c:v>
                </c:pt>
                <c:pt idx="4">
                  <c:v>_x0014_Erl 2.5µM + Tra 50nM</c:v>
                </c:pt>
              </c:strCache>
            </c:strRef>
          </c:cat>
          <c:val>
            <c:numRef>
              <c:f>'[8]Combined Graphs'!$X$61:$X$65</c:f>
              <c:numCache>
                <c:formatCode>General</c:formatCode>
                <c:ptCount val="5"/>
                <c:pt idx="0">
                  <c:v>100</c:v>
                </c:pt>
                <c:pt idx="1">
                  <c:v>96.025005096147311</c:v>
                </c:pt>
                <c:pt idx="2">
                  <c:v>28.368553373649519</c:v>
                </c:pt>
                <c:pt idx="3">
                  <c:v>33.138547258272745</c:v>
                </c:pt>
                <c:pt idx="4">
                  <c:v>33.770469525039047</c:v>
                </c:pt>
              </c:numCache>
            </c:numRef>
          </c:val>
        </c:ser>
        <c:ser>
          <c:idx val="1"/>
          <c:order val="1"/>
          <c:tx>
            <c:strRef>
              <c:f>'[8]Combined Graphs'!$Y$60</c:f>
              <c:strCache>
                <c:ptCount val="1"/>
                <c:pt idx="0">
                  <c:v>CV</c:v>
                </c:pt>
              </c:strCache>
            </c:strRef>
          </c:tx>
          <c:errBars>
            <c:errBarType val="both"/>
            <c:errValType val="cust"/>
            <c:plus>
              <c:numRef>
                <c:f>'[8]Combined Graphs'!$AF$76:$AF$80</c:f>
                <c:numCache>
                  <c:formatCode>General</c:formatCode>
                  <c:ptCount val="5"/>
                  <c:pt idx="0">
                    <c:v>3.7104786022510341</c:v>
                  </c:pt>
                  <c:pt idx="1">
                    <c:v>1.5133654721216758</c:v>
                  </c:pt>
                  <c:pt idx="2">
                    <c:v>1.0826992846368499</c:v>
                  </c:pt>
                  <c:pt idx="3">
                    <c:v>0.75541009137108006</c:v>
                  </c:pt>
                  <c:pt idx="4">
                    <c:v>1.3926971871712321</c:v>
                  </c:pt>
                </c:numCache>
              </c:numRef>
            </c:plus>
            <c:minus>
              <c:numLit>
                <c:formatCode>General</c:formatCode>
                <c:ptCount val="1"/>
                <c:pt idx="0">
                  <c:v>1</c:v>
                </c:pt>
              </c:numLit>
            </c:minus>
          </c:errBars>
          <c:cat>
            <c:strRef>
              <c:f>'[8]Combined Graphs'!$W$61:$W$65</c:f>
              <c:strCache>
                <c:ptCount val="5"/>
                <c:pt idx="0">
                  <c:v>_x0004_DMSO</c:v>
                </c:pt>
                <c:pt idx="1">
                  <c:v>_x000f_Erlotinib 2.5µM</c:v>
                </c:pt>
                <c:pt idx="2">
                  <c:v>_x0010_Trametinib 100nM</c:v>
                </c:pt>
                <c:pt idx="3">
                  <c:v>_x000f_Trametinib 50nM</c:v>
                </c:pt>
                <c:pt idx="4">
                  <c:v>_x0014_Erl 2.5µM + Tra 50nM</c:v>
                </c:pt>
              </c:strCache>
            </c:strRef>
          </c:cat>
          <c:val>
            <c:numRef>
              <c:f>'[8]Combined Graphs'!$Y$61:$Y$65</c:f>
              <c:numCache>
                <c:formatCode>General</c:formatCode>
                <c:ptCount val="5"/>
                <c:pt idx="0">
                  <c:v>100</c:v>
                </c:pt>
                <c:pt idx="1">
                  <c:v>108.39378238341968</c:v>
                </c:pt>
                <c:pt idx="2">
                  <c:v>26.943005181347147</c:v>
                </c:pt>
                <c:pt idx="3">
                  <c:v>30.051813471502602</c:v>
                </c:pt>
                <c:pt idx="4">
                  <c:v>38.134715025906729</c:v>
                </c:pt>
              </c:numCache>
            </c:numRef>
          </c:val>
        </c:ser>
        <c:dLbls/>
        <c:axId val="100061184"/>
        <c:axId val="100063104"/>
      </c:barChart>
      <c:catAx>
        <c:axId val="100061184"/>
        <c:scaling>
          <c:orientation val="minMax"/>
        </c:scaling>
        <c:delete val="1"/>
        <c:axPos val="b"/>
        <c:title>
          <c:tx>
            <c:rich>
              <a:bodyPr/>
              <a:lstStyle/>
              <a:p>
                <a:pPr>
                  <a:defRPr/>
                </a:pPr>
                <a:r>
                  <a:rPr lang="en-US"/>
                  <a:t>Treatment Condition</a:t>
                </a:r>
              </a:p>
            </c:rich>
          </c:tx>
          <c:layout>
            <c:manualLayout>
              <c:xMode val="edge"/>
              <c:yMode val="edge"/>
              <c:x val="0.35899312922503301"/>
              <c:y val="0.83359830930053602"/>
            </c:manualLayout>
          </c:layout>
        </c:title>
        <c:tickLblPos val="none"/>
        <c:crossAx val="100063104"/>
        <c:crosses val="autoZero"/>
        <c:auto val="1"/>
        <c:lblAlgn val="ctr"/>
        <c:lblOffset val="100"/>
      </c:catAx>
      <c:valAx>
        <c:axId val="100063104"/>
        <c:scaling>
          <c:orientation val="minMax"/>
        </c:scaling>
        <c:axPos val="l"/>
        <c:majorGridlines/>
        <c:title>
          <c:tx>
            <c:rich>
              <a:bodyPr rot="-5400000" vert="horz"/>
              <a:lstStyle/>
              <a:p>
                <a:pPr>
                  <a:defRPr/>
                </a:pPr>
                <a:r>
                  <a:rPr lang="en-US"/>
                  <a:t>% of DMSO Control</a:t>
                </a:r>
              </a:p>
            </c:rich>
          </c:tx>
          <c:layout>
            <c:manualLayout>
              <c:xMode val="edge"/>
              <c:yMode val="edge"/>
              <c:x val="0"/>
              <c:y val="0.29958046142006212"/>
            </c:manualLayout>
          </c:layout>
        </c:title>
        <c:numFmt formatCode="General" sourceLinked="1"/>
        <c:tickLblPos val="nextTo"/>
        <c:crossAx val="100061184"/>
        <c:crosses val="autoZero"/>
        <c:crossBetween val="between"/>
      </c:valAx>
    </c:plotArea>
    <c:legend>
      <c:legendPos val="r"/>
      <c:layout>
        <c:manualLayout>
          <c:xMode val="edge"/>
          <c:yMode val="edge"/>
          <c:x val="0.20607200248975799"/>
          <c:y val="0.90426084571965282"/>
          <c:w val="0.63227827165598516"/>
          <c:h val="8.5749244376500541E-2"/>
        </c:manualLayout>
      </c:layout>
    </c:legend>
    <c:plotVisOnly val="1"/>
    <c:dispBlanksAs val="gap"/>
  </c:chart>
  <c:txPr>
    <a:bodyPr/>
    <a:lstStyle/>
    <a:p>
      <a:pPr>
        <a:defRPr sz="800"/>
      </a:pPr>
      <a:endParaRPr lang="en-US"/>
    </a:p>
  </c:txPr>
  <c:externalData r:id="rId1"/>
</c:chartSpace>
</file>

<file path=ppt/charts/chart4.xml><?xml version="1.0" encoding="utf-8"?>
<c:chartSpace xmlns:c="http://schemas.openxmlformats.org/drawingml/2006/chart" xmlns:a="http://schemas.openxmlformats.org/drawingml/2006/main" xmlns:r="http://schemas.openxmlformats.org/officeDocument/2006/relationships">
  <c:lang val="en-IN"/>
  <c:style val="1"/>
  <c:chart>
    <c:plotArea>
      <c:layout>
        <c:manualLayout>
          <c:layoutTarget val="inner"/>
          <c:xMode val="edge"/>
          <c:yMode val="edge"/>
          <c:x val="0.197139559100839"/>
          <c:y val="0.25188033534038906"/>
          <c:w val="0.72292842133899016"/>
          <c:h val="0.57963310424801107"/>
        </c:manualLayout>
      </c:layout>
      <c:barChart>
        <c:barDir val="col"/>
        <c:grouping val="clustered"/>
        <c:ser>
          <c:idx val="0"/>
          <c:order val="0"/>
          <c:tx>
            <c:strRef>
              <c:f>'[7]Combined Graphs'!$W$109</c:f>
              <c:strCache>
                <c:ptCount val="1"/>
                <c:pt idx="0">
                  <c:v>MTS</c:v>
                </c:pt>
              </c:strCache>
            </c:strRef>
          </c:tx>
          <c:errBars>
            <c:errBarType val="both"/>
            <c:errValType val="cust"/>
            <c:plus>
              <c:numRef>
                <c:f>'[7]Combined Graphs'!$AE$142:$AE$146</c:f>
                <c:numCache>
                  <c:formatCode>General</c:formatCode>
                  <c:ptCount val="5"/>
                  <c:pt idx="0">
                    <c:v>1.7307843850669697</c:v>
                  </c:pt>
                  <c:pt idx="1">
                    <c:v>1.9133071173940039</c:v>
                  </c:pt>
                  <c:pt idx="2">
                    <c:v>0.73389016020726394</c:v>
                  </c:pt>
                  <c:pt idx="3">
                    <c:v>2.8218972083141152</c:v>
                  </c:pt>
                  <c:pt idx="4">
                    <c:v>2.346053918837022</c:v>
                  </c:pt>
                </c:numCache>
              </c:numRef>
            </c:plus>
            <c:minus>
              <c:numRef>
                <c:f>'[7]Combined Graphs'!$AE$142:$AE$146</c:f>
                <c:numCache>
                  <c:formatCode>General</c:formatCode>
                  <c:ptCount val="5"/>
                  <c:pt idx="0">
                    <c:v>1.7307843850669697</c:v>
                  </c:pt>
                  <c:pt idx="1">
                    <c:v>1.9133071173940039</c:v>
                  </c:pt>
                  <c:pt idx="2">
                    <c:v>0.73389016020726394</c:v>
                  </c:pt>
                  <c:pt idx="3">
                    <c:v>2.8218972083141152</c:v>
                  </c:pt>
                  <c:pt idx="4">
                    <c:v>2.346053918837022</c:v>
                  </c:pt>
                </c:numCache>
              </c:numRef>
            </c:minus>
          </c:errBars>
          <c:cat>
            <c:strRef>
              <c:f>'[7]Combined Graphs'!$V$110:$V$114</c:f>
              <c:strCache>
                <c:ptCount val="5"/>
                <c:pt idx="0">
                  <c:v>_x0004_DMSO</c:v>
                </c:pt>
                <c:pt idx="1">
                  <c:v>_x000f_Erlotinib 2.5µM</c:v>
                </c:pt>
                <c:pt idx="2">
                  <c:v>_x0010_Trametinib 100nM</c:v>
                </c:pt>
                <c:pt idx="3">
                  <c:v>_x000f_Trametinib 50nM</c:v>
                </c:pt>
                <c:pt idx="4">
                  <c:v>_x0014_Erl 2.5µM + Tra 50nM</c:v>
                </c:pt>
              </c:strCache>
            </c:strRef>
          </c:cat>
          <c:val>
            <c:numRef>
              <c:f>'[7]Combined Graphs'!$W$136:$W$140</c:f>
              <c:numCache>
                <c:formatCode>General</c:formatCode>
                <c:ptCount val="5"/>
                <c:pt idx="0">
                  <c:v>100</c:v>
                </c:pt>
                <c:pt idx="1">
                  <c:v>64.112209802235597</c:v>
                </c:pt>
                <c:pt idx="2">
                  <c:v>46.700343938091159</c:v>
                </c:pt>
                <c:pt idx="3">
                  <c:v>44.507738607050726</c:v>
                </c:pt>
                <c:pt idx="4">
                  <c:v>35.995270851246765</c:v>
                </c:pt>
              </c:numCache>
            </c:numRef>
          </c:val>
        </c:ser>
        <c:ser>
          <c:idx val="1"/>
          <c:order val="1"/>
          <c:tx>
            <c:strRef>
              <c:f>'[7]Combined Graphs'!$X$109</c:f>
              <c:strCache>
                <c:ptCount val="1"/>
                <c:pt idx="0">
                  <c:v>CV</c:v>
                </c:pt>
              </c:strCache>
            </c:strRef>
          </c:tx>
          <c:errBars>
            <c:errBarType val="both"/>
            <c:errValType val="cust"/>
            <c:plus>
              <c:numRef>
                <c:f>'[7]Combined Graphs'!$AE$150:$AE$154</c:f>
                <c:numCache>
                  <c:formatCode>General</c:formatCode>
                  <c:ptCount val="5"/>
                  <c:pt idx="0">
                    <c:v>3.2135568180403107</c:v>
                  </c:pt>
                  <c:pt idx="1">
                    <c:v>2.5126103062496936</c:v>
                  </c:pt>
                  <c:pt idx="2">
                    <c:v>5.3078595876820156</c:v>
                  </c:pt>
                  <c:pt idx="3">
                    <c:v>6.1636803455778546</c:v>
                  </c:pt>
                  <c:pt idx="4">
                    <c:v>0.73978575301966609</c:v>
                  </c:pt>
                </c:numCache>
              </c:numRef>
            </c:plus>
            <c:minus>
              <c:numRef>
                <c:f>'[7]Combined Graphs'!$AE$150:$AE$154</c:f>
                <c:numCache>
                  <c:formatCode>General</c:formatCode>
                  <c:ptCount val="5"/>
                  <c:pt idx="0">
                    <c:v>3.2135568180403107</c:v>
                  </c:pt>
                  <c:pt idx="1">
                    <c:v>2.5126103062496936</c:v>
                  </c:pt>
                  <c:pt idx="2">
                    <c:v>5.3078595876820156</c:v>
                  </c:pt>
                  <c:pt idx="3">
                    <c:v>6.1636803455778546</c:v>
                  </c:pt>
                  <c:pt idx="4">
                    <c:v>0.73978575301966609</c:v>
                  </c:pt>
                </c:numCache>
              </c:numRef>
            </c:minus>
          </c:errBars>
          <c:cat>
            <c:strRef>
              <c:f>'[7]Combined Graphs'!$V$110:$V$114</c:f>
              <c:strCache>
                <c:ptCount val="5"/>
                <c:pt idx="0">
                  <c:v>_x0004_DMSO</c:v>
                </c:pt>
                <c:pt idx="1">
                  <c:v>_x000f_Erlotinib 2.5µM</c:v>
                </c:pt>
                <c:pt idx="2">
                  <c:v>_x0010_Trametinib 100nM</c:v>
                </c:pt>
                <c:pt idx="3">
                  <c:v>_x000f_Trametinib 50nM</c:v>
                </c:pt>
                <c:pt idx="4">
                  <c:v>_x0014_Erl 2.5µM + Tra 50nM</c:v>
                </c:pt>
              </c:strCache>
            </c:strRef>
          </c:cat>
          <c:val>
            <c:numRef>
              <c:f>'[7]Combined Graphs'!$X$136:$X$140</c:f>
              <c:numCache>
                <c:formatCode>General</c:formatCode>
                <c:ptCount val="5"/>
                <c:pt idx="0">
                  <c:v>100</c:v>
                </c:pt>
                <c:pt idx="1">
                  <c:v>60.287970274036219</c:v>
                </c:pt>
                <c:pt idx="2">
                  <c:v>37.018114259173231</c:v>
                </c:pt>
                <c:pt idx="3">
                  <c:v>37.157454714352035</c:v>
                </c:pt>
                <c:pt idx="4">
                  <c:v>24.198792382721752</c:v>
                </c:pt>
              </c:numCache>
            </c:numRef>
          </c:val>
        </c:ser>
        <c:dLbls/>
        <c:axId val="100241408"/>
        <c:axId val="100242944"/>
      </c:barChart>
      <c:catAx>
        <c:axId val="100241408"/>
        <c:scaling>
          <c:orientation val="minMax"/>
        </c:scaling>
        <c:delete val="1"/>
        <c:axPos val="b"/>
        <c:tickLblPos val="none"/>
        <c:crossAx val="100242944"/>
        <c:crosses val="autoZero"/>
        <c:auto val="1"/>
        <c:lblAlgn val="ctr"/>
        <c:lblOffset val="100"/>
      </c:catAx>
      <c:valAx>
        <c:axId val="100242944"/>
        <c:scaling>
          <c:orientation val="minMax"/>
        </c:scaling>
        <c:axPos val="l"/>
        <c:majorGridlines/>
        <c:title>
          <c:tx>
            <c:rich>
              <a:bodyPr rot="-5400000" vert="horz"/>
              <a:lstStyle/>
              <a:p>
                <a:pPr>
                  <a:defRPr/>
                </a:pPr>
                <a:r>
                  <a:rPr lang="en-US"/>
                  <a:t>% of DMSO Control</a:t>
                </a:r>
              </a:p>
            </c:rich>
          </c:tx>
          <c:layout/>
        </c:title>
        <c:numFmt formatCode="General" sourceLinked="1"/>
        <c:tickLblPos val="nextTo"/>
        <c:crossAx val="100241408"/>
        <c:crosses val="autoZero"/>
        <c:crossBetween val="between"/>
      </c:valAx>
    </c:plotArea>
    <c:plotVisOnly val="1"/>
    <c:dispBlanksAs val="gap"/>
  </c:chart>
  <c:txPr>
    <a:bodyPr/>
    <a:lstStyle/>
    <a:p>
      <a:pPr>
        <a:defRPr sz="800"/>
      </a:pPr>
      <a:endParaRPr lang="en-US"/>
    </a:p>
  </c:txPr>
  <c:externalData r:id="rId1"/>
</c:chartSpace>
</file>

<file path=ppt/charts/chart5.xml><?xml version="1.0" encoding="utf-8"?>
<c:chartSpace xmlns:c="http://schemas.openxmlformats.org/drawingml/2006/chart" xmlns:a="http://schemas.openxmlformats.org/drawingml/2006/main" xmlns:r="http://schemas.openxmlformats.org/officeDocument/2006/relationships">
  <c:lang val="en-IN"/>
  <c:style val="18"/>
  <c:chart>
    <c:autoTitleDeleted val="1"/>
    <c:plotArea>
      <c:layout>
        <c:manualLayout>
          <c:layoutTarget val="inner"/>
          <c:xMode val="edge"/>
          <c:yMode val="edge"/>
          <c:x val="0.119969162323565"/>
          <c:y val="0.18490437505442506"/>
          <c:w val="0.70669323234525816"/>
          <c:h val="0.45984151403442602"/>
        </c:manualLayout>
      </c:layout>
      <c:scatterChart>
        <c:scatterStyle val="lineMarker"/>
        <c:ser>
          <c:idx val="0"/>
          <c:order val="0"/>
          <c:tx>
            <c:v>DMSO</c:v>
          </c:tx>
          <c:spPr>
            <a:ln w="19050">
              <a:solidFill>
                <a:schemeClr val="tx1"/>
              </a:solidFill>
            </a:ln>
            <a:effectLst/>
          </c:spPr>
          <c:marker>
            <c:symbol val="diamond"/>
            <c:size val="5"/>
            <c:spPr>
              <a:solidFill>
                <a:schemeClr val="tx1"/>
              </a:solidFill>
              <a:ln>
                <a:solidFill>
                  <a:schemeClr val="tx1"/>
                </a:solidFill>
              </a:ln>
              <a:effectLst/>
            </c:spPr>
          </c:marker>
          <c:errBars>
            <c:errDir val="y"/>
            <c:errBarType val="both"/>
            <c:errValType val="cust"/>
            <c:plus>
              <c:numRef>
                <c:f>'Macintosh HD:Users:ovcarelab:Desktop:Josh Master''s Files:Erlotinib-Sel-Project:MTS and CV:Incucyte Raw Data:3993:[20180314-3993 Raw Data TraErlo.xlsx]3993 Raw Data TraErlo.txt'!$V$31:$AM$31</c:f>
                <c:numCache>
                  <c:formatCode>General</c:formatCode>
                  <c:ptCount val="18"/>
                  <c:pt idx="0">
                    <c:v>6.5672259999999936</c:v>
                  </c:pt>
                  <c:pt idx="1">
                    <c:v>4.8538559999999817</c:v>
                  </c:pt>
                  <c:pt idx="2">
                    <c:v>4.9114570000000004</c:v>
                  </c:pt>
                  <c:pt idx="3">
                    <c:v>4.5275279999999816</c:v>
                  </c:pt>
                  <c:pt idx="4">
                    <c:v>6.0968299999999997</c:v>
                  </c:pt>
                  <c:pt idx="5">
                    <c:v>7.4758920000000009</c:v>
                  </c:pt>
                  <c:pt idx="6">
                    <c:v>7.6641309999999674</c:v>
                  </c:pt>
                  <c:pt idx="7">
                    <c:v>9.0185820000000003</c:v>
                  </c:pt>
                  <c:pt idx="8">
                    <c:v>10.26159</c:v>
                  </c:pt>
                  <c:pt idx="9">
                    <c:v>9.4554910000000021</c:v>
                  </c:pt>
                  <c:pt idx="10">
                    <c:v>10.21613</c:v>
                  </c:pt>
                  <c:pt idx="11">
                    <c:v>10.959760000000001</c:v>
                  </c:pt>
                  <c:pt idx="12">
                    <c:v>9.3196590000000015</c:v>
                  </c:pt>
                  <c:pt idx="13">
                    <c:v>9.661009</c:v>
                  </c:pt>
                  <c:pt idx="14">
                    <c:v>8.8602790000000002</c:v>
                  </c:pt>
                  <c:pt idx="15">
                    <c:v>6.7952389999999987</c:v>
                  </c:pt>
                  <c:pt idx="16">
                    <c:v>6.7161499999999998</c:v>
                  </c:pt>
                  <c:pt idx="17">
                    <c:v>6.2251159999999759</c:v>
                  </c:pt>
                </c:numCache>
              </c:numRef>
            </c:plus>
            <c:minus>
              <c:numRef>
                <c:f>'Macintosh HD:Users:ovcarelab:Desktop:Josh Master''s Files:Erlotinib-Sel-Project:MTS and CV:Incucyte Raw Data:3993:[20180314-3993 Raw Data TraErlo.xlsx]3993 Raw Data TraErlo.txt'!$V$31:$AM$31</c:f>
                <c:numCache>
                  <c:formatCode>General</c:formatCode>
                  <c:ptCount val="18"/>
                  <c:pt idx="0">
                    <c:v>6.5672259999999936</c:v>
                  </c:pt>
                  <c:pt idx="1">
                    <c:v>4.8538559999999817</c:v>
                  </c:pt>
                  <c:pt idx="2">
                    <c:v>4.9114570000000004</c:v>
                  </c:pt>
                  <c:pt idx="3">
                    <c:v>4.5275279999999816</c:v>
                  </c:pt>
                  <c:pt idx="4">
                    <c:v>6.0968299999999997</c:v>
                  </c:pt>
                  <c:pt idx="5">
                    <c:v>7.4758920000000009</c:v>
                  </c:pt>
                  <c:pt idx="6">
                    <c:v>7.6641309999999674</c:v>
                  </c:pt>
                  <c:pt idx="7">
                    <c:v>9.0185820000000003</c:v>
                  </c:pt>
                  <c:pt idx="8">
                    <c:v>10.26159</c:v>
                  </c:pt>
                  <c:pt idx="9">
                    <c:v>9.4554910000000021</c:v>
                  </c:pt>
                  <c:pt idx="10">
                    <c:v>10.21613</c:v>
                  </c:pt>
                  <c:pt idx="11">
                    <c:v>10.959760000000001</c:v>
                  </c:pt>
                  <c:pt idx="12">
                    <c:v>9.3196590000000015</c:v>
                  </c:pt>
                  <c:pt idx="13">
                    <c:v>9.661009</c:v>
                  </c:pt>
                  <c:pt idx="14">
                    <c:v>8.8602790000000002</c:v>
                  </c:pt>
                  <c:pt idx="15">
                    <c:v>6.7952389999999987</c:v>
                  </c:pt>
                  <c:pt idx="16">
                    <c:v>6.7161499999999998</c:v>
                  </c:pt>
                  <c:pt idx="17">
                    <c:v>6.2251159999999759</c:v>
                  </c:pt>
                </c:numCache>
              </c:numRef>
            </c:minus>
          </c:errBars>
          <c:xVal>
            <c:numRef>
              <c:f>'Macintosh HD:Users:ovcarelab:Desktop:Josh Master''s Files:Erlotinib-Sel-Project:MTS and CV:Incucyte Raw Data:3993:[20180314-3993 Raw Data TraErlo.xlsx]3993 Raw Data TraErlo.txt'!$B$30:$S$30</c:f>
              <c:numCache>
                <c:formatCode>General</c:formatCode>
                <c:ptCount val="18"/>
                <c:pt idx="0">
                  <c:v>0</c:v>
                </c:pt>
                <c:pt idx="1">
                  <c:v>6</c:v>
                </c:pt>
                <c:pt idx="2">
                  <c:v>12</c:v>
                </c:pt>
                <c:pt idx="3">
                  <c:v>18</c:v>
                </c:pt>
                <c:pt idx="4">
                  <c:v>24</c:v>
                </c:pt>
                <c:pt idx="5">
                  <c:v>30</c:v>
                </c:pt>
                <c:pt idx="6">
                  <c:v>36</c:v>
                </c:pt>
                <c:pt idx="7">
                  <c:v>42</c:v>
                </c:pt>
                <c:pt idx="8">
                  <c:v>48</c:v>
                </c:pt>
                <c:pt idx="9">
                  <c:v>54</c:v>
                </c:pt>
                <c:pt idx="10">
                  <c:v>60</c:v>
                </c:pt>
                <c:pt idx="11">
                  <c:v>72</c:v>
                </c:pt>
                <c:pt idx="12">
                  <c:v>78</c:v>
                </c:pt>
                <c:pt idx="13">
                  <c:v>84</c:v>
                </c:pt>
                <c:pt idx="14">
                  <c:v>90</c:v>
                </c:pt>
                <c:pt idx="15">
                  <c:v>96</c:v>
                </c:pt>
                <c:pt idx="16">
                  <c:v>102</c:v>
                </c:pt>
                <c:pt idx="17">
                  <c:v>108</c:v>
                </c:pt>
              </c:numCache>
            </c:numRef>
          </c:xVal>
          <c:yVal>
            <c:numRef>
              <c:f>'Macintosh HD:Users:ovcarelab:Desktop:Josh Master''s Files:Erlotinib-Sel-Project:MTS and CV:Incucyte Raw Data:3993:[20180314-3993 Raw Data TraErlo.xlsx]3993 Raw Data TraErlo.txt'!$B$31:$S$31</c:f>
              <c:numCache>
                <c:formatCode>General</c:formatCode>
                <c:ptCount val="18"/>
                <c:pt idx="0">
                  <c:v>23.792719999999882</c:v>
                </c:pt>
                <c:pt idx="1">
                  <c:v>25.875299999999999</c:v>
                </c:pt>
                <c:pt idx="2">
                  <c:v>28.787239999999997</c:v>
                </c:pt>
                <c:pt idx="3">
                  <c:v>31.338419999999999</c:v>
                </c:pt>
                <c:pt idx="4">
                  <c:v>34.734300000000005</c:v>
                </c:pt>
                <c:pt idx="5">
                  <c:v>38.537619999999997</c:v>
                </c:pt>
                <c:pt idx="6">
                  <c:v>42.985760000000006</c:v>
                </c:pt>
                <c:pt idx="7">
                  <c:v>47.851749999999996</c:v>
                </c:pt>
                <c:pt idx="8">
                  <c:v>51.818049999999999</c:v>
                </c:pt>
                <c:pt idx="9">
                  <c:v>56.386429999999997</c:v>
                </c:pt>
                <c:pt idx="10">
                  <c:v>60.851379999999992</c:v>
                </c:pt>
                <c:pt idx="11">
                  <c:v>72.110200000000006</c:v>
                </c:pt>
                <c:pt idx="12">
                  <c:v>74.365529999999993</c:v>
                </c:pt>
                <c:pt idx="13">
                  <c:v>79.95393</c:v>
                </c:pt>
                <c:pt idx="14">
                  <c:v>82.265039999999999</c:v>
                </c:pt>
                <c:pt idx="15">
                  <c:v>86.569310000000002</c:v>
                </c:pt>
                <c:pt idx="16">
                  <c:v>89.574650000000005</c:v>
                </c:pt>
                <c:pt idx="17">
                  <c:v>92.661799999999999</c:v>
                </c:pt>
              </c:numCache>
            </c:numRef>
          </c:yVal>
          <c:extLst xmlns:c16r2="http://schemas.microsoft.com/office/drawing/2015/06/chart">
            <c:ext xmlns:c16="http://schemas.microsoft.com/office/drawing/2014/chart" uri="{C3380CC4-5D6E-409C-BE32-E72D297353CC}">
              <c16:uniqueId val="{00000000-1422-0E4C-9A0B-02A7F7926E6F}"/>
            </c:ext>
          </c:extLst>
        </c:ser>
        <c:ser>
          <c:idx val="2"/>
          <c:order val="1"/>
          <c:tx>
            <c:strRef>
              <c:f>'Macintosh HD:Users:ovcarelab:Desktop:Josh Master''s Files:Erlotinib-Sel-Project:MTS and CV:Incucyte Raw Data:3993:[20180314-3993 Raw Data TraErlo.xlsx]3993 Raw Data TraErlo.txt'!$A$33</c:f>
              <c:strCache>
                <c:ptCount val="1"/>
                <c:pt idx="0">
                  <c:v>Erlotinib 2.5 µM</c:v>
                </c:pt>
              </c:strCache>
            </c:strRef>
          </c:tx>
          <c:spPr>
            <a:ln w="19050">
              <a:solidFill>
                <a:schemeClr val="bg1">
                  <a:lumMod val="50000"/>
                </a:schemeClr>
              </a:solidFill>
            </a:ln>
            <a:effectLst/>
          </c:spPr>
          <c:marker>
            <c:symbol val="x"/>
            <c:size val="5"/>
            <c:spPr>
              <a:noFill/>
              <a:ln>
                <a:solidFill>
                  <a:schemeClr val="bg1">
                    <a:lumMod val="50000"/>
                  </a:schemeClr>
                </a:solidFill>
              </a:ln>
              <a:effectLst/>
            </c:spPr>
          </c:marker>
          <c:errBars>
            <c:errDir val="y"/>
            <c:errBarType val="both"/>
            <c:errValType val="cust"/>
            <c:plus>
              <c:numRef>
                <c:f>'Macintosh HD:Users:ovcarelab:Desktop:Josh Master''s Files:Erlotinib-Sel-Project:MTS and CV:Incucyte Raw Data:3993:[20180314-3993 Raw Data TraErlo.xlsx]3993 Raw Data TraErlo.txt'!$V$33:$AM$33</c:f>
                <c:numCache>
                  <c:formatCode>General</c:formatCode>
                  <c:ptCount val="18"/>
                  <c:pt idx="0">
                    <c:v>5.9344139999999976</c:v>
                  </c:pt>
                  <c:pt idx="1">
                    <c:v>4.0343749999999936</c:v>
                  </c:pt>
                  <c:pt idx="2">
                    <c:v>4.5331610000000007</c:v>
                  </c:pt>
                  <c:pt idx="3">
                    <c:v>5.5359559999999881</c:v>
                  </c:pt>
                  <c:pt idx="4">
                    <c:v>6.5792550000000007</c:v>
                  </c:pt>
                  <c:pt idx="5">
                    <c:v>6.3632580000000001</c:v>
                  </c:pt>
                  <c:pt idx="6">
                    <c:v>5.486670000000001</c:v>
                  </c:pt>
                  <c:pt idx="7">
                    <c:v>6.4928299999999997</c:v>
                  </c:pt>
                  <c:pt idx="8">
                    <c:v>6.6775089999999881</c:v>
                  </c:pt>
                  <c:pt idx="9">
                    <c:v>7.0639199999999995</c:v>
                  </c:pt>
                  <c:pt idx="10">
                    <c:v>6.4641009999999817</c:v>
                  </c:pt>
                  <c:pt idx="11">
                    <c:v>8.0533760000000001</c:v>
                  </c:pt>
                  <c:pt idx="12">
                    <c:v>6.1300420000000004</c:v>
                  </c:pt>
                  <c:pt idx="13">
                    <c:v>6.6736000000000004</c:v>
                  </c:pt>
                  <c:pt idx="14">
                    <c:v>6.5446239999999998</c:v>
                  </c:pt>
                  <c:pt idx="15">
                    <c:v>4.7603169999999881</c:v>
                  </c:pt>
                  <c:pt idx="16">
                    <c:v>3.350101</c:v>
                  </c:pt>
                  <c:pt idx="17">
                    <c:v>2.256399</c:v>
                  </c:pt>
                </c:numCache>
              </c:numRef>
            </c:plus>
            <c:minus>
              <c:numRef>
                <c:f>'Macintosh HD:Users:ovcarelab:Desktop:Josh Master''s Files:Erlotinib-Sel-Project:MTS and CV:Incucyte Raw Data:3993:[20180314-3993 Raw Data TraErlo.xlsx]3993 Raw Data TraErlo.txt'!$V$33:$AM$33</c:f>
                <c:numCache>
                  <c:formatCode>General</c:formatCode>
                  <c:ptCount val="18"/>
                  <c:pt idx="0">
                    <c:v>5.9344139999999976</c:v>
                  </c:pt>
                  <c:pt idx="1">
                    <c:v>4.0343749999999936</c:v>
                  </c:pt>
                  <c:pt idx="2">
                    <c:v>4.5331610000000007</c:v>
                  </c:pt>
                  <c:pt idx="3">
                    <c:v>5.5359559999999881</c:v>
                  </c:pt>
                  <c:pt idx="4">
                    <c:v>6.5792550000000007</c:v>
                  </c:pt>
                  <c:pt idx="5">
                    <c:v>6.3632580000000001</c:v>
                  </c:pt>
                  <c:pt idx="6">
                    <c:v>5.486670000000001</c:v>
                  </c:pt>
                  <c:pt idx="7">
                    <c:v>6.4928299999999997</c:v>
                  </c:pt>
                  <c:pt idx="8">
                    <c:v>6.6775089999999881</c:v>
                  </c:pt>
                  <c:pt idx="9">
                    <c:v>7.0639199999999995</c:v>
                  </c:pt>
                  <c:pt idx="10">
                    <c:v>6.4641009999999817</c:v>
                  </c:pt>
                  <c:pt idx="11">
                    <c:v>8.0533760000000001</c:v>
                  </c:pt>
                  <c:pt idx="12">
                    <c:v>6.1300420000000004</c:v>
                  </c:pt>
                  <c:pt idx="13">
                    <c:v>6.6736000000000004</c:v>
                  </c:pt>
                  <c:pt idx="14">
                    <c:v>6.5446239999999998</c:v>
                  </c:pt>
                  <c:pt idx="15">
                    <c:v>4.7603169999999881</c:v>
                  </c:pt>
                  <c:pt idx="16">
                    <c:v>3.350101</c:v>
                  </c:pt>
                  <c:pt idx="17">
                    <c:v>2.256399</c:v>
                  </c:pt>
                </c:numCache>
              </c:numRef>
            </c:minus>
          </c:errBars>
          <c:xVal>
            <c:numRef>
              <c:f>'Macintosh HD:Users:ovcarelab:Desktop:Josh Master''s Files:Erlotinib-Sel-Project:MTS and CV:Incucyte Raw Data:3993:[20180314-3993 Raw Data TraErlo.xlsx]3993 Raw Data TraErlo.txt'!$B$30:$S$30</c:f>
              <c:numCache>
                <c:formatCode>General</c:formatCode>
                <c:ptCount val="18"/>
                <c:pt idx="0">
                  <c:v>0</c:v>
                </c:pt>
                <c:pt idx="1">
                  <c:v>6</c:v>
                </c:pt>
                <c:pt idx="2">
                  <c:v>12</c:v>
                </c:pt>
                <c:pt idx="3">
                  <c:v>18</c:v>
                </c:pt>
                <c:pt idx="4">
                  <c:v>24</c:v>
                </c:pt>
                <c:pt idx="5">
                  <c:v>30</c:v>
                </c:pt>
                <c:pt idx="6">
                  <c:v>36</c:v>
                </c:pt>
                <c:pt idx="7">
                  <c:v>42</c:v>
                </c:pt>
                <c:pt idx="8">
                  <c:v>48</c:v>
                </c:pt>
                <c:pt idx="9">
                  <c:v>54</c:v>
                </c:pt>
                <c:pt idx="10">
                  <c:v>60</c:v>
                </c:pt>
                <c:pt idx="11">
                  <c:v>72</c:v>
                </c:pt>
                <c:pt idx="12">
                  <c:v>78</c:v>
                </c:pt>
                <c:pt idx="13">
                  <c:v>84</c:v>
                </c:pt>
                <c:pt idx="14">
                  <c:v>90</c:v>
                </c:pt>
                <c:pt idx="15">
                  <c:v>96</c:v>
                </c:pt>
                <c:pt idx="16">
                  <c:v>102</c:v>
                </c:pt>
                <c:pt idx="17">
                  <c:v>108</c:v>
                </c:pt>
              </c:numCache>
            </c:numRef>
          </c:xVal>
          <c:yVal>
            <c:numRef>
              <c:f>'Macintosh HD:Users:ovcarelab:Desktop:Josh Master''s Files:Erlotinib-Sel-Project:MTS and CV:Incucyte Raw Data:3993:[20180314-3993 Raw Data TraErlo.xlsx]3993 Raw Data TraErlo.txt'!$B$33:$S$33</c:f>
              <c:numCache>
                <c:formatCode>General</c:formatCode>
                <c:ptCount val="18"/>
                <c:pt idx="0">
                  <c:v>28.272849999999977</c:v>
                </c:pt>
                <c:pt idx="1">
                  <c:v>28.837689999999988</c:v>
                </c:pt>
                <c:pt idx="2">
                  <c:v>31.484039999999997</c:v>
                </c:pt>
                <c:pt idx="3">
                  <c:v>35.349849999999996</c:v>
                </c:pt>
                <c:pt idx="4">
                  <c:v>39.120990000000006</c:v>
                </c:pt>
                <c:pt idx="5">
                  <c:v>42.92831000000001</c:v>
                </c:pt>
                <c:pt idx="6">
                  <c:v>46.859229999999997</c:v>
                </c:pt>
                <c:pt idx="7">
                  <c:v>51.307089999999995</c:v>
                </c:pt>
                <c:pt idx="8">
                  <c:v>60.107930000000003</c:v>
                </c:pt>
                <c:pt idx="9">
                  <c:v>63.717130000000004</c:v>
                </c:pt>
                <c:pt idx="10">
                  <c:v>69.688159999999982</c:v>
                </c:pt>
                <c:pt idx="11">
                  <c:v>80.706410000000005</c:v>
                </c:pt>
                <c:pt idx="12">
                  <c:v>84.657139999999998</c:v>
                </c:pt>
                <c:pt idx="13">
                  <c:v>88.067450000000008</c:v>
                </c:pt>
                <c:pt idx="14">
                  <c:v>91.024569999999997</c:v>
                </c:pt>
                <c:pt idx="15">
                  <c:v>94.305759999999978</c:v>
                </c:pt>
                <c:pt idx="16">
                  <c:v>96.927640000000011</c:v>
                </c:pt>
                <c:pt idx="17">
                  <c:v>97.661960000000008</c:v>
                </c:pt>
              </c:numCache>
            </c:numRef>
          </c:yVal>
          <c:extLst xmlns:c16r2="http://schemas.microsoft.com/office/drawing/2015/06/chart">
            <c:ext xmlns:c16="http://schemas.microsoft.com/office/drawing/2014/chart" uri="{C3380CC4-5D6E-409C-BE32-E72D297353CC}">
              <c16:uniqueId val="{00000001-1422-0E4C-9A0B-02A7F7926E6F}"/>
            </c:ext>
          </c:extLst>
        </c:ser>
        <c:ser>
          <c:idx val="3"/>
          <c:order val="2"/>
          <c:tx>
            <c:strRef>
              <c:f>'Macintosh HD:Users:ovcarelab:Desktop:Josh Master''s Files:Erlotinib-Sel-Project:MTS and CV:Incucyte Raw Data:3993:[20180314-3993 Raw Data TraErlo.xlsx]3993 Raw Data TraErlo.txt'!$A$34</c:f>
              <c:strCache>
                <c:ptCount val="1"/>
                <c:pt idx="0">
                  <c:v>Trametinib 100 nM</c:v>
                </c:pt>
              </c:strCache>
            </c:strRef>
          </c:tx>
          <c:spPr>
            <a:ln w="19050">
              <a:solidFill>
                <a:srgbClr val="C00000"/>
              </a:solidFill>
            </a:ln>
            <a:effectLst/>
          </c:spPr>
          <c:marker>
            <c:symbol val="square"/>
            <c:size val="5"/>
            <c:spPr>
              <a:solidFill>
                <a:srgbClr val="C00000"/>
              </a:solidFill>
              <a:ln>
                <a:solidFill>
                  <a:srgbClr val="C00000"/>
                </a:solidFill>
              </a:ln>
              <a:effectLst/>
            </c:spPr>
          </c:marker>
          <c:errBars>
            <c:errDir val="y"/>
            <c:errBarType val="both"/>
            <c:errValType val="cust"/>
            <c:plus>
              <c:numRef>
                <c:f>'Macintosh HD:Users:ovcarelab:Desktop:Josh Master''s Files:Erlotinib-Sel-Project:MTS and CV:Incucyte Raw Data:3993:[20180314-3993 Raw Data TraErlo.xlsx]3993 Raw Data TraErlo.txt'!$V$34:$AM$34</c:f>
                <c:numCache>
                  <c:formatCode>General</c:formatCode>
                  <c:ptCount val="18"/>
                  <c:pt idx="0">
                    <c:v>4.8777400000000002</c:v>
                  </c:pt>
                  <c:pt idx="1">
                    <c:v>3.497217</c:v>
                  </c:pt>
                  <c:pt idx="2">
                    <c:v>3.0388579999999976</c:v>
                  </c:pt>
                  <c:pt idx="3">
                    <c:v>3.7863910000000005</c:v>
                  </c:pt>
                  <c:pt idx="4">
                    <c:v>4.8882470000000007</c:v>
                  </c:pt>
                  <c:pt idx="5">
                    <c:v>5.1993400000000003</c:v>
                  </c:pt>
                  <c:pt idx="6">
                    <c:v>5.5725769999999946</c:v>
                  </c:pt>
                  <c:pt idx="7">
                    <c:v>5.674652</c:v>
                  </c:pt>
                  <c:pt idx="8">
                    <c:v>6.3458230000000002</c:v>
                  </c:pt>
                  <c:pt idx="9">
                    <c:v>4.8431799999999976</c:v>
                  </c:pt>
                  <c:pt idx="10">
                    <c:v>4.6986720000000002</c:v>
                  </c:pt>
                  <c:pt idx="11">
                    <c:v>6.4415690000000012</c:v>
                  </c:pt>
                  <c:pt idx="12">
                    <c:v>5.5582440000000002</c:v>
                  </c:pt>
                  <c:pt idx="13">
                    <c:v>5.7424559999999882</c:v>
                  </c:pt>
                  <c:pt idx="14">
                    <c:v>6.006863000000001</c:v>
                  </c:pt>
                  <c:pt idx="15">
                    <c:v>5.912687</c:v>
                  </c:pt>
                  <c:pt idx="16">
                    <c:v>5.8410190000000002</c:v>
                  </c:pt>
                  <c:pt idx="17">
                    <c:v>5.3911530000000001</c:v>
                  </c:pt>
                </c:numCache>
              </c:numRef>
            </c:plus>
            <c:minus>
              <c:numRef>
                <c:f>'Macintosh HD:Users:ovcarelab:Desktop:Josh Master''s Files:Erlotinib-Sel-Project:MTS and CV:Incucyte Raw Data:3993:[20180314-3993 Raw Data TraErlo.xlsx]3993 Raw Data TraErlo.txt'!$V$34:$AM$34</c:f>
                <c:numCache>
                  <c:formatCode>General</c:formatCode>
                  <c:ptCount val="18"/>
                  <c:pt idx="0">
                    <c:v>4.8777400000000002</c:v>
                  </c:pt>
                  <c:pt idx="1">
                    <c:v>3.497217</c:v>
                  </c:pt>
                  <c:pt idx="2">
                    <c:v>3.0388579999999976</c:v>
                  </c:pt>
                  <c:pt idx="3">
                    <c:v>3.7863910000000005</c:v>
                  </c:pt>
                  <c:pt idx="4">
                    <c:v>4.8882470000000007</c:v>
                  </c:pt>
                  <c:pt idx="5">
                    <c:v>5.1993400000000003</c:v>
                  </c:pt>
                  <c:pt idx="6">
                    <c:v>5.5725769999999946</c:v>
                  </c:pt>
                  <c:pt idx="7">
                    <c:v>5.674652</c:v>
                  </c:pt>
                  <c:pt idx="8">
                    <c:v>6.3458230000000002</c:v>
                  </c:pt>
                  <c:pt idx="9">
                    <c:v>4.8431799999999976</c:v>
                  </c:pt>
                  <c:pt idx="10">
                    <c:v>4.6986720000000002</c:v>
                  </c:pt>
                  <c:pt idx="11">
                    <c:v>6.4415690000000012</c:v>
                  </c:pt>
                  <c:pt idx="12">
                    <c:v>5.5582440000000002</c:v>
                  </c:pt>
                  <c:pt idx="13">
                    <c:v>5.7424559999999882</c:v>
                  </c:pt>
                  <c:pt idx="14">
                    <c:v>6.006863000000001</c:v>
                  </c:pt>
                  <c:pt idx="15">
                    <c:v>5.912687</c:v>
                  </c:pt>
                  <c:pt idx="16">
                    <c:v>5.8410190000000002</c:v>
                  </c:pt>
                  <c:pt idx="17">
                    <c:v>5.3911530000000001</c:v>
                  </c:pt>
                </c:numCache>
              </c:numRef>
            </c:minus>
          </c:errBars>
          <c:xVal>
            <c:numRef>
              <c:f>'Macintosh HD:Users:ovcarelab:Desktop:Josh Master''s Files:Erlotinib-Sel-Project:MTS and CV:Incucyte Raw Data:3993:[20180314-3993 Raw Data TraErlo.xlsx]3993 Raw Data TraErlo.txt'!$B$30:$S$30</c:f>
              <c:numCache>
                <c:formatCode>General</c:formatCode>
                <c:ptCount val="18"/>
                <c:pt idx="0">
                  <c:v>0</c:v>
                </c:pt>
                <c:pt idx="1">
                  <c:v>6</c:v>
                </c:pt>
                <c:pt idx="2">
                  <c:v>12</c:v>
                </c:pt>
                <c:pt idx="3">
                  <c:v>18</c:v>
                </c:pt>
                <c:pt idx="4">
                  <c:v>24</c:v>
                </c:pt>
                <c:pt idx="5">
                  <c:v>30</c:v>
                </c:pt>
                <c:pt idx="6">
                  <c:v>36</c:v>
                </c:pt>
                <c:pt idx="7">
                  <c:v>42</c:v>
                </c:pt>
                <c:pt idx="8">
                  <c:v>48</c:v>
                </c:pt>
                <c:pt idx="9">
                  <c:v>54</c:v>
                </c:pt>
                <c:pt idx="10">
                  <c:v>60</c:v>
                </c:pt>
                <c:pt idx="11">
                  <c:v>72</c:v>
                </c:pt>
                <c:pt idx="12">
                  <c:v>78</c:v>
                </c:pt>
                <c:pt idx="13">
                  <c:v>84</c:v>
                </c:pt>
                <c:pt idx="14">
                  <c:v>90</c:v>
                </c:pt>
                <c:pt idx="15">
                  <c:v>96</c:v>
                </c:pt>
                <c:pt idx="16">
                  <c:v>102</c:v>
                </c:pt>
                <c:pt idx="17">
                  <c:v>108</c:v>
                </c:pt>
              </c:numCache>
            </c:numRef>
          </c:xVal>
          <c:yVal>
            <c:numRef>
              <c:f>'Macintosh HD:Users:ovcarelab:Desktop:Josh Master''s Files:Erlotinib-Sel-Project:MTS and CV:Incucyte Raw Data:3993:[20180314-3993 Raw Data TraErlo.xlsx]3993 Raw Data TraErlo.txt'!$B$34:$S$34</c:f>
              <c:numCache>
                <c:formatCode>General</c:formatCode>
                <c:ptCount val="18"/>
                <c:pt idx="0">
                  <c:v>27.529779999999999</c:v>
                </c:pt>
                <c:pt idx="1">
                  <c:v>30.274560000000001</c:v>
                </c:pt>
                <c:pt idx="2">
                  <c:v>33.325490000000002</c:v>
                </c:pt>
                <c:pt idx="3">
                  <c:v>36.766610000000007</c:v>
                </c:pt>
                <c:pt idx="4">
                  <c:v>38.371629999999996</c:v>
                </c:pt>
                <c:pt idx="5">
                  <c:v>41.162580000000013</c:v>
                </c:pt>
                <c:pt idx="6">
                  <c:v>41.093060000000001</c:v>
                </c:pt>
                <c:pt idx="7">
                  <c:v>43.54354</c:v>
                </c:pt>
                <c:pt idx="8">
                  <c:v>44.337949999999999</c:v>
                </c:pt>
                <c:pt idx="9">
                  <c:v>45.433190000000003</c:v>
                </c:pt>
                <c:pt idx="10">
                  <c:v>44.887709999999998</c:v>
                </c:pt>
                <c:pt idx="11">
                  <c:v>46.035700000000006</c:v>
                </c:pt>
                <c:pt idx="12">
                  <c:v>44.642150000000008</c:v>
                </c:pt>
                <c:pt idx="13">
                  <c:v>46.493120000000012</c:v>
                </c:pt>
                <c:pt idx="14">
                  <c:v>45.572160000000011</c:v>
                </c:pt>
                <c:pt idx="15">
                  <c:v>46.026410000000006</c:v>
                </c:pt>
                <c:pt idx="16">
                  <c:v>45.636850000000003</c:v>
                </c:pt>
                <c:pt idx="17">
                  <c:v>45.506259999999997</c:v>
                </c:pt>
              </c:numCache>
            </c:numRef>
          </c:yVal>
          <c:extLst xmlns:c16r2="http://schemas.microsoft.com/office/drawing/2015/06/chart">
            <c:ext xmlns:c16="http://schemas.microsoft.com/office/drawing/2014/chart" uri="{C3380CC4-5D6E-409C-BE32-E72D297353CC}">
              <c16:uniqueId val="{00000002-1422-0E4C-9A0B-02A7F7926E6F}"/>
            </c:ext>
          </c:extLst>
        </c:ser>
        <c:ser>
          <c:idx val="4"/>
          <c:order val="3"/>
          <c:tx>
            <c:strRef>
              <c:f>'Macintosh HD:Users:ovcarelab:Desktop:Josh Master''s Files:Erlotinib-Sel-Project:MTS and CV:Incucyte Raw Data:3993:[20180314-3993 Raw Data TraErlo.xlsx]3993 Raw Data TraErlo.txt'!$A$35</c:f>
              <c:strCache>
                <c:ptCount val="1"/>
                <c:pt idx="0">
                  <c:v>Trametinib 50 nM</c:v>
                </c:pt>
              </c:strCache>
            </c:strRef>
          </c:tx>
          <c:spPr>
            <a:ln w="19050">
              <a:solidFill>
                <a:srgbClr val="FF0000"/>
              </a:solidFill>
            </a:ln>
            <a:effectLst/>
          </c:spPr>
          <c:marker>
            <c:symbol val="square"/>
            <c:size val="5"/>
            <c:spPr>
              <a:solidFill>
                <a:srgbClr val="FF0000"/>
              </a:solidFill>
              <a:ln>
                <a:solidFill>
                  <a:srgbClr val="FF0000"/>
                </a:solidFill>
              </a:ln>
              <a:effectLst/>
            </c:spPr>
          </c:marker>
          <c:errBars>
            <c:errDir val="y"/>
            <c:errBarType val="both"/>
            <c:errValType val="cust"/>
            <c:plus>
              <c:numRef>
                <c:f>'Macintosh HD:Users:ovcarelab:Desktop:Josh Master''s Files:Erlotinib-Sel-Project:MTS and CV:Incucyte Raw Data:3993:[20180314-3993 Raw Data TraErlo.xlsx]3993 Raw Data TraErlo.txt'!$V$35:$AM$35</c:f>
                <c:numCache>
                  <c:formatCode>General</c:formatCode>
                  <c:ptCount val="18"/>
                  <c:pt idx="0">
                    <c:v>3.4337800000000001</c:v>
                  </c:pt>
                  <c:pt idx="1">
                    <c:v>4.4244599999999936</c:v>
                  </c:pt>
                  <c:pt idx="2">
                    <c:v>4.7659139999999818</c:v>
                  </c:pt>
                  <c:pt idx="3">
                    <c:v>4.9250930000000004</c:v>
                  </c:pt>
                  <c:pt idx="4">
                    <c:v>4.9354740000000001</c:v>
                  </c:pt>
                  <c:pt idx="5">
                    <c:v>5.9902990000000012</c:v>
                  </c:pt>
                  <c:pt idx="6">
                    <c:v>4.8884639999999999</c:v>
                  </c:pt>
                  <c:pt idx="7">
                    <c:v>5.0125559999999778</c:v>
                  </c:pt>
                  <c:pt idx="8">
                    <c:v>7.3126630000000006</c:v>
                  </c:pt>
                  <c:pt idx="9">
                    <c:v>6.7171759999999816</c:v>
                  </c:pt>
                  <c:pt idx="10">
                    <c:v>6.9940139999999946</c:v>
                  </c:pt>
                  <c:pt idx="11">
                    <c:v>8.7670450000000013</c:v>
                  </c:pt>
                  <c:pt idx="12">
                    <c:v>7.4823420000000009</c:v>
                  </c:pt>
                  <c:pt idx="13">
                    <c:v>7.715624</c:v>
                  </c:pt>
                  <c:pt idx="14">
                    <c:v>7.9668859999999881</c:v>
                  </c:pt>
                  <c:pt idx="15">
                    <c:v>8.2148619999999983</c:v>
                  </c:pt>
                  <c:pt idx="16">
                    <c:v>8.6541670000000011</c:v>
                  </c:pt>
                  <c:pt idx="17">
                    <c:v>8.6302529999999962</c:v>
                  </c:pt>
                </c:numCache>
              </c:numRef>
            </c:plus>
            <c:minus>
              <c:numRef>
                <c:f>'Macintosh HD:Users:ovcarelab:Desktop:Josh Master''s Files:Erlotinib-Sel-Project:MTS and CV:Incucyte Raw Data:3993:[20180314-3993 Raw Data TraErlo.xlsx]3993 Raw Data TraErlo.txt'!$V$35:$AM$35</c:f>
                <c:numCache>
                  <c:formatCode>General</c:formatCode>
                  <c:ptCount val="18"/>
                  <c:pt idx="0">
                    <c:v>3.4337800000000001</c:v>
                  </c:pt>
                  <c:pt idx="1">
                    <c:v>4.4244599999999936</c:v>
                  </c:pt>
                  <c:pt idx="2">
                    <c:v>4.7659139999999818</c:v>
                  </c:pt>
                  <c:pt idx="3">
                    <c:v>4.9250930000000004</c:v>
                  </c:pt>
                  <c:pt idx="4">
                    <c:v>4.9354740000000001</c:v>
                  </c:pt>
                  <c:pt idx="5">
                    <c:v>5.9902990000000012</c:v>
                  </c:pt>
                  <c:pt idx="6">
                    <c:v>4.8884639999999999</c:v>
                  </c:pt>
                  <c:pt idx="7">
                    <c:v>5.0125559999999778</c:v>
                  </c:pt>
                  <c:pt idx="8">
                    <c:v>7.3126630000000006</c:v>
                  </c:pt>
                  <c:pt idx="9">
                    <c:v>6.7171759999999816</c:v>
                  </c:pt>
                  <c:pt idx="10">
                    <c:v>6.9940139999999946</c:v>
                  </c:pt>
                  <c:pt idx="11">
                    <c:v>8.7670450000000013</c:v>
                  </c:pt>
                  <c:pt idx="12">
                    <c:v>7.4823420000000009</c:v>
                  </c:pt>
                  <c:pt idx="13">
                    <c:v>7.715624</c:v>
                  </c:pt>
                  <c:pt idx="14">
                    <c:v>7.9668859999999881</c:v>
                  </c:pt>
                  <c:pt idx="15">
                    <c:v>8.2148619999999983</c:v>
                  </c:pt>
                  <c:pt idx="16">
                    <c:v>8.6541670000000011</c:v>
                  </c:pt>
                  <c:pt idx="17">
                    <c:v>8.6302529999999962</c:v>
                  </c:pt>
                </c:numCache>
              </c:numRef>
            </c:minus>
          </c:errBars>
          <c:xVal>
            <c:numRef>
              <c:f>'Macintosh HD:Users:ovcarelab:Desktop:Josh Master''s Files:Erlotinib-Sel-Project:MTS and CV:Incucyte Raw Data:3993:[20180314-3993 Raw Data TraErlo.xlsx]3993 Raw Data TraErlo.txt'!$B$30:$S$30</c:f>
              <c:numCache>
                <c:formatCode>General</c:formatCode>
                <c:ptCount val="18"/>
                <c:pt idx="0">
                  <c:v>0</c:v>
                </c:pt>
                <c:pt idx="1">
                  <c:v>6</c:v>
                </c:pt>
                <c:pt idx="2">
                  <c:v>12</c:v>
                </c:pt>
                <c:pt idx="3">
                  <c:v>18</c:v>
                </c:pt>
                <c:pt idx="4">
                  <c:v>24</c:v>
                </c:pt>
                <c:pt idx="5">
                  <c:v>30</c:v>
                </c:pt>
                <c:pt idx="6">
                  <c:v>36</c:v>
                </c:pt>
                <c:pt idx="7">
                  <c:v>42</c:v>
                </c:pt>
                <c:pt idx="8">
                  <c:v>48</c:v>
                </c:pt>
                <c:pt idx="9">
                  <c:v>54</c:v>
                </c:pt>
                <c:pt idx="10">
                  <c:v>60</c:v>
                </c:pt>
                <c:pt idx="11">
                  <c:v>72</c:v>
                </c:pt>
                <c:pt idx="12">
                  <c:v>78</c:v>
                </c:pt>
                <c:pt idx="13">
                  <c:v>84</c:v>
                </c:pt>
                <c:pt idx="14">
                  <c:v>90</c:v>
                </c:pt>
                <c:pt idx="15">
                  <c:v>96</c:v>
                </c:pt>
                <c:pt idx="16">
                  <c:v>102</c:v>
                </c:pt>
                <c:pt idx="17">
                  <c:v>108</c:v>
                </c:pt>
              </c:numCache>
            </c:numRef>
          </c:xVal>
          <c:yVal>
            <c:numRef>
              <c:f>'Macintosh HD:Users:ovcarelab:Desktop:Josh Master''s Files:Erlotinib-Sel-Project:MTS and CV:Incucyte Raw Data:3993:[20180314-3993 Raw Data TraErlo.xlsx]3993 Raw Data TraErlo.txt'!$B$35:$S$35</c:f>
              <c:numCache>
                <c:formatCode>General</c:formatCode>
                <c:ptCount val="18"/>
                <c:pt idx="0">
                  <c:v>23.601670000000002</c:v>
                </c:pt>
                <c:pt idx="1">
                  <c:v>28.357790000000001</c:v>
                </c:pt>
                <c:pt idx="2">
                  <c:v>30.351120000000012</c:v>
                </c:pt>
                <c:pt idx="3">
                  <c:v>33.306659999999994</c:v>
                </c:pt>
                <c:pt idx="4">
                  <c:v>36.249010000000006</c:v>
                </c:pt>
                <c:pt idx="5">
                  <c:v>38.117750000000001</c:v>
                </c:pt>
                <c:pt idx="6">
                  <c:v>38.93289</c:v>
                </c:pt>
                <c:pt idx="7">
                  <c:v>40.757239999999996</c:v>
                </c:pt>
                <c:pt idx="8">
                  <c:v>43.869459999999997</c:v>
                </c:pt>
                <c:pt idx="9">
                  <c:v>45.252020000000002</c:v>
                </c:pt>
                <c:pt idx="10">
                  <c:v>45.897930000000002</c:v>
                </c:pt>
                <c:pt idx="11">
                  <c:v>47.988819999999997</c:v>
                </c:pt>
                <c:pt idx="12">
                  <c:v>49.150010000000002</c:v>
                </c:pt>
                <c:pt idx="13">
                  <c:v>49.077579999999998</c:v>
                </c:pt>
                <c:pt idx="14">
                  <c:v>50.137010000000004</c:v>
                </c:pt>
                <c:pt idx="15">
                  <c:v>50.568300000000008</c:v>
                </c:pt>
                <c:pt idx="16">
                  <c:v>50.286540000000002</c:v>
                </c:pt>
                <c:pt idx="17">
                  <c:v>51.273900000000005</c:v>
                </c:pt>
              </c:numCache>
            </c:numRef>
          </c:yVal>
          <c:extLst xmlns:c16r2="http://schemas.microsoft.com/office/drawing/2015/06/chart">
            <c:ext xmlns:c16="http://schemas.microsoft.com/office/drawing/2014/chart" uri="{C3380CC4-5D6E-409C-BE32-E72D297353CC}">
              <c16:uniqueId val="{00000003-1422-0E4C-9A0B-02A7F7926E6F}"/>
            </c:ext>
          </c:extLst>
        </c:ser>
        <c:ser>
          <c:idx val="12"/>
          <c:order val="4"/>
          <c:tx>
            <c:v>Erl 2.5µM + Tra 50nM</c:v>
          </c:tx>
          <c:spPr>
            <a:ln w="19050">
              <a:solidFill>
                <a:srgbClr val="7030A0"/>
              </a:solidFill>
            </a:ln>
            <a:effectLst/>
          </c:spPr>
          <c:marker>
            <c:symbol val="plus"/>
            <c:size val="5"/>
            <c:spPr>
              <a:noFill/>
              <a:ln>
                <a:solidFill>
                  <a:srgbClr val="7030A0"/>
                </a:solidFill>
              </a:ln>
              <a:effectLst/>
            </c:spPr>
          </c:marker>
          <c:errBars>
            <c:errDir val="y"/>
            <c:errBarType val="both"/>
            <c:errValType val="cust"/>
            <c:plus>
              <c:numRef>
                <c:f>'Macintosh HD:Users:ovcarelab:Desktop:Josh Master''s Files:Erlotinib-Sel-Project:MTS and CV:Incucyte Raw Data:3993:[20180314-3993 Raw Data TraErlo.xlsx]3993 Raw Data TraErlo.txt'!$V$43:$AM$43</c:f>
                <c:numCache>
                  <c:formatCode>General</c:formatCode>
                  <c:ptCount val="18"/>
                  <c:pt idx="0">
                    <c:v>2.3311419999999976</c:v>
                  </c:pt>
                  <c:pt idx="1">
                    <c:v>3.2103619999999999</c:v>
                  </c:pt>
                  <c:pt idx="2">
                    <c:v>2.8702159999999997</c:v>
                  </c:pt>
                  <c:pt idx="3">
                    <c:v>2.8902899999999976</c:v>
                  </c:pt>
                  <c:pt idx="4">
                    <c:v>3.5176589999999996</c:v>
                  </c:pt>
                  <c:pt idx="5">
                    <c:v>3.3748259999999997</c:v>
                  </c:pt>
                  <c:pt idx="6">
                    <c:v>3.323779</c:v>
                  </c:pt>
                  <c:pt idx="7">
                    <c:v>4.431566000000001</c:v>
                  </c:pt>
                  <c:pt idx="8">
                    <c:v>3.1510489999999995</c:v>
                  </c:pt>
                  <c:pt idx="9">
                    <c:v>5.0694620000000006</c:v>
                  </c:pt>
                  <c:pt idx="10">
                    <c:v>4.9090190000000007</c:v>
                  </c:pt>
                  <c:pt idx="11">
                    <c:v>4.5599889999999945</c:v>
                  </c:pt>
                  <c:pt idx="12">
                    <c:v>4.2142819999999945</c:v>
                  </c:pt>
                  <c:pt idx="13">
                    <c:v>4.2859259999999946</c:v>
                  </c:pt>
                  <c:pt idx="14">
                    <c:v>4.1446179999999817</c:v>
                  </c:pt>
                  <c:pt idx="15">
                    <c:v>4.6638709999999817</c:v>
                  </c:pt>
                  <c:pt idx="16">
                    <c:v>4.6299639999999966</c:v>
                  </c:pt>
                  <c:pt idx="17">
                    <c:v>5.9506940000000004</c:v>
                  </c:pt>
                </c:numCache>
              </c:numRef>
            </c:plus>
            <c:minus>
              <c:numRef>
                <c:f>'Macintosh HD:Users:ovcarelab:Desktop:Josh Master''s Files:Erlotinib-Sel-Project:MTS and CV:Incucyte Raw Data:3993:[20180314-3993 Raw Data TraErlo.xlsx]3993 Raw Data TraErlo.txt'!$V$43:$AM$43</c:f>
                <c:numCache>
                  <c:formatCode>General</c:formatCode>
                  <c:ptCount val="18"/>
                  <c:pt idx="0">
                    <c:v>2.3311419999999976</c:v>
                  </c:pt>
                  <c:pt idx="1">
                    <c:v>3.2103619999999999</c:v>
                  </c:pt>
                  <c:pt idx="2">
                    <c:v>2.8702159999999997</c:v>
                  </c:pt>
                  <c:pt idx="3">
                    <c:v>2.8902899999999976</c:v>
                  </c:pt>
                  <c:pt idx="4">
                    <c:v>3.5176589999999996</c:v>
                  </c:pt>
                  <c:pt idx="5">
                    <c:v>3.3748259999999997</c:v>
                  </c:pt>
                  <c:pt idx="6">
                    <c:v>3.323779</c:v>
                  </c:pt>
                  <c:pt idx="7">
                    <c:v>4.431566000000001</c:v>
                  </c:pt>
                  <c:pt idx="8">
                    <c:v>3.1510489999999995</c:v>
                  </c:pt>
                  <c:pt idx="9">
                    <c:v>5.0694620000000006</c:v>
                  </c:pt>
                  <c:pt idx="10">
                    <c:v>4.9090190000000007</c:v>
                  </c:pt>
                  <c:pt idx="11">
                    <c:v>4.5599889999999945</c:v>
                  </c:pt>
                  <c:pt idx="12">
                    <c:v>4.2142819999999945</c:v>
                  </c:pt>
                  <c:pt idx="13">
                    <c:v>4.2859259999999946</c:v>
                  </c:pt>
                  <c:pt idx="14">
                    <c:v>4.1446179999999817</c:v>
                  </c:pt>
                  <c:pt idx="15">
                    <c:v>4.6638709999999817</c:v>
                  </c:pt>
                  <c:pt idx="16">
                    <c:v>4.6299639999999966</c:v>
                  </c:pt>
                  <c:pt idx="17">
                    <c:v>5.9506940000000004</c:v>
                  </c:pt>
                </c:numCache>
              </c:numRef>
            </c:minus>
          </c:errBars>
          <c:xVal>
            <c:numRef>
              <c:f>'Macintosh HD:Users:ovcarelab:Desktop:Josh Master''s Files:Erlotinib-Sel-Project:MTS and CV:Incucyte Raw Data:3993:[20180314-3993 Raw Data TraErlo.xlsx]3993 Raw Data TraErlo.txt'!$B$30:$S$30</c:f>
              <c:numCache>
                <c:formatCode>General</c:formatCode>
                <c:ptCount val="18"/>
                <c:pt idx="0">
                  <c:v>0</c:v>
                </c:pt>
                <c:pt idx="1">
                  <c:v>6</c:v>
                </c:pt>
                <c:pt idx="2">
                  <c:v>12</c:v>
                </c:pt>
                <c:pt idx="3">
                  <c:v>18</c:v>
                </c:pt>
                <c:pt idx="4">
                  <c:v>24</c:v>
                </c:pt>
                <c:pt idx="5">
                  <c:v>30</c:v>
                </c:pt>
                <c:pt idx="6">
                  <c:v>36</c:v>
                </c:pt>
                <c:pt idx="7">
                  <c:v>42</c:v>
                </c:pt>
                <c:pt idx="8">
                  <c:v>48</c:v>
                </c:pt>
                <c:pt idx="9">
                  <c:v>54</c:v>
                </c:pt>
                <c:pt idx="10">
                  <c:v>60</c:v>
                </c:pt>
                <c:pt idx="11">
                  <c:v>72</c:v>
                </c:pt>
                <c:pt idx="12">
                  <c:v>78</c:v>
                </c:pt>
                <c:pt idx="13">
                  <c:v>84</c:v>
                </c:pt>
                <c:pt idx="14">
                  <c:v>90</c:v>
                </c:pt>
                <c:pt idx="15">
                  <c:v>96</c:v>
                </c:pt>
                <c:pt idx="16">
                  <c:v>102</c:v>
                </c:pt>
                <c:pt idx="17">
                  <c:v>108</c:v>
                </c:pt>
              </c:numCache>
            </c:numRef>
          </c:xVal>
          <c:yVal>
            <c:numRef>
              <c:f>'Macintosh HD:Users:ovcarelab:Desktop:Josh Master''s Files:Erlotinib-Sel-Project:MTS and CV:Incucyte Raw Data:3993:[20180314-3993 Raw Data TraErlo.xlsx]3993 Raw Data TraErlo.txt'!$B$43:$S$43</c:f>
              <c:numCache>
                <c:formatCode>General</c:formatCode>
                <c:ptCount val="18"/>
                <c:pt idx="0">
                  <c:v>25.303639999999998</c:v>
                </c:pt>
                <c:pt idx="1">
                  <c:v>24.80752</c:v>
                </c:pt>
                <c:pt idx="2">
                  <c:v>27.505929999999999</c:v>
                </c:pt>
                <c:pt idx="3">
                  <c:v>29.558350000000001</c:v>
                </c:pt>
                <c:pt idx="4">
                  <c:v>33.214649999999999</c:v>
                </c:pt>
                <c:pt idx="5">
                  <c:v>34.280290000000001</c:v>
                </c:pt>
                <c:pt idx="6">
                  <c:v>35.997030000000002</c:v>
                </c:pt>
                <c:pt idx="7">
                  <c:v>39.318759999999997</c:v>
                </c:pt>
                <c:pt idx="8">
                  <c:v>42.571750000000002</c:v>
                </c:pt>
                <c:pt idx="9">
                  <c:v>42.957869999999986</c:v>
                </c:pt>
                <c:pt idx="10">
                  <c:v>44.244910000000004</c:v>
                </c:pt>
                <c:pt idx="11">
                  <c:v>48.626170000000009</c:v>
                </c:pt>
                <c:pt idx="12">
                  <c:v>48.65992</c:v>
                </c:pt>
                <c:pt idx="13">
                  <c:v>49.661659999999998</c:v>
                </c:pt>
                <c:pt idx="14">
                  <c:v>49.980609999999999</c:v>
                </c:pt>
                <c:pt idx="15">
                  <c:v>49.998720000000013</c:v>
                </c:pt>
                <c:pt idx="16">
                  <c:v>50.820980000000006</c:v>
                </c:pt>
                <c:pt idx="17">
                  <c:v>51.673570000000005</c:v>
                </c:pt>
              </c:numCache>
            </c:numRef>
          </c:yVal>
          <c:extLst xmlns:c16r2="http://schemas.microsoft.com/office/drawing/2015/06/chart">
            <c:ext xmlns:c16="http://schemas.microsoft.com/office/drawing/2014/chart" uri="{C3380CC4-5D6E-409C-BE32-E72D297353CC}">
              <c16:uniqueId val="{00000004-1422-0E4C-9A0B-02A7F7926E6F}"/>
            </c:ext>
          </c:extLst>
        </c:ser>
        <c:dLbls/>
        <c:axId val="112102400"/>
        <c:axId val="112129152"/>
      </c:scatterChart>
      <c:valAx>
        <c:axId val="112102400"/>
        <c:scaling>
          <c:orientation val="minMax"/>
          <c:max val="108"/>
          <c:min val="0"/>
        </c:scaling>
        <c:axPos val="b"/>
        <c:title>
          <c:tx>
            <c:rich>
              <a:bodyPr/>
              <a:lstStyle/>
              <a:p>
                <a:pPr>
                  <a:defRPr/>
                </a:pPr>
                <a:r>
                  <a:rPr lang="en-US" dirty="0"/>
                  <a:t>Time (Hours)</a:t>
                </a:r>
              </a:p>
            </c:rich>
          </c:tx>
          <c:layout>
            <c:manualLayout>
              <c:xMode val="edge"/>
              <c:yMode val="edge"/>
              <c:x val="0.45043994108262803"/>
              <c:y val="0.70942879016574301"/>
            </c:manualLayout>
          </c:layout>
        </c:title>
        <c:numFmt formatCode="General" sourceLinked="1"/>
        <c:tickLblPos val="nextTo"/>
        <c:crossAx val="112129152"/>
        <c:crosses val="autoZero"/>
        <c:crossBetween val="midCat"/>
        <c:majorUnit val="15"/>
      </c:valAx>
      <c:valAx>
        <c:axId val="112129152"/>
        <c:scaling>
          <c:orientation val="minMax"/>
          <c:max val="100"/>
        </c:scaling>
        <c:axPos val="l"/>
        <c:majorGridlines/>
        <c:title>
          <c:tx>
            <c:rich>
              <a:bodyPr rot="-5400000" vert="horz"/>
              <a:lstStyle/>
              <a:p>
                <a:pPr>
                  <a:defRPr/>
                </a:pPr>
                <a:r>
                  <a:rPr lang="en-US" dirty="0"/>
                  <a:t>%</a:t>
                </a:r>
                <a:r>
                  <a:rPr lang="en-US" baseline="0" dirty="0"/>
                  <a:t> Confluence</a:t>
                </a:r>
                <a:endParaRPr lang="en-US" dirty="0"/>
              </a:p>
            </c:rich>
          </c:tx>
          <c:layout>
            <c:manualLayout>
              <c:xMode val="edge"/>
              <c:yMode val="edge"/>
              <c:x val="2.7162235653973306E-2"/>
              <c:y val="0.20402528228498401"/>
            </c:manualLayout>
          </c:layout>
        </c:title>
        <c:numFmt formatCode="General" sourceLinked="1"/>
        <c:tickLblPos val="nextTo"/>
        <c:crossAx val="112102400"/>
        <c:crosses val="autoZero"/>
        <c:crossBetween val="midCat"/>
        <c:majorUnit val="10"/>
      </c:valAx>
    </c:plotArea>
    <c:legend>
      <c:legendPos val="r"/>
      <c:layout>
        <c:manualLayout>
          <c:xMode val="edge"/>
          <c:yMode val="edge"/>
          <c:x val="0.22421955598227702"/>
          <c:y val="0.79450161098371608"/>
          <c:w val="0.65461173292132213"/>
          <c:h val="0.19554298068838502"/>
        </c:manualLayout>
      </c:layout>
    </c:legend>
    <c:plotVisOnly val="1"/>
    <c:dispBlanksAs val="gap"/>
  </c:chart>
  <c:txPr>
    <a:bodyPr/>
    <a:lstStyle/>
    <a:p>
      <a:pPr>
        <a:defRPr sz="800"/>
      </a:pPr>
      <a:endParaRPr lang="en-US"/>
    </a:p>
  </c:txPr>
  <c:externalData r:id="rId1"/>
</c:chartSpace>
</file>

<file path=ppt/charts/chart6.xml><?xml version="1.0" encoding="utf-8"?>
<c:chartSpace xmlns:c="http://schemas.openxmlformats.org/drawingml/2006/chart" xmlns:a="http://schemas.openxmlformats.org/drawingml/2006/main" xmlns:r="http://schemas.openxmlformats.org/officeDocument/2006/relationships">
  <c:lang val="en-IN"/>
  <c:style val="18"/>
  <c:chart>
    <c:autoTitleDeleted val="1"/>
    <c:plotArea>
      <c:layout>
        <c:manualLayout>
          <c:layoutTarget val="inner"/>
          <c:xMode val="edge"/>
          <c:yMode val="edge"/>
          <c:x val="0.10732415837742601"/>
          <c:y val="0.16256225153726905"/>
          <c:w val="0.7158471042413751"/>
          <c:h val="0.64831624988527792"/>
        </c:manualLayout>
      </c:layout>
      <c:scatterChart>
        <c:scatterStyle val="lineMarker"/>
        <c:ser>
          <c:idx val="0"/>
          <c:order val="0"/>
          <c:tx>
            <c:v>DMSO</c:v>
          </c:tx>
          <c:spPr>
            <a:ln w="19050">
              <a:solidFill>
                <a:schemeClr val="tx1"/>
              </a:solidFill>
            </a:ln>
            <a:effectLst/>
          </c:spPr>
          <c:marker>
            <c:symbol val="diamond"/>
            <c:size val="5"/>
            <c:spPr>
              <a:solidFill>
                <a:schemeClr val="tx1"/>
              </a:solidFill>
              <a:ln>
                <a:solidFill>
                  <a:schemeClr val="tx1"/>
                </a:solidFill>
              </a:ln>
              <a:effectLst/>
            </c:spPr>
          </c:marker>
          <c:errBars>
            <c:errDir val="y"/>
            <c:errBarType val="both"/>
            <c:errValType val="cust"/>
            <c:plus>
              <c:numRef>
                <c:f>'4627 TraErlo'!$B$52:$R$52</c:f>
                <c:numCache>
                  <c:formatCode>General</c:formatCode>
                  <c:ptCount val="17"/>
                  <c:pt idx="0">
                    <c:v>2.7061090000000001</c:v>
                  </c:pt>
                  <c:pt idx="1">
                    <c:v>2.5828609999999985</c:v>
                  </c:pt>
                  <c:pt idx="2">
                    <c:v>4.2587490000000008</c:v>
                  </c:pt>
                  <c:pt idx="3">
                    <c:v>4.2952380000000003</c:v>
                  </c:pt>
                  <c:pt idx="4">
                    <c:v>4.5205069999999816</c:v>
                  </c:pt>
                  <c:pt idx="5">
                    <c:v>5.2823920000000006</c:v>
                  </c:pt>
                  <c:pt idx="6">
                    <c:v>6.0148589999999995</c:v>
                  </c:pt>
                  <c:pt idx="7">
                    <c:v>8.6870719999999988</c:v>
                  </c:pt>
                  <c:pt idx="8">
                    <c:v>9.4986990000000002</c:v>
                  </c:pt>
                  <c:pt idx="9">
                    <c:v>11.755330000000001</c:v>
                  </c:pt>
                  <c:pt idx="10">
                    <c:v>14.07723</c:v>
                  </c:pt>
                  <c:pt idx="11">
                    <c:v>14.58493</c:v>
                  </c:pt>
                  <c:pt idx="12">
                    <c:v>18.843830000000001</c:v>
                  </c:pt>
                  <c:pt idx="13">
                    <c:v>19.228309999999997</c:v>
                  </c:pt>
                  <c:pt idx="14">
                    <c:v>16.936339999999998</c:v>
                  </c:pt>
                  <c:pt idx="15">
                    <c:v>12.852790000000002</c:v>
                  </c:pt>
                  <c:pt idx="16">
                    <c:v>9.5589500000000012</c:v>
                  </c:pt>
                </c:numCache>
              </c:numRef>
            </c:plus>
            <c:minus>
              <c:numRef>
                <c:f>'4627 TraErlo'!$B$52:$R$52</c:f>
                <c:numCache>
                  <c:formatCode>General</c:formatCode>
                  <c:ptCount val="17"/>
                  <c:pt idx="0">
                    <c:v>2.7061090000000001</c:v>
                  </c:pt>
                  <c:pt idx="1">
                    <c:v>2.5828609999999985</c:v>
                  </c:pt>
                  <c:pt idx="2">
                    <c:v>4.2587490000000008</c:v>
                  </c:pt>
                  <c:pt idx="3">
                    <c:v>4.2952380000000003</c:v>
                  </c:pt>
                  <c:pt idx="4">
                    <c:v>4.5205069999999816</c:v>
                  </c:pt>
                  <c:pt idx="5">
                    <c:v>5.2823920000000006</c:v>
                  </c:pt>
                  <c:pt idx="6">
                    <c:v>6.0148589999999995</c:v>
                  </c:pt>
                  <c:pt idx="7">
                    <c:v>8.6870719999999988</c:v>
                  </c:pt>
                  <c:pt idx="8">
                    <c:v>9.4986990000000002</c:v>
                  </c:pt>
                  <c:pt idx="9">
                    <c:v>11.755330000000001</c:v>
                  </c:pt>
                  <c:pt idx="10">
                    <c:v>14.07723</c:v>
                  </c:pt>
                  <c:pt idx="11">
                    <c:v>14.58493</c:v>
                  </c:pt>
                  <c:pt idx="12">
                    <c:v>18.843830000000001</c:v>
                  </c:pt>
                  <c:pt idx="13">
                    <c:v>19.228309999999997</c:v>
                  </c:pt>
                  <c:pt idx="14">
                    <c:v>16.936339999999998</c:v>
                  </c:pt>
                  <c:pt idx="15">
                    <c:v>12.852790000000002</c:v>
                  </c:pt>
                  <c:pt idx="16">
                    <c:v>9.5589500000000012</c:v>
                  </c:pt>
                </c:numCache>
              </c:numRef>
            </c:minus>
          </c:errBars>
          <c:xVal>
            <c:numRef>
              <c:f>'4627 TraErlo'!$B$9:$R$9</c:f>
              <c:numCache>
                <c:formatCode>General</c:formatCode>
                <c:ptCount val="17"/>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pt idx="16">
                  <c:v>96</c:v>
                </c:pt>
              </c:numCache>
            </c:numRef>
          </c:xVal>
          <c:yVal>
            <c:numRef>
              <c:f>'4627 TraErlo'!$B$35:$R$35</c:f>
              <c:numCache>
                <c:formatCode>General</c:formatCode>
                <c:ptCount val="17"/>
                <c:pt idx="0">
                  <c:v>12.063269999999999</c:v>
                </c:pt>
                <c:pt idx="1">
                  <c:v>12.580680000000001</c:v>
                </c:pt>
                <c:pt idx="2">
                  <c:v>14.525460000000001</c:v>
                </c:pt>
                <c:pt idx="3">
                  <c:v>16.572870000000012</c:v>
                </c:pt>
                <c:pt idx="4">
                  <c:v>18.749719999999996</c:v>
                </c:pt>
                <c:pt idx="5">
                  <c:v>21.526109999999999</c:v>
                </c:pt>
                <c:pt idx="6">
                  <c:v>23.194270000000003</c:v>
                </c:pt>
                <c:pt idx="7">
                  <c:v>28.826070000000001</c:v>
                </c:pt>
                <c:pt idx="8">
                  <c:v>33.135370000000009</c:v>
                </c:pt>
                <c:pt idx="9">
                  <c:v>39.68262</c:v>
                </c:pt>
                <c:pt idx="10">
                  <c:v>49.295480000000012</c:v>
                </c:pt>
                <c:pt idx="11">
                  <c:v>55.225110000000015</c:v>
                </c:pt>
                <c:pt idx="12">
                  <c:v>65.573579999999978</c:v>
                </c:pt>
                <c:pt idx="13">
                  <c:v>75.14358</c:v>
                </c:pt>
                <c:pt idx="14">
                  <c:v>79.520420000000001</c:v>
                </c:pt>
                <c:pt idx="15">
                  <c:v>86.202889999999982</c:v>
                </c:pt>
                <c:pt idx="16">
                  <c:v>90.534940000000006</c:v>
                </c:pt>
              </c:numCache>
            </c:numRef>
          </c:yVal>
          <c:extLst xmlns:c16r2="http://schemas.microsoft.com/office/drawing/2015/06/chart">
            <c:ext xmlns:c16="http://schemas.microsoft.com/office/drawing/2014/chart" uri="{C3380CC4-5D6E-409C-BE32-E72D297353CC}">
              <c16:uniqueId val="{00000000-CCA8-2D4A-9E5E-A964BE89A65F}"/>
            </c:ext>
          </c:extLst>
        </c:ser>
        <c:ser>
          <c:idx val="2"/>
          <c:order val="1"/>
          <c:tx>
            <c:strRef>
              <c:f>'4627 TraErlo'!$A$37</c:f>
              <c:strCache>
                <c:ptCount val="1"/>
                <c:pt idx="0">
                  <c:v>Erlotinib 2.5 µM</c:v>
                </c:pt>
              </c:strCache>
            </c:strRef>
          </c:tx>
          <c:spPr>
            <a:ln w="19050">
              <a:solidFill>
                <a:schemeClr val="bg1">
                  <a:lumMod val="50000"/>
                </a:schemeClr>
              </a:solidFill>
            </a:ln>
            <a:effectLst/>
          </c:spPr>
          <c:marker>
            <c:symbol val="x"/>
            <c:size val="5"/>
            <c:spPr>
              <a:noFill/>
              <a:ln>
                <a:solidFill>
                  <a:schemeClr val="bg1">
                    <a:lumMod val="50000"/>
                  </a:schemeClr>
                </a:solidFill>
              </a:ln>
              <a:effectLst/>
            </c:spPr>
          </c:marker>
          <c:errBars>
            <c:errDir val="y"/>
            <c:errBarType val="both"/>
            <c:errValType val="cust"/>
            <c:plus>
              <c:numRef>
                <c:f>'4627 TraErlo'!$B$54:$R$54</c:f>
                <c:numCache>
                  <c:formatCode>General</c:formatCode>
                  <c:ptCount val="17"/>
                  <c:pt idx="0">
                    <c:v>1.3178339999999997</c:v>
                  </c:pt>
                  <c:pt idx="1">
                    <c:v>2.1851740000000004</c:v>
                  </c:pt>
                  <c:pt idx="2">
                    <c:v>2.9144709999999976</c:v>
                  </c:pt>
                  <c:pt idx="3">
                    <c:v>2.5317699999999985</c:v>
                  </c:pt>
                  <c:pt idx="4">
                    <c:v>4.466736</c:v>
                  </c:pt>
                  <c:pt idx="5">
                    <c:v>4.057635999999988</c:v>
                  </c:pt>
                  <c:pt idx="6">
                    <c:v>2.9651340000000004</c:v>
                  </c:pt>
                  <c:pt idx="7">
                    <c:v>5.0298819999999935</c:v>
                  </c:pt>
                  <c:pt idx="8">
                    <c:v>5.0675389999999778</c:v>
                  </c:pt>
                  <c:pt idx="9">
                    <c:v>7.5534319999999946</c:v>
                  </c:pt>
                  <c:pt idx="10">
                    <c:v>8.2702370000000016</c:v>
                  </c:pt>
                  <c:pt idx="11">
                    <c:v>8.976187000000003</c:v>
                  </c:pt>
                  <c:pt idx="12">
                    <c:v>11.581480000000001</c:v>
                  </c:pt>
                  <c:pt idx="13">
                    <c:v>12.66028</c:v>
                  </c:pt>
                  <c:pt idx="14">
                    <c:v>12.648219999999997</c:v>
                  </c:pt>
                  <c:pt idx="15">
                    <c:v>10.537359999999998</c:v>
                  </c:pt>
                  <c:pt idx="16">
                    <c:v>13.09296</c:v>
                  </c:pt>
                </c:numCache>
              </c:numRef>
            </c:plus>
            <c:minus>
              <c:numRef>
                <c:f>'4627 TraErlo'!$B$54:$R$54</c:f>
                <c:numCache>
                  <c:formatCode>General</c:formatCode>
                  <c:ptCount val="17"/>
                  <c:pt idx="0">
                    <c:v>1.3178339999999997</c:v>
                  </c:pt>
                  <c:pt idx="1">
                    <c:v>2.1851740000000004</c:v>
                  </c:pt>
                  <c:pt idx="2">
                    <c:v>2.9144709999999976</c:v>
                  </c:pt>
                  <c:pt idx="3">
                    <c:v>2.5317699999999985</c:v>
                  </c:pt>
                  <c:pt idx="4">
                    <c:v>4.466736</c:v>
                  </c:pt>
                  <c:pt idx="5">
                    <c:v>4.057635999999988</c:v>
                  </c:pt>
                  <c:pt idx="6">
                    <c:v>2.9651340000000004</c:v>
                  </c:pt>
                  <c:pt idx="7">
                    <c:v>5.0298819999999935</c:v>
                  </c:pt>
                  <c:pt idx="8">
                    <c:v>5.0675389999999778</c:v>
                  </c:pt>
                  <c:pt idx="9">
                    <c:v>7.5534319999999946</c:v>
                  </c:pt>
                  <c:pt idx="10">
                    <c:v>8.2702370000000016</c:v>
                  </c:pt>
                  <c:pt idx="11">
                    <c:v>8.976187000000003</c:v>
                  </c:pt>
                  <c:pt idx="12">
                    <c:v>11.581480000000001</c:v>
                  </c:pt>
                  <c:pt idx="13">
                    <c:v>12.66028</c:v>
                  </c:pt>
                  <c:pt idx="14">
                    <c:v>12.648219999999997</c:v>
                  </c:pt>
                  <c:pt idx="15">
                    <c:v>10.537359999999998</c:v>
                  </c:pt>
                  <c:pt idx="16">
                    <c:v>13.09296</c:v>
                  </c:pt>
                </c:numCache>
              </c:numRef>
            </c:minus>
          </c:errBars>
          <c:xVal>
            <c:numRef>
              <c:f>'4627 TraErlo'!$B$9:$R$9</c:f>
              <c:numCache>
                <c:formatCode>General</c:formatCode>
                <c:ptCount val="17"/>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pt idx="16">
                  <c:v>96</c:v>
                </c:pt>
              </c:numCache>
            </c:numRef>
          </c:xVal>
          <c:yVal>
            <c:numRef>
              <c:f>'4627 TraErlo'!$B$37:$R$37</c:f>
              <c:numCache>
                <c:formatCode>General</c:formatCode>
                <c:ptCount val="17"/>
                <c:pt idx="0">
                  <c:v>15.32884</c:v>
                </c:pt>
                <c:pt idx="1">
                  <c:v>15.93065</c:v>
                </c:pt>
                <c:pt idx="2">
                  <c:v>17.822939999999999</c:v>
                </c:pt>
                <c:pt idx="3">
                  <c:v>19.430810000000001</c:v>
                </c:pt>
                <c:pt idx="4">
                  <c:v>21.001810000000003</c:v>
                </c:pt>
                <c:pt idx="5">
                  <c:v>24.137470000000004</c:v>
                </c:pt>
                <c:pt idx="6">
                  <c:v>26.407579999999999</c:v>
                </c:pt>
                <c:pt idx="7">
                  <c:v>27.740549999999882</c:v>
                </c:pt>
                <c:pt idx="8">
                  <c:v>33.705140000000007</c:v>
                </c:pt>
                <c:pt idx="9">
                  <c:v>39.720870000000005</c:v>
                </c:pt>
                <c:pt idx="10">
                  <c:v>44.829530000000005</c:v>
                </c:pt>
                <c:pt idx="11">
                  <c:v>53.87538</c:v>
                </c:pt>
                <c:pt idx="12">
                  <c:v>59.378140000000002</c:v>
                </c:pt>
                <c:pt idx="13">
                  <c:v>68.591840000000005</c:v>
                </c:pt>
                <c:pt idx="14">
                  <c:v>73.943830000000005</c:v>
                </c:pt>
                <c:pt idx="15">
                  <c:v>84.668539999999979</c:v>
                </c:pt>
                <c:pt idx="16">
                  <c:v>87.218180000000004</c:v>
                </c:pt>
              </c:numCache>
            </c:numRef>
          </c:yVal>
          <c:extLst xmlns:c16r2="http://schemas.microsoft.com/office/drawing/2015/06/chart">
            <c:ext xmlns:c16="http://schemas.microsoft.com/office/drawing/2014/chart" uri="{C3380CC4-5D6E-409C-BE32-E72D297353CC}">
              <c16:uniqueId val="{00000001-CCA8-2D4A-9E5E-A964BE89A65F}"/>
            </c:ext>
          </c:extLst>
        </c:ser>
        <c:ser>
          <c:idx val="3"/>
          <c:order val="2"/>
          <c:tx>
            <c:strRef>
              <c:f>'4627 TraErlo'!$A$38</c:f>
              <c:strCache>
                <c:ptCount val="1"/>
                <c:pt idx="0">
                  <c:v>Trametinib 100 nM</c:v>
                </c:pt>
              </c:strCache>
            </c:strRef>
          </c:tx>
          <c:spPr>
            <a:ln w="19050">
              <a:solidFill>
                <a:srgbClr val="C00000"/>
              </a:solidFill>
            </a:ln>
            <a:effectLst/>
          </c:spPr>
          <c:marker>
            <c:symbol val="square"/>
            <c:size val="5"/>
            <c:spPr>
              <a:solidFill>
                <a:srgbClr val="C00000"/>
              </a:solidFill>
              <a:ln>
                <a:solidFill>
                  <a:srgbClr val="C00000"/>
                </a:solidFill>
              </a:ln>
              <a:effectLst/>
            </c:spPr>
          </c:marker>
          <c:errBars>
            <c:errDir val="y"/>
            <c:errBarType val="both"/>
            <c:errValType val="cust"/>
            <c:plus>
              <c:numRef>
                <c:f>'4627 TraErlo'!$B$55:$R$55</c:f>
                <c:numCache>
                  <c:formatCode>General</c:formatCode>
                  <c:ptCount val="17"/>
                  <c:pt idx="0">
                    <c:v>1.9252289999999999</c:v>
                  </c:pt>
                  <c:pt idx="1">
                    <c:v>1.9504190000000001</c:v>
                  </c:pt>
                  <c:pt idx="2">
                    <c:v>2.2299640000000003</c:v>
                  </c:pt>
                  <c:pt idx="3">
                    <c:v>2.4742699999999997</c:v>
                  </c:pt>
                  <c:pt idx="4">
                    <c:v>3.2362049999999996</c:v>
                  </c:pt>
                  <c:pt idx="5">
                    <c:v>4.3873859999999816</c:v>
                  </c:pt>
                  <c:pt idx="6">
                    <c:v>5.2550990000000004</c:v>
                  </c:pt>
                  <c:pt idx="7">
                    <c:v>5.5866920000000011</c:v>
                  </c:pt>
                  <c:pt idx="8">
                    <c:v>6.4127999999999998</c:v>
                  </c:pt>
                  <c:pt idx="9">
                    <c:v>7.6829899999999789</c:v>
                  </c:pt>
                  <c:pt idx="10">
                    <c:v>5.0857890000000001</c:v>
                  </c:pt>
                  <c:pt idx="11">
                    <c:v>8.5156990000000015</c:v>
                  </c:pt>
                  <c:pt idx="12">
                    <c:v>10.49325</c:v>
                  </c:pt>
                  <c:pt idx="13">
                    <c:v>9.6793010000000006</c:v>
                  </c:pt>
                  <c:pt idx="14">
                    <c:v>9.7394250000000007</c:v>
                  </c:pt>
                  <c:pt idx="15">
                    <c:v>13.082500000000001</c:v>
                  </c:pt>
                  <c:pt idx="16">
                    <c:v>15.78265</c:v>
                  </c:pt>
                </c:numCache>
              </c:numRef>
            </c:plus>
            <c:minus>
              <c:numRef>
                <c:f>'4627 TraErlo'!$B$55:$R$55</c:f>
                <c:numCache>
                  <c:formatCode>General</c:formatCode>
                  <c:ptCount val="17"/>
                  <c:pt idx="0">
                    <c:v>1.9252289999999999</c:v>
                  </c:pt>
                  <c:pt idx="1">
                    <c:v>1.9504190000000001</c:v>
                  </c:pt>
                  <c:pt idx="2">
                    <c:v>2.2299640000000003</c:v>
                  </c:pt>
                  <c:pt idx="3">
                    <c:v>2.4742699999999997</c:v>
                  </c:pt>
                  <c:pt idx="4">
                    <c:v>3.2362049999999996</c:v>
                  </c:pt>
                  <c:pt idx="5">
                    <c:v>4.3873859999999816</c:v>
                  </c:pt>
                  <c:pt idx="6">
                    <c:v>5.2550990000000004</c:v>
                  </c:pt>
                  <c:pt idx="7">
                    <c:v>5.5866920000000011</c:v>
                  </c:pt>
                  <c:pt idx="8">
                    <c:v>6.4127999999999998</c:v>
                  </c:pt>
                  <c:pt idx="9">
                    <c:v>7.6829899999999789</c:v>
                  </c:pt>
                  <c:pt idx="10">
                    <c:v>5.0857890000000001</c:v>
                  </c:pt>
                  <c:pt idx="11">
                    <c:v>8.5156990000000015</c:v>
                  </c:pt>
                  <c:pt idx="12">
                    <c:v>10.49325</c:v>
                  </c:pt>
                  <c:pt idx="13">
                    <c:v>9.6793010000000006</c:v>
                  </c:pt>
                  <c:pt idx="14">
                    <c:v>9.7394250000000007</c:v>
                  </c:pt>
                  <c:pt idx="15">
                    <c:v>13.082500000000001</c:v>
                  </c:pt>
                  <c:pt idx="16">
                    <c:v>15.78265</c:v>
                  </c:pt>
                </c:numCache>
              </c:numRef>
            </c:minus>
          </c:errBars>
          <c:xVal>
            <c:numRef>
              <c:f>'4627 TraErlo'!$B$9:$R$9</c:f>
              <c:numCache>
                <c:formatCode>General</c:formatCode>
                <c:ptCount val="17"/>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pt idx="16">
                  <c:v>96</c:v>
                </c:pt>
              </c:numCache>
            </c:numRef>
          </c:xVal>
          <c:yVal>
            <c:numRef>
              <c:f>'4627 TraErlo'!$B$38:$R$38</c:f>
              <c:numCache>
                <c:formatCode>General</c:formatCode>
                <c:ptCount val="17"/>
                <c:pt idx="0">
                  <c:v>14.121739999999999</c:v>
                </c:pt>
                <c:pt idx="1">
                  <c:v>15.377610000000001</c:v>
                </c:pt>
                <c:pt idx="2">
                  <c:v>14.430369999999998</c:v>
                </c:pt>
                <c:pt idx="3">
                  <c:v>17.438359999999999</c:v>
                </c:pt>
                <c:pt idx="4">
                  <c:v>23.399639999999998</c:v>
                </c:pt>
                <c:pt idx="5">
                  <c:v>26.069709999999997</c:v>
                </c:pt>
                <c:pt idx="6">
                  <c:v>29.783169999999977</c:v>
                </c:pt>
                <c:pt idx="7">
                  <c:v>36.142050000000005</c:v>
                </c:pt>
                <c:pt idx="8">
                  <c:v>32.969610000000003</c:v>
                </c:pt>
                <c:pt idx="9">
                  <c:v>37.69212000000001</c:v>
                </c:pt>
                <c:pt idx="10">
                  <c:v>39.069810000000004</c:v>
                </c:pt>
                <c:pt idx="11">
                  <c:v>41.919259999999994</c:v>
                </c:pt>
                <c:pt idx="12">
                  <c:v>42.205220000000011</c:v>
                </c:pt>
                <c:pt idx="13">
                  <c:v>45.263030000000008</c:v>
                </c:pt>
                <c:pt idx="14">
                  <c:v>47.402420000000006</c:v>
                </c:pt>
                <c:pt idx="15">
                  <c:v>49.061600000000006</c:v>
                </c:pt>
                <c:pt idx="16">
                  <c:v>51.852039999999995</c:v>
                </c:pt>
              </c:numCache>
            </c:numRef>
          </c:yVal>
          <c:extLst xmlns:c16r2="http://schemas.microsoft.com/office/drawing/2015/06/chart">
            <c:ext xmlns:c16="http://schemas.microsoft.com/office/drawing/2014/chart" uri="{C3380CC4-5D6E-409C-BE32-E72D297353CC}">
              <c16:uniqueId val="{00000002-CCA8-2D4A-9E5E-A964BE89A65F}"/>
            </c:ext>
          </c:extLst>
        </c:ser>
        <c:ser>
          <c:idx val="4"/>
          <c:order val="3"/>
          <c:tx>
            <c:strRef>
              <c:f>'4627 TraErlo'!$A$39</c:f>
              <c:strCache>
                <c:ptCount val="1"/>
                <c:pt idx="0">
                  <c:v>Trametinib 50 nM</c:v>
                </c:pt>
              </c:strCache>
            </c:strRef>
          </c:tx>
          <c:spPr>
            <a:ln w="19050">
              <a:solidFill>
                <a:srgbClr val="FF0000"/>
              </a:solidFill>
            </a:ln>
            <a:effectLst/>
          </c:spPr>
          <c:marker>
            <c:symbol val="square"/>
            <c:size val="5"/>
            <c:spPr>
              <a:solidFill>
                <a:srgbClr val="FF0000"/>
              </a:solidFill>
              <a:ln>
                <a:solidFill>
                  <a:srgbClr val="FF0000"/>
                </a:solidFill>
              </a:ln>
              <a:effectLst/>
            </c:spPr>
          </c:marker>
          <c:errBars>
            <c:errDir val="y"/>
            <c:errBarType val="both"/>
            <c:errValType val="cust"/>
            <c:plus>
              <c:numRef>
                <c:f>'4627 TraErlo'!$B$56:$R$56</c:f>
                <c:numCache>
                  <c:formatCode>General</c:formatCode>
                  <c:ptCount val="17"/>
                  <c:pt idx="0">
                    <c:v>2.4245140000000003</c:v>
                  </c:pt>
                  <c:pt idx="1">
                    <c:v>2.7929689999999976</c:v>
                  </c:pt>
                  <c:pt idx="2">
                    <c:v>2.2127140000000001</c:v>
                  </c:pt>
                  <c:pt idx="3">
                    <c:v>4.3475919999999881</c:v>
                  </c:pt>
                  <c:pt idx="4">
                    <c:v>4.7815320000000003</c:v>
                  </c:pt>
                  <c:pt idx="5">
                    <c:v>4.3403720000000003</c:v>
                  </c:pt>
                  <c:pt idx="6">
                    <c:v>3.4286949999999998</c:v>
                  </c:pt>
                  <c:pt idx="7">
                    <c:v>6.563008</c:v>
                  </c:pt>
                  <c:pt idx="8">
                    <c:v>7.778633000000001</c:v>
                  </c:pt>
                  <c:pt idx="9">
                    <c:v>8.6668020000000006</c:v>
                  </c:pt>
                  <c:pt idx="10">
                    <c:v>6.8825189999999816</c:v>
                  </c:pt>
                  <c:pt idx="11">
                    <c:v>9.2559060000000013</c:v>
                  </c:pt>
                  <c:pt idx="12">
                    <c:v>7.297447</c:v>
                  </c:pt>
                  <c:pt idx="13">
                    <c:v>11.287649999999999</c:v>
                  </c:pt>
                  <c:pt idx="14">
                    <c:v>8.3946540000000009</c:v>
                  </c:pt>
                  <c:pt idx="15">
                    <c:v>14.33367</c:v>
                  </c:pt>
                  <c:pt idx="16">
                    <c:v>9.7878629999999962</c:v>
                  </c:pt>
                </c:numCache>
              </c:numRef>
            </c:plus>
            <c:minus>
              <c:numRef>
                <c:f>'4627 TraErlo'!$B$56:$R$56</c:f>
                <c:numCache>
                  <c:formatCode>General</c:formatCode>
                  <c:ptCount val="17"/>
                  <c:pt idx="0">
                    <c:v>2.4245140000000003</c:v>
                  </c:pt>
                  <c:pt idx="1">
                    <c:v>2.7929689999999976</c:v>
                  </c:pt>
                  <c:pt idx="2">
                    <c:v>2.2127140000000001</c:v>
                  </c:pt>
                  <c:pt idx="3">
                    <c:v>4.3475919999999881</c:v>
                  </c:pt>
                  <c:pt idx="4">
                    <c:v>4.7815320000000003</c:v>
                  </c:pt>
                  <c:pt idx="5">
                    <c:v>4.3403720000000003</c:v>
                  </c:pt>
                  <c:pt idx="6">
                    <c:v>3.4286949999999998</c:v>
                  </c:pt>
                  <c:pt idx="7">
                    <c:v>6.563008</c:v>
                  </c:pt>
                  <c:pt idx="8">
                    <c:v>7.778633000000001</c:v>
                  </c:pt>
                  <c:pt idx="9">
                    <c:v>8.6668020000000006</c:v>
                  </c:pt>
                  <c:pt idx="10">
                    <c:v>6.8825189999999816</c:v>
                  </c:pt>
                  <c:pt idx="11">
                    <c:v>9.2559060000000013</c:v>
                  </c:pt>
                  <c:pt idx="12">
                    <c:v>7.297447</c:v>
                  </c:pt>
                  <c:pt idx="13">
                    <c:v>11.287649999999999</c:v>
                  </c:pt>
                  <c:pt idx="14">
                    <c:v>8.3946540000000009</c:v>
                  </c:pt>
                  <c:pt idx="15">
                    <c:v>14.33367</c:v>
                  </c:pt>
                  <c:pt idx="16">
                    <c:v>9.7878629999999962</c:v>
                  </c:pt>
                </c:numCache>
              </c:numRef>
            </c:minus>
          </c:errBars>
          <c:xVal>
            <c:numRef>
              <c:f>'4627 TraErlo'!$B$9:$R$9</c:f>
              <c:numCache>
                <c:formatCode>General</c:formatCode>
                <c:ptCount val="17"/>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pt idx="16">
                  <c:v>96</c:v>
                </c:pt>
              </c:numCache>
            </c:numRef>
          </c:xVal>
          <c:yVal>
            <c:numRef>
              <c:f>'4627 TraErlo'!$B$39:$R$39</c:f>
              <c:numCache>
                <c:formatCode>General</c:formatCode>
                <c:ptCount val="17"/>
                <c:pt idx="0">
                  <c:v>11.410500000000001</c:v>
                </c:pt>
                <c:pt idx="1">
                  <c:v>12.7585</c:v>
                </c:pt>
                <c:pt idx="2">
                  <c:v>12.975480000000003</c:v>
                </c:pt>
                <c:pt idx="3">
                  <c:v>15.66375</c:v>
                </c:pt>
                <c:pt idx="4">
                  <c:v>17.949679999999997</c:v>
                </c:pt>
                <c:pt idx="5">
                  <c:v>20.605239999999977</c:v>
                </c:pt>
                <c:pt idx="6">
                  <c:v>22.426729999999882</c:v>
                </c:pt>
                <c:pt idx="7">
                  <c:v>25.142339999999997</c:v>
                </c:pt>
                <c:pt idx="8">
                  <c:v>28.95739</c:v>
                </c:pt>
                <c:pt idx="9">
                  <c:v>28.967669999999977</c:v>
                </c:pt>
                <c:pt idx="10">
                  <c:v>31.537210000000012</c:v>
                </c:pt>
                <c:pt idx="11">
                  <c:v>35.961639999999996</c:v>
                </c:pt>
                <c:pt idx="12">
                  <c:v>35.584899999999998</c:v>
                </c:pt>
                <c:pt idx="13">
                  <c:v>39.842669999999998</c:v>
                </c:pt>
                <c:pt idx="14">
                  <c:v>39.019500000000001</c:v>
                </c:pt>
                <c:pt idx="15">
                  <c:v>42.469060000000006</c:v>
                </c:pt>
                <c:pt idx="16">
                  <c:v>41.802639999999997</c:v>
                </c:pt>
              </c:numCache>
            </c:numRef>
          </c:yVal>
          <c:extLst xmlns:c16r2="http://schemas.microsoft.com/office/drawing/2015/06/chart">
            <c:ext xmlns:c16="http://schemas.microsoft.com/office/drawing/2014/chart" uri="{C3380CC4-5D6E-409C-BE32-E72D297353CC}">
              <c16:uniqueId val="{00000003-CCA8-2D4A-9E5E-A964BE89A65F}"/>
            </c:ext>
          </c:extLst>
        </c:ser>
        <c:ser>
          <c:idx val="12"/>
          <c:order val="4"/>
          <c:tx>
            <c:v>Erl 2.5µM + Tra 50nM</c:v>
          </c:tx>
          <c:spPr>
            <a:ln w="19050">
              <a:solidFill>
                <a:srgbClr val="7030A0"/>
              </a:solidFill>
            </a:ln>
            <a:effectLst/>
          </c:spPr>
          <c:marker>
            <c:symbol val="plus"/>
            <c:size val="5"/>
            <c:spPr>
              <a:noFill/>
              <a:ln>
                <a:solidFill>
                  <a:srgbClr val="7030A0"/>
                </a:solidFill>
              </a:ln>
              <a:effectLst/>
            </c:spPr>
          </c:marker>
          <c:errBars>
            <c:errDir val="y"/>
            <c:errBarType val="both"/>
            <c:errValType val="cust"/>
            <c:plus>
              <c:numRef>
                <c:f>'4627 TraErlo'!$B$64:$R$64</c:f>
                <c:numCache>
                  <c:formatCode>General</c:formatCode>
                  <c:ptCount val="17"/>
                  <c:pt idx="0">
                    <c:v>1.3706229999999999</c:v>
                  </c:pt>
                  <c:pt idx="1">
                    <c:v>1.6974880000000001</c:v>
                  </c:pt>
                  <c:pt idx="2">
                    <c:v>2.0007770000000002</c:v>
                  </c:pt>
                  <c:pt idx="3">
                    <c:v>2.5820979999999998</c:v>
                  </c:pt>
                  <c:pt idx="4">
                    <c:v>4.9884550000000001</c:v>
                  </c:pt>
                  <c:pt idx="5">
                    <c:v>5.0634009999999936</c:v>
                  </c:pt>
                  <c:pt idx="6">
                    <c:v>4.6439049999999789</c:v>
                  </c:pt>
                  <c:pt idx="7">
                    <c:v>6.4061220000000008</c:v>
                  </c:pt>
                  <c:pt idx="8">
                    <c:v>6.1488490000000002</c:v>
                  </c:pt>
                  <c:pt idx="9">
                    <c:v>8.2629090000000005</c:v>
                  </c:pt>
                  <c:pt idx="10">
                    <c:v>4.805002</c:v>
                  </c:pt>
                  <c:pt idx="11">
                    <c:v>4.216888</c:v>
                  </c:pt>
                  <c:pt idx="12">
                    <c:v>4.1027649999999936</c:v>
                  </c:pt>
                  <c:pt idx="13">
                    <c:v>4.9355960000000003</c:v>
                  </c:pt>
                  <c:pt idx="14">
                    <c:v>5.8573659999999936</c:v>
                  </c:pt>
                  <c:pt idx="15">
                    <c:v>3.9310089999999995</c:v>
                  </c:pt>
                  <c:pt idx="16">
                    <c:v>7.0999189999999945</c:v>
                  </c:pt>
                </c:numCache>
              </c:numRef>
            </c:plus>
            <c:minus>
              <c:numRef>
                <c:f>'4627 TraErlo'!$B$64:$R$64</c:f>
                <c:numCache>
                  <c:formatCode>General</c:formatCode>
                  <c:ptCount val="17"/>
                  <c:pt idx="0">
                    <c:v>1.3706229999999999</c:v>
                  </c:pt>
                  <c:pt idx="1">
                    <c:v>1.6974880000000001</c:v>
                  </c:pt>
                  <c:pt idx="2">
                    <c:v>2.0007770000000002</c:v>
                  </c:pt>
                  <c:pt idx="3">
                    <c:v>2.5820979999999998</c:v>
                  </c:pt>
                  <c:pt idx="4">
                    <c:v>4.9884550000000001</c:v>
                  </c:pt>
                  <c:pt idx="5">
                    <c:v>5.0634009999999936</c:v>
                  </c:pt>
                  <c:pt idx="6">
                    <c:v>4.6439049999999789</c:v>
                  </c:pt>
                  <c:pt idx="7">
                    <c:v>6.4061220000000008</c:v>
                  </c:pt>
                  <c:pt idx="8">
                    <c:v>6.1488490000000002</c:v>
                  </c:pt>
                  <c:pt idx="9">
                    <c:v>8.2629090000000005</c:v>
                  </c:pt>
                  <c:pt idx="10">
                    <c:v>4.805002</c:v>
                  </c:pt>
                  <c:pt idx="11">
                    <c:v>4.216888</c:v>
                  </c:pt>
                  <c:pt idx="12">
                    <c:v>4.1027649999999936</c:v>
                  </c:pt>
                  <c:pt idx="13">
                    <c:v>4.9355960000000003</c:v>
                  </c:pt>
                  <c:pt idx="14">
                    <c:v>5.8573659999999936</c:v>
                  </c:pt>
                  <c:pt idx="15">
                    <c:v>3.9310089999999995</c:v>
                  </c:pt>
                  <c:pt idx="16">
                    <c:v>7.0999189999999945</c:v>
                  </c:pt>
                </c:numCache>
              </c:numRef>
            </c:minus>
          </c:errBars>
          <c:xVal>
            <c:numRef>
              <c:f>'4627 TraErlo'!$B$9:$R$9</c:f>
              <c:numCache>
                <c:formatCode>General</c:formatCode>
                <c:ptCount val="17"/>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pt idx="16">
                  <c:v>96</c:v>
                </c:pt>
              </c:numCache>
            </c:numRef>
          </c:xVal>
          <c:yVal>
            <c:numRef>
              <c:f>'4627 TraErlo'!$B$47:$R$47</c:f>
              <c:numCache>
                <c:formatCode>General</c:formatCode>
                <c:ptCount val="17"/>
                <c:pt idx="0">
                  <c:v>14.206319999999998</c:v>
                </c:pt>
                <c:pt idx="1">
                  <c:v>15.737979999999999</c:v>
                </c:pt>
                <c:pt idx="2">
                  <c:v>16.37557</c:v>
                </c:pt>
                <c:pt idx="3">
                  <c:v>19.223389999999977</c:v>
                </c:pt>
                <c:pt idx="4">
                  <c:v>23.059550000000012</c:v>
                </c:pt>
                <c:pt idx="5">
                  <c:v>26.35538</c:v>
                </c:pt>
                <c:pt idx="6">
                  <c:v>29.692350000000001</c:v>
                </c:pt>
                <c:pt idx="7">
                  <c:v>33.390060000000005</c:v>
                </c:pt>
                <c:pt idx="8">
                  <c:v>34.912590000000002</c:v>
                </c:pt>
                <c:pt idx="9">
                  <c:v>41.257869999999997</c:v>
                </c:pt>
                <c:pt idx="10">
                  <c:v>38.339710000000004</c:v>
                </c:pt>
                <c:pt idx="11">
                  <c:v>36.647859999999994</c:v>
                </c:pt>
                <c:pt idx="12">
                  <c:v>41.47636</c:v>
                </c:pt>
                <c:pt idx="13">
                  <c:v>45.197790000000005</c:v>
                </c:pt>
                <c:pt idx="14">
                  <c:v>45.68497</c:v>
                </c:pt>
                <c:pt idx="15">
                  <c:v>44.744</c:v>
                </c:pt>
                <c:pt idx="16">
                  <c:v>41.217190000000002</c:v>
                </c:pt>
              </c:numCache>
            </c:numRef>
          </c:yVal>
          <c:extLst xmlns:c16r2="http://schemas.microsoft.com/office/drawing/2015/06/chart">
            <c:ext xmlns:c16="http://schemas.microsoft.com/office/drawing/2014/chart" uri="{C3380CC4-5D6E-409C-BE32-E72D297353CC}">
              <c16:uniqueId val="{00000004-CCA8-2D4A-9E5E-A964BE89A65F}"/>
            </c:ext>
          </c:extLst>
        </c:ser>
        <c:dLbls/>
        <c:axId val="100332672"/>
        <c:axId val="100333824"/>
      </c:scatterChart>
      <c:valAx>
        <c:axId val="100332672"/>
        <c:scaling>
          <c:orientation val="minMax"/>
          <c:max val="90"/>
        </c:scaling>
        <c:axPos val="b"/>
        <c:numFmt formatCode="General" sourceLinked="1"/>
        <c:tickLblPos val="nextTo"/>
        <c:crossAx val="100333824"/>
        <c:crosses val="autoZero"/>
        <c:crossBetween val="midCat"/>
        <c:majorUnit val="15"/>
      </c:valAx>
      <c:valAx>
        <c:axId val="100333824"/>
        <c:scaling>
          <c:orientation val="minMax"/>
          <c:max val="100"/>
        </c:scaling>
        <c:axPos val="l"/>
        <c:majorGridlines/>
        <c:title>
          <c:tx>
            <c:rich>
              <a:bodyPr rot="-5400000" vert="horz"/>
              <a:lstStyle/>
              <a:p>
                <a:pPr>
                  <a:defRPr/>
                </a:pPr>
                <a:r>
                  <a:rPr lang="en-US" dirty="0"/>
                  <a:t>% Confluence</a:t>
                </a:r>
              </a:p>
            </c:rich>
          </c:tx>
          <c:layout>
            <c:manualLayout>
              <c:xMode val="edge"/>
              <c:yMode val="edge"/>
              <c:x val="1.5049272817060005E-2"/>
              <c:y val="0.24440943759872108"/>
            </c:manualLayout>
          </c:layout>
        </c:title>
        <c:numFmt formatCode="General" sourceLinked="1"/>
        <c:tickLblPos val="nextTo"/>
        <c:crossAx val="100332672"/>
        <c:crosses val="autoZero"/>
        <c:crossBetween val="midCat"/>
        <c:majorUnit val="10"/>
      </c:valAx>
    </c:plotArea>
    <c:plotVisOnly val="1"/>
    <c:dispBlanksAs val="gap"/>
  </c:chart>
  <c:txPr>
    <a:bodyPr/>
    <a:lstStyle/>
    <a:p>
      <a:pPr>
        <a:defRPr sz="800"/>
      </a:pPr>
      <a:endParaRPr lang="en-US"/>
    </a:p>
  </c:txPr>
  <c:externalData r:id="rId1"/>
</c:chartSpace>
</file>

<file path=ppt/charts/chart7.xml><?xml version="1.0" encoding="utf-8"?>
<c:chartSpace xmlns:c="http://schemas.openxmlformats.org/drawingml/2006/chart" xmlns:a="http://schemas.openxmlformats.org/drawingml/2006/main" xmlns:r="http://schemas.openxmlformats.org/officeDocument/2006/relationships">
  <c:lang val="en-IN"/>
  <c:style val="18"/>
  <c:chart>
    <c:autoTitleDeleted val="1"/>
    <c:plotArea>
      <c:layout>
        <c:manualLayout>
          <c:layoutTarget val="inner"/>
          <c:xMode val="edge"/>
          <c:yMode val="edge"/>
          <c:x val="0.10726375202287403"/>
          <c:y val="0.19272080879902201"/>
          <c:w val="0.7113484462743902"/>
          <c:h val="0.56779468947894707"/>
        </c:manualLayout>
      </c:layout>
      <c:scatterChart>
        <c:scatterStyle val="lineMarker"/>
        <c:ser>
          <c:idx val="0"/>
          <c:order val="0"/>
          <c:tx>
            <c:v>DMSO</c:v>
          </c:tx>
          <c:spPr>
            <a:ln w="19050">
              <a:solidFill>
                <a:schemeClr val="tx1"/>
              </a:solidFill>
            </a:ln>
            <a:effectLst/>
          </c:spPr>
          <c:marker>
            <c:symbol val="diamond"/>
            <c:size val="5"/>
            <c:spPr>
              <a:solidFill>
                <a:schemeClr val="tx1"/>
              </a:solidFill>
              <a:ln>
                <a:solidFill>
                  <a:schemeClr val="tx1"/>
                </a:solidFill>
              </a:ln>
              <a:effectLst/>
            </c:spPr>
          </c:marker>
          <c:errBars>
            <c:errDir val="y"/>
            <c:errBarType val="both"/>
            <c:errValType val="cust"/>
            <c:plus>
              <c:numRef>
                <c:f>'Macintosh HD:Users:ovcarelab:Desktop:Josh Master''s Files:Erlotinib-Sel-Project:MTS and CV:Incucyte Raw Data:3723:[21080305-3723 Raw Data TraErlo.xlsx]3723 Raw Data TraErlo.txt'!$T$28:$AI$28</c:f>
                <c:numCache>
                  <c:formatCode>General</c:formatCode>
                  <c:ptCount val="16"/>
                  <c:pt idx="0">
                    <c:v>1.7824500000000001</c:v>
                  </c:pt>
                  <c:pt idx="1">
                    <c:v>2.1728789999999996</c:v>
                  </c:pt>
                  <c:pt idx="2">
                    <c:v>2.2362109999999986</c:v>
                  </c:pt>
                  <c:pt idx="3">
                    <c:v>2.1272770000000003</c:v>
                  </c:pt>
                  <c:pt idx="4">
                    <c:v>2.552465999999983</c:v>
                  </c:pt>
                  <c:pt idx="5">
                    <c:v>3.1346079999999996</c:v>
                  </c:pt>
                  <c:pt idx="6">
                    <c:v>3.197851</c:v>
                  </c:pt>
                  <c:pt idx="7">
                    <c:v>4.8279009999999758</c:v>
                  </c:pt>
                  <c:pt idx="8">
                    <c:v>5.5232770000000002</c:v>
                  </c:pt>
                  <c:pt idx="9">
                    <c:v>5.4210460000000005</c:v>
                  </c:pt>
                  <c:pt idx="10">
                    <c:v>6.6440219999999881</c:v>
                  </c:pt>
                  <c:pt idx="11">
                    <c:v>6.7050910000000004</c:v>
                  </c:pt>
                  <c:pt idx="12">
                    <c:v>7.1872920000000002</c:v>
                  </c:pt>
                  <c:pt idx="13">
                    <c:v>6.357342</c:v>
                  </c:pt>
                  <c:pt idx="14">
                    <c:v>6.0332930000000013</c:v>
                  </c:pt>
                  <c:pt idx="15">
                    <c:v>4.3137879999999882</c:v>
                  </c:pt>
                </c:numCache>
              </c:numRef>
            </c:plus>
            <c:minus>
              <c:numRef>
                <c:f>'Macintosh HD:Users:ovcarelab:Desktop:Josh Master''s Files:Erlotinib-Sel-Project:MTS and CV:Incucyte Raw Data:3723:[21080305-3723 Raw Data TraErlo.xlsx]3723 Raw Data TraErlo.txt'!$T$28:$AI$28</c:f>
                <c:numCache>
                  <c:formatCode>General</c:formatCode>
                  <c:ptCount val="16"/>
                  <c:pt idx="0">
                    <c:v>1.7824500000000001</c:v>
                  </c:pt>
                  <c:pt idx="1">
                    <c:v>2.1728789999999996</c:v>
                  </c:pt>
                  <c:pt idx="2">
                    <c:v>2.2362109999999986</c:v>
                  </c:pt>
                  <c:pt idx="3">
                    <c:v>2.1272770000000003</c:v>
                  </c:pt>
                  <c:pt idx="4">
                    <c:v>2.552465999999983</c:v>
                  </c:pt>
                  <c:pt idx="5">
                    <c:v>3.1346079999999996</c:v>
                  </c:pt>
                  <c:pt idx="6">
                    <c:v>3.197851</c:v>
                  </c:pt>
                  <c:pt idx="7">
                    <c:v>4.8279009999999758</c:v>
                  </c:pt>
                  <c:pt idx="8">
                    <c:v>5.5232770000000002</c:v>
                  </c:pt>
                  <c:pt idx="9">
                    <c:v>5.4210460000000005</c:v>
                  </c:pt>
                  <c:pt idx="10">
                    <c:v>6.6440219999999881</c:v>
                  </c:pt>
                  <c:pt idx="11">
                    <c:v>6.7050910000000004</c:v>
                  </c:pt>
                  <c:pt idx="12">
                    <c:v>7.1872920000000002</c:v>
                  </c:pt>
                  <c:pt idx="13">
                    <c:v>6.357342</c:v>
                  </c:pt>
                  <c:pt idx="14">
                    <c:v>6.0332930000000013</c:v>
                  </c:pt>
                  <c:pt idx="15">
                    <c:v>4.3137879999999882</c:v>
                  </c:pt>
                </c:numCache>
              </c:numRef>
            </c:minus>
          </c:errBars>
          <c:xVal>
            <c:numRef>
              <c:f>'Macintosh HD:Users:ovcarelab:Desktop:Josh Master''s Files:Erlotinib-Sel-Project:MTS and CV:Incucyte Raw Data:3723:[21080305-3723 Raw Data TraErlo.xlsx]3723 Raw Data TraErlo.txt'!$B$27:$Q$27</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3723:[21080305-3723 Raw Data TraErlo.xlsx]3723 Raw Data TraErlo.txt'!$B$28:$Q$28</c:f>
              <c:numCache>
                <c:formatCode>General</c:formatCode>
                <c:ptCount val="16"/>
                <c:pt idx="0">
                  <c:v>20.04918</c:v>
                </c:pt>
                <c:pt idx="1">
                  <c:v>21.43777</c:v>
                </c:pt>
                <c:pt idx="2">
                  <c:v>23.843329999999998</c:v>
                </c:pt>
                <c:pt idx="3">
                  <c:v>26.73433</c:v>
                </c:pt>
                <c:pt idx="4">
                  <c:v>29.260619999999882</c:v>
                </c:pt>
                <c:pt idx="5">
                  <c:v>32.564210000000003</c:v>
                </c:pt>
                <c:pt idx="6">
                  <c:v>36.32141</c:v>
                </c:pt>
                <c:pt idx="7">
                  <c:v>42.029140000000012</c:v>
                </c:pt>
                <c:pt idx="8">
                  <c:v>50.32114</c:v>
                </c:pt>
                <c:pt idx="9">
                  <c:v>56.167070000000002</c:v>
                </c:pt>
                <c:pt idx="10">
                  <c:v>63.213790000000003</c:v>
                </c:pt>
                <c:pt idx="11">
                  <c:v>73.827089999999998</c:v>
                </c:pt>
                <c:pt idx="12">
                  <c:v>80.606549999999999</c:v>
                </c:pt>
                <c:pt idx="13">
                  <c:v>84.932040000000001</c:v>
                </c:pt>
                <c:pt idx="14">
                  <c:v>90.033230000000003</c:v>
                </c:pt>
                <c:pt idx="15">
                  <c:v>93.856709999999978</c:v>
                </c:pt>
              </c:numCache>
            </c:numRef>
          </c:yVal>
          <c:extLst xmlns:c16r2="http://schemas.microsoft.com/office/drawing/2015/06/chart">
            <c:ext xmlns:c16="http://schemas.microsoft.com/office/drawing/2014/chart" uri="{C3380CC4-5D6E-409C-BE32-E72D297353CC}">
              <c16:uniqueId val="{00000000-F108-D94C-B0DA-95BA7BD4D8C5}"/>
            </c:ext>
          </c:extLst>
        </c:ser>
        <c:ser>
          <c:idx val="2"/>
          <c:order val="1"/>
          <c:tx>
            <c:strRef>
              <c:f>'Macintosh HD:Users:ovcarelab:Desktop:Josh Master''s Files:Erlotinib-Sel-Project:MTS and CV:Incucyte Raw Data:3723:[21080305-3723 Raw Data TraErlo.xlsx]3723 Raw Data TraErlo.txt'!$A$30</c:f>
              <c:strCache>
                <c:ptCount val="1"/>
                <c:pt idx="0">
                  <c:v>Erlotinib 2.5µM</c:v>
                </c:pt>
              </c:strCache>
            </c:strRef>
          </c:tx>
          <c:spPr>
            <a:ln w="19050">
              <a:solidFill>
                <a:schemeClr val="bg1">
                  <a:lumMod val="50000"/>
                </a:schemeClr>
              </a:solidFill>
            </a:ln>
            <a:effectLst/>
          </c:spPr>
          <c:marker>
            <c:symbol val="x"/>
            <c:size val="5"/>
            <c:spPr>
              <a:noFill/>
              <a:ln>
                <a:solidFill>
                  <a:schemeClr val="bg1">
                    <a:lumMod val="50000"/>
                  </a:schemeClr>
                </a:solidFill>
              </a:ln>
              <a:effectLst/>
            </c:spPr>
          </c:marker>
          <c:errBars>
            <c:errDir val="y"/>
            <c:errBarType val="both"/>
            <c:errValType val="cust"/>
            <c:plus>
              <c:numRef>
                <c:f>'Macintosh HD:Users:ovcarelab:Desktop:Josh Master''s Files:Erlotinib-Sel-Project:MTS and CV:Incucyte Raw Data:3723:[21080305-3723 Raw Data TraErlo.xlsx]3723 Raw Data TraErlo.txt'!$T$30:$AI$30</c:f>
                <c:numCache>
                  <c:formatCode>General</c:formatCode>
                  <c:ptCount val="16"/>
                  <c:pt idx="0">
                    <c:v>1.466383</c:v>
                  </c:pt>
                  <c:pt idx="1">
                    <c:v>1.1745050000000001</c:v>
                  </c:pt>
                  <c:pt idx="2">
                    <c:v>1.638703</c:v>
                  </c:pt>
                  <c:pt idx="3">
                    <c:v>1.7951229999999998</c:v>
                  </c:pt>
                  <c:pt idx="4">
                    <c:v>1.6700440000000001</c:v>
                  </c:pt>
                  <c:pt idx="5">
                    <c:v>1.9515400000000001</c:v>
                  </c:pt>
                  <c:pt idx="6">
                    <c:v>2.0738819999999998</c:v>
                  </c:pt>
                  <c:pt idx="7">
                    <c:v>1.9052750000000001</c:v>
                  </c:pt>
                  <c:pt idx="8">
                    <c:v>2.4657240000000002</c:v>
                  </c:pt>
                  <c:pt idx="9">
                    <c:v>2.4849920000000001</c:v>
                  </c:pt>
                  <c:pt idx="10">
                    <c:v>2.4834320000000001</c:v>
                  </c:pt>
                  <c:pt idx="11">
                    <c:v>3.1487610000000004</c:v>
                  </c:pt>
                  <c:pt idx="12">
                    <c:v>3.6123989999999977</c:v>
                  </c:pt>
                  <c:pt idx="13">
                    <c:v>3.5128659999999829</c:v>
                  </c:pt>
                  <c:pt idx="14">
                    <c:v>3.443425</c:v>
                  </c:pt>
                  <c:pt idx="15">
                    <c:v>3.984318</c:v>
                  </c:pt>
                </c:numCache>
              </c:numRef>
            </c:plus>
            <c:minus>
              <c:numRef>
                <c:f>'Macintosh HD:Users:ovcarelab:Desktop:Josh Master''s Files:Erlotinib-Sel-Project:MTS and CV:Incucyte Raw Data:3723:[21080305-3723 Raw Data TraErlo.xlsx]3723 Raw Data TraErlo.txt'!$T$30:$AI$30</c:f>
                <c:numCache>
                  <c:formatCode>General</c:formatCode>
                  <c:ptCount val="16"/>
                  <c:pt idx="0">
                    <c:v>1.466383</c:v>
                  </c:pt>
                  <c:pt idx="1">
                    <c:v>1.1745050000000001</c:v>
                  </c:pt>
                  <c:pt idx="2">
                    <c:v>1.638703</c:v>
                  </c:pt>
                  <c:pt idx="3">
                    <c:v>1.7951229999999998</c:v>
                  </c:pt>
                  <c:pt idx="4">
                    <c:v>1.6700440000000001</c:v>
                  </c:pt>
                  <c:pt idx="5">
                    <c:v>1.9515400000000001</c:v>
                  </c:pt>
                  <c:pt idx="6">
                    <c:v>2.0738819999999998</c:v>
                  </c:pt>
                  <c:pt idx="7">
                    <c:v>1.9052750000000001</c:v>
                  </c:pt>
                  <c:pt idx="8">
                    <c:v>2.4657240000000002</c:v>
                  </c:pt>
                  <c:pt idx="9">
                    <c:v>2.4849920000000001</c:v>
                  </c:pt>
                  <c:pt idx="10">
                    <c:v>2.4834320000000001</c:v>
                  </c:pt>
                  <c:pt idx="11">
                    <c:v>3.1487610000000004</c:v>
                  </c:pt>
                  <c:pt idx="12">
                    <c:v>3.6123989999999977</c:v>
                  </c:pt>
                  <c:pt idx="13">
                    <c:v>3.5128659999999829</c:v>
                  </c:pt>
                  <c:pt idx="14">
                    <c:v>3.443425</c:v>
                  </c:pt>
                  <c:pt idx="15">
                    <c:v>3.984318</c:v>
                  </c:pt>
                </c:numCache>
              </c:numRef>
            </c:minus>
          </c:errBars>
          <c:xVal>
            <c:numRef>
              <c:f>'Macintosh HD:Users:ovcarelab:Desktop:Josh Master''s Files:Erlotinib-Sel-Project:MTS and CV:Incucyte Raw Data:3723:[21080305-3723 Raw Data TraErlo.xlsx]3723 Raw Data TraErlo.txt'!$B$27:$Q$27</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3723:[21080305-3723 Raw Data TraErlo.xlsx]3723 Raw Data TraErlo.txt'!$B$30:$Q$30</c:f>
              <c:numCache>
                <c:formatCode>General</c:formatCode>
                <c:ptCount val="16"/>
                <c:pt idx="0">
                  <c:v>21.276800000000001</c:v>
                </c:pt>
                <c:pt idx="1">
                  <c:v>21.34469</c:v>
                </c:pt>
                <c:pt idx="2">
                  <c:v>22.5489</c:v>
                </c:pt>
                <c:pt idx="3">
                  <c:v>24.180199999999999</c:v>
                </c:pt>
                <c:pt idx="4">
                  <c:v>24.219919999999988</c:v>
                </c:pt>
                <c:pt idx="5">
                  <c:v>24.249079999999999</c:v>
                </c:pt>
                <c:pt idx="6">
                  <c:v>24.922969999999999</c:v>
                </c:pt>
                <c:pt idx="7">
                  <c:v>26.161810000000003</c:v>
                </c:pt>
                <c:pt idx="8">
                  <c:v>28.59965</c:v>
                </c:pt>
                <c:pt idx="9">
                  <c:v>28.500529999999998</c:v>
                </c:pt>
                <c:pt idx="10">
                  <c:v>29.539529999999999</c:v>
                </c:pt>
                <c:pt idx="11">
                  <c:v>34.589500000000001</c:v>
                </c:pt>
                <c:pt idx="12">
                  <c:v>35.27328</c:v>
                </c:pt>
                <c:pt idx="13">
                  <c:v>36.021430000000002</c:v>
                </c:pt>
                <c:pt idx="14">
                  <c:v>37.146420000000006</c:v>
                </c:pt>
                <c:pt idx="15">
                  <c:v>39.805210000000002</c:v>
                </c:pt>
              </c:numCache>
            </c:numRef>
          </c:yVal>
          <c:extLst xmlns:c16r2="http://schemas.microsoft.com/office/drawing/2015/06/chart">
            <c:ext xmlns:c16="http://schemas.microsoft.com/office/drawing/2014/chart" uri="{C3380CC4-5D6E-409C-BE32-E72D297353CC}">
              <c16:uniqueId val="{00000001-F108-D94C-B0DA-95BA7BD4D8C5}"/>
            </c:ext>
          </c:extLst>
        </c:ser>
        <c:ser>
          <c:idx val="3"/>
          <c:order val="2"/>
          <c:tx>
            <c:strRef>
              <c:f>'Macintosh HD:Users:ovcarelab:Desktop:Josh Master''s Files:Erlotinib-Sel-Project:MTS and CV:Incucyte Raw Data:3723:[21080305-3723 Raw Data TraErlo.xlsx]3723 Raw Data TraErlo.txt'!$A$31</c:f>
              <c:strCache>
                <c:ptCount val="1"/>
                <c:pt idx="0">
                  <c:v>Trametinib 100 nM</c:v>
                </c:pt>
              </c:strCache>
            </c:strRef>
          </c:tx>
          <c:spPr>
            <a:ln w="19050">
              <a:solidFill>
                <a:srgbClr val="C00000"/>
              </a:solidFill>
            </a:ln>
            <a:effectLst/>
          </c:spPr>
          <c:marker>
            <c:symbol val="square"/>
            <c:size val="5"/>
            <c:spPr>
              <a:solidFill>
                <a:srgbClr val="C00000"/>
              </a:solidFill>
              <a:ln>
                <a:solidFill>
                  <a:srgbClr val="C00000"/>
                </a:solidFill>
              </a:ln>
              <a:effectLst/>
            </c:spPr>
          </c:marker>
          <c:errBars>
            <c:errDir val="y"/>
            <c:errBarType val="both"/>
            <c:errValType val="cust"/>
            <c:plus>
              <c:numRef>
                <c:f>'Macintosh HD:Users:ovcarelab:Desktop:Josh Master''s Files:Erlotinib-Sel-Project:MTS and CV:Incucyte Raw Data:3723:[21080305-3723 Raw Data TraErlo.xlsx]3723 Raw Data TraErlo.txt'!$T$31:$AI$31</c:f>
                <c:numCache>
                  <c:formatCode>General</c:formatCode>
                  <c:ptCount val="16"/>
                  <c:pt idx="0">
                    <c:v>1.3872150000000001</c:v>
                  </c:pt>
                  <c:pt idx="1">
                    <c:v>1.2011759999999998</c:v>
                  </c:pt>
                  <c:pt idx="2">
                    <c:v>0.91940089999999997</c:v>
                  </c:pt>
                  <c:pt idx="3">
                    <c:v>1.2511029999999999</c:v>
                  </c:pt>
                  <c:pt idx="4">
                    <c:v>1.4231139999999998</c:v>
                  </c:pt>
                  <c:pt idx="5">
                    <c:v>1.167554</c:v>
                  </c:pt>
                  <c:pt idx="6">
                    <c:v>1.2596409999999998</c:v>
                  </c:pt>
                  <c:pt idx="7">
                    <c:v>1.5429089999999999</c:v>
                  </c:pt>
                  <c:pt idx="8">
                    <c:v>1.5326339999999998</c:v>
                  </c:pt>
                  <c:pt idx="9">
                    <c:v>1.6824250000000001</c:v>
                  </c:pt>
                  <c:pt idx="10">
                    <c:v>2.6073110000000006</c:v>
                  </c:pt>
                  <c:pt idx="11">
                    <c:v>3.6940140000000001</c:v>
                  </c:pt>
                  <c:pt idx="12">
                    <c:v>4.5713210000000011</c:v>
                  </c:pt>
                  <c:pt idx="13">
                    <c:v>5.4506360000000003</c:v>
                  </c:pt>
                  <c:pt idx="14">
                    <c:v>7.8137620000000005</c:v>
                  </c:pt>
                  <c:pt idx="15">
                    <c:v>6.4362350000000008</c:v>
                  </c:pt>
                </c:numCache>
              </c:numRef>
            </c:plus>
            <c:minus>
              <c:numRef>
                <c:f>'Macintosh HD:Users:ovcarelab:Desktop:Josh Master''s Files:Erlotinib-Sel-Project:MTS and CV:Incucyte Raw Data:3723:[21080305-3723 Raw Data TraErlo.xlsx]3723 Raw Data TraErlo.txt'!$T$31:$AI$31</c:f>
                <c:numCache>
                  <c:formatCode>General</c:formatCode>
                  <c:ptCount val="16"/>
                  <c:pt idx="0">
                    <c:v>1.3872150000000001</c:v>
                  </c:pt>
                  <c:pt idx="1">
                    <c:v>1.2011759999999998</c:v>
                  </c:pt>
                  <c:pt idx="2">
                    <c:v>0.91940089999999997</c:v>
                  </c:pt>
                  <c:pt idx="3">
                    <c:v>1.2511029999999999</c:v>
                  </c:pt>
                  <c:pt idx="4">
                    <c:v>1.4231139999999998</c:v>
                  </c:pt>
                  <c:pt idx="5">
                    <c:v>1.167554</c:v>
                  </c:pt>
                  <c:pt idx="6">
                    <c:v>1.2596409999999998</c:v>
                  </c:pt>
                  <c:pt idx="7">
                    <c:v>1.5429089999999999</c:v>
                  </c:pt>
                  <c:pt idx="8">
                    <c:v>1.5326339999999998</c:v>
                  </c:pt>
                  <c:pt idx="9">
                    <c:v>1.6824250000000001</c:v>
                  </c:pt>
                  <c:pt idx="10">
                    <c:v>2.6073110000000006</c:v>
                  </c:pt>
                  <c:pt idx="11">
                    <c:v>3.6940140000000001</c:v>
                  </c:pt>
                  <c:pt idx="12">
                    <c:v>4.5713210000000011</c:v>
                  </c:pt>
                  <c:pt idx="13">
                    <c:v>5.4506360000000003</c:v>
                  </c:pt>
                  <c:pt idx="14">
                    <c:v>7.8137620000000005</c:v>
                  </c:pt>
                  <c:pt idx="15">
                    <c:v>6.4362350000000008</c:v>
                  </c:pt>
                </c:numCache>
              </c:numRef>
            </c:minus>
          </c:errBars>
          <c:xVal>
            <c:numRef>
              <c:f>'Macintosh HD:Users:ovcarelab:Desktop:Josh Master''s Files:Erlotinib-Sel-Project:MTS and CV:Incucyte Raw Data:3723:[21080305-3723 Raw Data TraErlo.xlsx]3723 Raw Data TraErlo.txt'!$B$27:$Q$27</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3723:[21080305-3723 Raw Data TraErlo.xlsx]3723 Raw Data TraErlo.txt'!$B$31:$Q$31</c:f>
              <c:numCache>
                <c:formatCode>General</c:formatCode>
                <c:ptCount val="16"/>
                <c:pt idx="0">
                  <c:v>20.6082</c:v>
                </c:pt>
                <c:pt idx="1">
                  <c:v>21.39528</c:v>
                </c:pt>
                <c:pt idx="2">
                  <c:v>22.126880000000003</c:v>
                </c:pt>
                <c:pt idx="3">
                  <c:v>23.841100000000001</c:v>
                </c:pt>
                <c:pt idx="4">
                  <c:v>23.456489999999999</c:v>
                </c:pt>
                <c:pt idx="5">
                  <c:v>22.882139999999996</c:v>
                </c:pt>
                <c:pt idx="6">
                  <c:v>23.20102</c:v>
                </c:pt>
                <c:pt idx="7">
                  <c:v>23.431229999999999</c:v>
                </c:pt>
                <c:pt idx="8">
                  <c:v>24.234490000000001</c:v>
                </c:pt>
                <c:pt idx="9">
                  <c:v>23.769399999999997</c:v>
                </c:pt>
                <c:pt idx="10">
                  <c:v>24.13503</c:v>
                </c:pt>
                <c:pt idx="11">
                  <c:v>26.69266</c:v>
                </c:pt>
                <c:pt idx="12">
                  <c:v>28.216060000000002</c:v>
                </c:pt>
                <c:pt idx="13">
                  <c:v>28.439900000000012</c:v>
                </c:pt>
                <c:pt idx="14">
                  <c:v>31.832900000000002</c:v>
                </c:pt>
                <c:pt idx="15">
                  <c:v>33.052730000000004</c:v>
                </c:pt>
              </c:numCache>
            </c:numRef>
          </c:yVal>
          <c:extLst xmlns:c16r2="http://schemas.microsoft.com/office/drawing/2015/06/chart">
            <c:ext xmlns:c16="http://schemas.microsoft.com/office/drawing/2014/chart" uri="{C3380CC4-5D6E-409C-BE32-E72D297353CC}">
              <c16:uniqueId val="{00000002-F108-D94C-B0DA-95BA7BD4D8C5}"/>
            </c:ext>
          </c:extLst>
        </c:ser>
        <c:ser>
          <c:idx val="4"/>
          <c:order val="3"/>
          <c:tx>
            <c:strRef>
              <c:f>'Macintosh HD:Users:ovcarelab:Desktop:Josh Master''s Files:Erlotinib-Sel-Project:MTS and CV:Incucyte Raw Data:3723:[21080305-3723 Raw Data TraErlo.xlsx]3723 Raw Data TraErlo.txt'!$A$32</c:f>
              <c:strCache>
                <c:ptCount val="1"/>
                <c:pt idx="0">
                  <c:v>Trametinib 50 nM</c:v>
                </c:pt>
              </c:strCache>
            </c:strRef>
          </c:tx>
          <c:spPr>
            <a:ln w="19050">
              <a:solidFill>
                <a:srgbClr val="FF0000"/>
              </a:solidFill>
            </a:ln>
            <a:effectLst/>
          </c:spPr>
          <c:marker>
            <c:symbol val="square"/>
            <c:size val="5"/>
            <c:spPr>
              <a:solidFill>
                <a:srgbClr val="FF0000"/>
              </a:solidFill>
              <a:ln>
                <a:solidFill>
                  <a:srgbClr val="FF0000"/>
                </a:solidFill>
              </a:ln>
              <a:effectLst/>
            </c:spPr>
          </c:marker>
          <c:errBars>
            <c:errDir val="y"/>
            <c:errBarType val="both"/>
            <c:errValType val="cust"/>
            <c:plus>
              <c:numRef>
                <c:f>'Macintosh HD:Users:ovcarelab:Desktop:Josh Master''s Files:Erlotinib-Sel-Project:MTS and CV:Incucyte Raw Data:3723:[21080305-3723 Raw Data TraErlo.xlsx]3723 Raw Data TraErlo.txt'!$T$32:$AI$32</c:f>
                <c:numCache>
                  <c:formatCode>General</c:formatCode>
                  <c:ptCount val="16"/>
                  <c:pt idx="0">
                    <c:v>3.9210559999999997</c:v>
                  </c:pt>
                  <c:pt idx="1">
                    <c:v>3.6735250000000002</c:v>
                  </c:pt>
                  <c:pt idx="2">
                    <c:v>4.6755829999999881</c:v>
                  </c:pt>
                  <c:pt idx="3">
                    <c:v>4.9187990000000008</c:v>
                  </c:pt>
                  <c:pt idx="4">
                    <c:v>5.4348070000000002</c:v>
                  </c:pt>
                  <c:pt idx="5">
                    <c:v>5.3467660000000006</c:v>
                  </c:pt>
                  <c:pt idx="6">
                    <c:v>5.8363750000000003</c:v>
                  </c:pt>
                  <c:pt idx="7">
                    <c:v>5.5659549999999758</c:v>
                  </c:pt>
                  <c:pt idx="8">
                    <c:v>6.2118739999999999</c:v>
                  </c:pt>
                  <c:pt idx="9">
                    <c:v>5.7228179999999789</c:v>
                  </c:pt>
                  <c:pt idx="10">
                    <c:v>6.8887349999999881</c:v>
                  </c:pt>
                  <c:pt idx="11">
                    <c:v>7.6617809999999817</c:v>
                  </c:pt>
                  <c:pt idx="12">
                    <c:v>7.2484010000000003</c:v>
                  </c:pt>
                  <c:pt idx="13">
                    <c:v>7.2738880000000004</c:v>
                  </c:pt>
                  <c:pt idx="14">
                    <c:v>7.9732070000000013</c:v>
                  </c:pt>
                  <c:pt idx="15">
                    <c:v>8.8318509999999986</c:v>
                  </c:pt>
                </c:numCache>
              </c:numRef>
            </c:plus>
            <c:minus>
              <c:numRef>
                <c:f>'Macintosh HD:Users:ovcarelab:Desktop:Josh Master''s Files:Erlotinib-Sel-Project:MTS and CV:Incucyte Raw Data:3723:[21080305-3723 Raw Data TraErlo.xlsx]3723 Raw Data TraErlo.txt'!$T$32:$AI$32</c:f>
                <c:numCache>
                  <c:formatCode>General</c:formatCode>
                  <c:ptCount val="16"/>
                  <c:pt idx="0">
                    <c:v>3.9210559999999997</c:v>
                  </c:pt>
                  <c:pt idx="1">
                    <c:v>3.6735250000000002</c:v>
                  </c:pt>
                  <c:pt idx="2">
                    <c:v>4.6755829999999881</c:v>
                  </c:pt>
                  <c:pt idx="3">
                    <c:v>4.9187990000000008</c:v>
                  </c:pt>
                  <c:pt idx="4">
                    <c:v>5.4348070000000002</c:v>
                  </c:pt>
                  <c:pt idx="5">
                    <c:v>5.3467660000000006</c:v>
                  </c:pt>
                  <c:pt idx="6">
                    <c:v>5.8363750000000003</c:v>
                  </c:pt>
                  <c:pt idx="7">
                    <c:v>5.5659549999999758</c:v>
                  </c:pt>
                  <c:pt idx="8">
                    <c:v>6.2118739999999999</c:v>
                  </c:pt>
                  <c:pt idx="9">
                    <c:v>5.7228179999999789</c:v>
                  </c:pt>
                  <c:pt idx="10">
                    <c:v>6.8887349999999881</c:v>
                  </c:pt>
                  <c:pt idx="11">
                    <c:v>7.6617809999999817</c:v>
                  </c:pt>
                  <c:pt idx="12">
                    <c:v>7.2484010000000003</c:v>
                  </c:pt>
                  <c:pt idx="13">
                    <c:v>7.2738880000000004</c:v>
                  </c:pt>
                  <c:pt idx="14">
                    <c:v>7.9732070000000013</c:v>
                  </c:pt>
                  <c:pt idx="15">
                    <c:v>8.8318509999999986</c:v>
                  </c:pt>
                </c:numCache>
              </c:numRef>
            </c:minus>
          </c:errBars>
          <c:xVal>
            <c:numRef>
              <c:f>'Macintosh HD:Users:ovcarelab:Desktop:Josh Master''s Files:Erlotinib-Sel-Project:MTS and CV:Incucyte Raw Data:3723:[21080305-3723 Raw Data TraErlo.xlsx]3723 Raw Data TraErlo.txt'!$B$27:$Q$27</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3723:[21080305-3723 Raw Data TraErlo.xlsx]3723 Raw Data TraErlo.txt'!$B$32:$Q$32</c:f>
              <c:numCache>
                <c:formatCode>General</c:formatCode>
                <c:ptCount val="16"/>
                <c:pt idx="0">
                  <c:v>21.328250000000001</c:v>
                </c:pt>
                <c:pt idx="1">
                  <c:v>20.960459999999998</c:v>
                </c:pt>
                <c:pt idx="2">
                  <c:v>22.741019999999999</c:v>
                </c:pt>
                <c:pt idx="3">
                  <c:v>23.373160000000002</c:v>
                </c:pt>
                <c:pt idx="4">
                  <c:v>23.931789999999999</c:v>
                </c:pt>
                <c:pt idx="5">
                  <c:v>23.191660000000002</c:v>
                </c:pt>
                <c:pt idx="6">
                  <c:v>23.807639999999999</c:v>
                </c:pt>
                <c:pt idx="7">
                  <c:v>23.934639999999998</c:v>
                </c:pt>
                <c:pt idx="8">
                  <c:v>24.423009999999998</c:v>
                </c:pt>
                <c:pt idx="9">
                  <c:v>23.557950000000016</c:v>
                </c:pt>
                <c:pt idx="10">
                  <c:v>23.669779999999999</c:v>
                </c:pt>
                <c:pt idx="11">
                  <c:v>26.086329999999997</c:v>
                </c:pt>
                <c:pt idx="12">
                  <c:v>25.694870000000016</c:v>
                </c:pt>
                <c:pt idx="13">
                  <c:v>25.299529999999997</c:v>
                </c:pt>
                <c:pt idx="14">
                  <c:v>25.485289999999882</c:v>
                </c:pt>
                <c:pt idx="15">
                  <c:v>26.47035</c:v>
                </c:pt>
              </c:numCache>
            </c:numRef>
          </c:yVal>
          <c:extLst xmlns:c16r2="http://schemas.microsoft.com/office/drawing/2015/06/chart">
            <c:ext xmlns:c16="http://schemas.microsoft.com/office/drawing/2014/chart" uri="{C3380CC4-5D6E-409C-BE32-E72D297353CC}">
              <c16:uniqueId val="{00000003-F108-D94C-B0DA-95BA7BD4D8C5}"/>
            </c:ext>
          </c:extLst>
        </c:ser>
        <c:ser>
          <c:idx val="12"/>
          <c:order val="4"/>
          <c:tx>
            <c:v>Erl 2.5µM + Tra 50nM</c:v>
          </c:tx>
          <c:spPr>
            <a:ln w="19050">
              <a:solidFill>
                <a:srgbClr val="7030A0"/>
              </a:solidFill>
            </a:ln>
            <a:effectLst/>
          </c:spPr>
          <c:marker>
            <c:symbol val="plus"/>
            <c:size val="5"/>
            <c:spPr>
              <a:noFill/>
              <a:ln>
                <a:solidFill>
                  <a:srgbClr val="7030A0"/>
                </a:solidFill>
              </a:ln>
              <a:effectLst/>
            </c:spPr>
          </c:marker>
          <c:errBars>
            <c:errDir val="y"/>
            <c:errBarType val="both"/>
            <c:errValType val="cust"/>
            <c:plus>
              <c:numRef>
                <c:f>'Macintosh HD:Users:ovcarelab:Desktop:Josh Master''s Files:Erlotinib-Sel-Project:MTS and CV:Incucyte Raw Data:3723:[21080305-3723 Raw Data TraErlo.xlsx]3723 Raw Data TraErlo.txt'!$T$40:$AI$40</c:f>
                <c:numCache>
                  <c:formatCode>General</c:formatCode>
                  <c:ptCount val="16"/>
                  <c:pt idx="0">
                    <c:v>2.1700599999999985</c:v>
                  </c:pt>
                  <c:pt idx="1">
                    <c:v>2.229476</c:v>
                  </c:pt>
                  <c:pt idx="2">
                    <c:v>2.031842999999983</c:v>
                  </c:pt>
                  <c:pt idx="3">
                    <c:v>2.1486179999999999</c:v>
                  </c:pt>
                  <c:pt idx="4">
                    <c:v>2.1135390000000003</c:v>
                  </c:pt>
                  <c:pt idx="5">
                    <c:v>2.3446959999999986</c:v>
                  </c:pt>
                  <c:pt idx="6">
                    <c:v>2.4455589999999976</c:v>
                  </c:pt>
                  <c:pt idx="7">
                    <c:v>2.246165</c:v>
                  </c:pt>
                  <c:pt idx="8">
                    <c:v>2.5637090000000002</c:v>
                  </c:pt>
                  <c:pt idx="9">
                    <c:v>3.1168979999999986</c:v>
                  </c:pt>
                  <c:pt idx="10">
                    <c:v>3.6625710000000002</c:v>
                  </c:pt>
                  <c:pt idx="11">
                    <c:v>5.3082120000000002</c:v>
                  </c:pt>
                  <c:pt idx="12">
                    <c:v>6.2383950000000006</c:v>
                  </c:pt>
                  <c:pt idx="13">
                    <c:v>6.7150660000000002</c:v>
                  </c:pt>
                  <c:pt idx="14">
                    <c:v>7.3442849999999789</c:v>
                  </c:pt>
                  <c:pt idx="15">
                    <c:v>8.2210509999999974</c:v>
                  </c:pt>
                </c:numCache>
              </c:numRef>
            </c:plus>
            <c:minus>
              <c:numRef>
                <c:f>'Macintosh HD:Users:ovcarelab:Desktop:Josh Master''s Files:Erlotinib-Sel-Project:MTS and CV:Incucyte Raw Data:3723:[21080305-3723 Raw Data TraErlo.xlsx]3723 Raw Data TraErlo.txt'!$T$40:$AI$40</c:f>
                <c:numCache>
                  <c:formatCode>General</c:formatCode>
                  <c:ptCount val="16"/>
                  <c:pt idx="0">
                    <c:v>2.1700599999999985</c:v>
                  </c:pt>
                  <c:pt idx="1">
                    <c:v>2.229476</c:v>
                  </c:pt>
                  <c:pt idx="2">
                    <c:v>2.031842999999983</c:v>
                  </c:pt>
                  <c:pt idx="3">
                    <c:v>2.1486179999999999</c:v>
                  </c:pt>
                  <c:pt idx="4">
                    <c:v>2.1135390000000003</c:v>
                  </c:pt>
                  <c:pt idx="5">
                    <c:v>2.3446959999999986</c:v>
                  </c:pt>
                  <c:pt idx="6">
                    <c:v>2.4455589999999976</c:v>
                  </c:pt>
                  <c:pt idx="7">
                    <c:v>2.246165</c:v>
                  </c:pt>
                  <c:pt idx="8">
                    <c:v>2.5637090000000002</c:v>
                  </c:pt>
                  <c:pt idx="9">
                    <c:v>3.1168979999999986</c:v>
                  </c:pt>
                  <c:pt idx="10">
                    <c:v>3.6625710000000002</c:v>
                  </c:pt>
                  <c:pt idx="11">
                    <c:v>5.3082120000000002</c:v>
                  </c:pt>
                  <c:pt idx="12">
                    <c:v>6.2383950000000006</c:v>
                  </c:pt>
                  <c:pt idx="13">
                    <c:v>6.7150660000000002</c:v>
                  </c:pt>
                  <c:pt idx="14">
                    <c:v>7.3442849999999789</c:v>
                  </c:pt>
                  <c:pt idx="15">
                    <c:v>8.2210509999999974</c:v>
                  </c:pt>
                </c:numCache>
              </c:numRef>
            </c:minus>
          </c:errBars>
          <c:xVal>
            <c:numRef>
              <c:f>'Macintosh HD:Users:ovcarelab:Desktop:Josh Master''s Files:Erlotinib-Sel-Project:MTS and CV:Incucyte Raw Data:3723:[21080305-3723 Raw Data TraErlo.xlsx]3723 Raw Data TraErlo.txt'!$B$27:$Q$27</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3723:[21080305-3723 Raw Data TraErlo.xlsx]3723 Raw Data TraErlo.txt'!$B$40:$Q$40</c:f>
              <c:numCache>
                <c:formatCode>General</c:formatCode>
                <c:ptCount val="16"/>
                <c:pt idx="0">
                  <c:v>21.086029999999997</c:v>
                </c:pt>
                <c:pt idx="1">
                  <c:v>21.115250000000003</c:v>
                </c:pt>
                <c:pt idx="2">
                  <c:v>20.821269999999988</c:v>
                </c:pt>
                <c:pt idx="3">
                  <c:v>21.581689999999977</c:v>
                </c:pt>
                <c:pt idx="4">
                  <c:v>20.849830000000001</c:v>
                </c:pt>
                <c:pt idx="5">
                  <c:v>20.424129999999998</c:v>
                </c:pt>
                <c:pt idx="6">
                  <c:v>20.875779999999999</c:v>
                </c:pt>
                <c:pt idx="7">
                  <c:v>21.065419999999996</c:v>
                </c:pt>
                <c:pt idx="8">
                  <c:v>22.403589999999998</c:v>
                </c:pt>
                <c:pt idx="9">
                  <c:v>22.231179999999988</c:v>
                </c:pt>
                <c:pt idx="10">
                  <c:v>23.119710000000001</c:v>
                </c:pt>
                <c:pt idx="11">
                  <c:v>26.999419999999997</c:v>
                </c:pt>
                <c:pt idx="12">
                  <c:v>28.30322</c:v>
                </c:pt>
                <c:pt idx="13">
                  <c:v>28.459739999999996</c:v>
                </c:pt>
                <c:pt idx="14">
                  <c:v>28.663139999999977</c:v>
                </c:pt>
                <c:pt idx="15">
                  <c:v>30.246479999999977</c:v>
                </c:pt>
              </c:numCache>
            </c:numRef>
          </c:yVal>
          <c:extLst xmlns:c16r2="http://schemas.microsoft.com/office/drawing/2015/06/chart">
            <c:ext xmlns:c16="http://schemas.microsoft.com/office/drawing/2014/chart" uri="{C3380CC4-5D6E-409C-BE32-E72D297353CC}">
              <c16:uniqueId val="{00000004-F108-D94C-B0DA-95BA7BD4D8C5}"/>
            </c:ext>
          </c:extLst>
        </c:ser>
        <c:dLbls/>
        <c:axId val="112947200"/>
        <c:axId val="112948736"/>
      </c:scatterChart>
      <c:valAx>
        <c:axId val="112947200"/>
        <c:scaling>
          <c:orientation val="minMax"/>
          <c:max val="90"/>
        </c:scaling>
        <c:axPos val="b"/>
        <c:numFmt formatCode="General" sourceLinked="1"/>
        <c:tickLblPos val="nextTo"/>
        <c:crossAx val="112948736"/>
        <c:crosses val="autoZero"/>
        <c:crossBetween val="midCat"/>
        <c:majorUnit val="15"/>
      </c:valAx>
      <c:valAx>
        <c:axId val="112948736"/>
        <c:scaling>
          <c:orientation val="minMax"/>
          <c:max val="100"/>
        </c:scaling>
        <c:axPos val="l"/>
        <c:majorGridlines/>
        <c:title>
          <c:tx>
            <c:rich>
              <a:bodyPr rot="-5400000" vert="horz"/>
              <a:lstStyle/>
              <a:p>
                <a:pPr>
                  <a:defRPr/>
                </a:pPr>
                <a:r>
                  <a:rPr lang="en-US" dirty="0"/>
                  <a:t>% Confluence</a:t>
                </a:r>
              </a:p>
            </c:rich>
          </c:tx>
          <c:layout>
            <c:manualLayout>
              <c:xMode val="edge"/>
              <c:yMode val="edge"/>
              <c:x val="1.4514197017275101E-2"/>
              <c:y val="0.25944006221530902"/>
            </c:manualLayout>
          </c:layout>
        </c:title>
        <c:numFmt formatCode="General" sourceLinked="1"/>
        <c:tickLblPos val="nextTo"/>
        <c:crossAx val="112947200"/>
        <c:crosses val="autoZero"/>
        <c:crossBetween val="midCat"/>
        <c:majorUnit val="10"/>
      </c:valAx>
    </c:plotArea>
    <c:plotVisOnly val="1"/>
    <c:dispBlanksAs val="gap"/>
  </c:chart>
  <c:txPr>
    <a:bodyPr/>
    <a:lstStyle/>
    <a:p>
      <a:pPr>
        <a:defRPr sz="800"/>
      </a:pPr>
      <a:endParaRPr lang="en-US"/>
    </a:p>
  </c:txPr>
  <c:externalData r:id="rId1"/>
</c:chartSpace>
</file>

<file path=ppt/charts/chart8.xml><?xml version="1.0" encoding="utf-8"?>
<c:chartSpace xmlns:c="http://schemas.openxmlformats.org/drawingml/2006/chart" xmlns:a="http://schemas.openxmlformats.org/drawingml/2006/main" xmlns:r="http://schemas.openxmlformats.org/officeDocument/2006/relationships">
  <c:lang val="en-IN"/>
  <c:style val="18"/>
  <c:chart>
    <c:autoTitleDeleted val="1"/>
    <c:plotArea>
      <c:layout>
        <c:manualLayout>
          <c:layoutTarget val="inner"/>
          <c:xMode val="edge"/>
          <c:yMode val="edge"/>
          <c:x val="0.11679403495517703"/>
          <c:y val="0.17125952799985597"/>
          <c:w val="0.72309768659036011"/>
          <c:h val="0.59881909864670901"/>
        </c:manualLayout>
      </c:layout>
      <c:scatterChart>
        <c:scatterStyle val="lineMarker"/>
        <c:ser>
          <c:idx val="0"/>
          <c:order val="0"/>
          <c:tx>
            <c:v>DMSO</c:v>
          </c:tx>
          <c:spPr>
            <a:ln w="19050">
              <a:solidFill>
                <a:schemeClr val="tx1"/>
              </a:solidFill>
            </a:ln>
            <a:effectLst/>
          </c:spPr>
          <c:marker>
            <c:symbol val="diamond"/>
            <c:size val="5"/>
            <c:spPr>
              <a:solidFill>
                <a:schemeClr val="tx1"/>
              </a:solidFill>
              <a:ln>
                <a:solidFill>
                  <a:schemeClr val="tx1"/>
                </a:solidFill>
              </a:ln>
              <a:effectLst/>
            </c:spPr>
          </c:marker>
          <c:errBars>
            <c:errDir val="y"/>
            <c:errBarType val="both"/>
            <c:errValType val="cust"/>
            <c:plus>
              <c:numRef>
                <c:f>'Macintosh HD:Users:ovcarelab:Desktop:Josh Master''s Files:Erlotinib-Sel-Project:MTS and CV:Incucyte Raw Data:20171017-6406-TraErlo:[17Oct17-6406-TraErlo-6500cw-Growth Curves.xlsx]17Oct17-6406-TraErlo-6500cw.txt'!$B$47:$Q$47</c:f>
                <c:numCache>
                  <c:formatCode>General</c:formatCode>
                  <c:ptCount val="16"/>
                  <c:pt idx="0">
                    <c:v>2.4670100000000001</c:v>
                  </c:pt>
                  <c:pt idx="1">
                    <c:v>2.6412659999999977</c:v>
                  </c:pt>
                  <c:pt idx="2">
                    <c:v>3.8196769999999916</c:v>
                  </c:pt>
                  <c:pt idx="3">
                    <c:v>4.263988999999988</c:v>
                  </c:pt>
                  <c:pt idx="4">
                    <c:v>4.7416980000000013</c:v>
                  </c:pt>
                  <c:pt idx="5">
                    <c:v>5.4627509999999946</c:v>
                  </c:pt>
                  <c:pt idx="6">
                    <c:v>6.9994830000000006</c:v>
                  </c:pt>
                  <c:pt idx="7">
                    <c:v>7.4170129999999945</c:v>
                  </c:pt>
                  <c:pt idx="8">
                    <c:v>6.8306820000000004</c:v>
                  </c:pt>
                  <c:pt idx="9">
                    <c:v>8.6992189999999994</c:v>
                  </c:pt>
                  <c:pt idx="10">
                    <c:v>9.9898510000000016</c:v>
                  </c:pt>
                  <c:pt idx="11">
                    <c:v>9.6858060000000012</c:v>
                  </c:pt>
                  <c:pt idx="12">
                    <c:v>10.09843</c:v>
                  </c:pt>
                  <c:pt idx="13">
                    <c:v>12.05062</c:v>
                  </c:pt>
                  <c:pt idx="14">
                    <c:v>9.5295380000000005</c:v>
                  </c:pt>
                  <c:pt idx="15">
                    <c:v>7.8899400000000002</c:v>
                  </c:pt>
                </c:numCache>
              </c:numRef>
            </c:plus>
            <c:minus>
              <c:numRef>
                <c:f>'Macintosh HD:Users:ovcarelab:Desktop:Josh Master''s Files:Erlotinib-Sel-Project:MTS and CV:Incucyte Raw Data:20171017-6406-TraErlo:[17Oct17-6406-TraErlo-6500cw-Growth Curves.xlsx]17Oct17-6406-TraErlo-6500cw.txt'!$B$47:$Q$47</c:f>
                <c:numCache>
                  <c:formatCode>General</c:formatCode>
                  <c:ptCount val="16"/>
                  <c:pt idx="0">
                    <c:v>2.4670100000000001</c:v>
                  </c:pt>
                  <c:pt idx="1">
                    <c:v>2.6412659999999977</c:v>
                  </c:pt>
                  <c:pt idx="2">
                    <c:v>3.8196769999999916</c:v>
                  </c:pt>
                  <c:pt idx="3">
                    <c:v>4.263988999999988</c:v>
                  </c:pt>
                  <c:pt idx="4">
                    <c:v>4.7416980000000013</c:v>
                  </c:pt>
                  <c:pt idx="5">
                    <c:v>5.4627509999999946</c:v>
                  </c:pt>
                  <c:pt idx="6">
                    <c:v>6.9994830000000006</c:v>
                  </c:pt>
                  <c:pt idx="7">
                    <c:v>7.4170129999999945</c:v>
                  </c:pt>
                  <c:pt idx="8">
                    <c:v>6.8306820000000004</c:v>
                  </c:pt>
                  <c:pt idx="9">
                    <c:v>8.6992189999999994</c:v>
                  </c:pt>
                  <c:pt idx="10">
                    <c:v>9.9898510000000016</c:v>
                  </c:pt>
                  <c:pt idx="11">
                    <c:v>9.6858060000000012</c:v>
                  </c:pt>
                  <c:pt idx="12">
                    <c:v>10.09843</c:v>
                  </c:pt>
                  <c:pt idx="13">
                    <c:v>12.05062</c:v>
                  </c:pt>
                  <c:pt idx="14">
                    <c:v>9.5295380000000005</c:v>
                  </c:pt>
                  <c:pt idx="15">
                    <c:v>7.8899400000000002</c:v>
                  </c:pt>
                </c:numCache>
              </c:numRef>
            </c:minus>
          </c:errBars>
          <c:errBars>
            <c:errDir val="x"/>
            <c:errBarType val="both"/>
            <c:errValType val="fixedVal"/>
            <c:val val="1"/>
          </c:errBars>
          <c:xVal>
            <c:numRef>
              <c:f>'Macintosh HD:Users:ovcarelab:Desktop:Josh Master''s Files:Erlotinib-Sel-Project:MTS and CV:Incucyte Raw Data:20171017-6406-TraErlo:[17Oct17-6406-TraErlo-6500cw-Growth Curves.xlsx]17Oct17-6406-TraErlo-6500cw.txt'!$B$28:$Q$28</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20171017-6406-TraErlo:[17Oct17-6406-TraErlo-6500cw-Growth Curves.xlsx]17Oct17-6406-TraErlo-6500cw.txt'!$B$29:$Q$29</c:f>
              <c:numCache>
                <c:formatCode>General</c:formatCode>
                <c:ptCount val="16"/>
                <c:pt idx="0">
                  <c:v>19.117400000000004</c:v>
                </c:pt>
                <c:pt idx="1">
                  <c:v>20.634260000000005</c:v>
                </c:pt>
                <c:pt idx="2">
                  <c:v>23.921619999999997</c:v>
                </c:pt>
                <c:pt idx="3">
                  <c:v>27.551580000000001</c:v>
                </c:pt>
                <c:pt idx="4">
                  <c:v>31.020569999999999</c:v>
                </c:pt>
                <c:pt idx="5">
                  <c:v>32.94961</c:v>
                </c:pt>
                <c:pt idx="6">
                  <c:v>37.428490000000004</c:v>
                </c:pt>
                <c:pt idx="7">
                  <c:v>42.446429999999999</c:v>
                </c:pt>
                <c:pt idx="8">
                  <c:v>46.91695</c:v>
                </c:pt>
                <c:pt idx="9">
                  <c:v>52.735550000000011</c:v>
                </c:pt>
                <c:pt idx="10">
                  <c:v>59.741810000000001</c:v>
                </c:pt>
                <c:pt idx="11">
                  <c:v>67.069769999999991</c:v>
                </c:pt>
                <c:pt idx="12">
                  <c:v>75.397320000000008</c:v>
                </c:pt>
                <c:pt idx="13">
                  <c:v>82.279560000000004</c:v>
                </c:pt>
                <c:pt idx="14">
                  <c:v>87.82483999999998</c:v>
                </c:pt>
                <c:pt idx="15">
                  <c:v>92.008359999999982</c:v>
                </c:pt>
              </c:numCache>
            </c:numRef>
          </c:yVal>
          <c:extLst xmlns:c16r2="http://schemas.microsoft.com/office/drawing/2015/06/chart">
            <c:ext xmlns:c16="http://schemas.microsoft.com/office/drawing/2014/chart" uri="{C3380CC4-5D6E-409C-BE32-E72D297353CC}">
              <c16:uniqueId val="{00000000-146C-8E4A-9AAD-AA4254134C9B}"/>
            </c:ext>
          </c:extLst>
        </c:ser>
        <c:ser>
          <c:idx val="2"/>
          <c:order val="1"/>
          <c:tx>
            <c:strRef>
              <c:f>'Macintosh HD:Users:ovcarelab:Desktop:Josh Master''s Files:Erlotinib-Sel-Project:MTS and CV:Incucyte Raw Data:20171017-6406-TraErlo:[17Oct17-6406-TraErlo-6500cw-Growth Curves.xlsx]17Oct17-6406-TraErlo-6500cw.txt'!$A$31</c:f>
              <c:strCache>
                <c:ptCount val="1"/>
                <c:pt idx="0">
                  <c:v>Erlotinib 2.5µM</c:v>
                </c:pt>
              </c:strCache>
            </c:strRef>
          </c:tx>
          <c:spPr>
            <a:ln w="19050">
              <a:solidFill>
                <a:schemeClr val="bg1">
                  <a:lumMod val="50000"/>
                </a:schemeClr>
              </a:solidFill>
            </a:ln>
            <a:effectLst/>
          </c:spPr>
          <c:marker>
            <c:symbol val="x"/>
            <c:size val="5"/>
            <c:spPr>
              <a:noFill/>
              <a:ln>
                <a:solidFill>
                  <a:schemeClr val="bg1">
                    <a:lumMod val="50000"/>
                  </a:schemeClr>
                </a:solidFill>
              </a:ln>
              <a:effectLst/>
            </c:spPr>
          </c:marker>
          <c:errBars>
            <c:errDir val="y"/>
            <c:errBarType val="both"/>
            <c:errValType val="cust"/>
            <c:plus>
              <c:numRef>
                <c:f>'Macintosh HD:Users:ovcarelab:Desktop:Josh Master''s Files:Erlotinib-Sel-Project:MTS and CV:Incucyte Raw Data:20171017-6406-TraErlo:[17Oct17-6406-TraErlo-6500cw-Growth Curves.xlsx]17Oct17-6406-TraErlo-6500cw.txt'!$B$49:$Q$49</c:f>
                <c:numCache>
                  <c:formatCode>General</c:formatCode>
                  <c:ptCount val="16"/>
                  <c:pt idx="0">
                    <c:v>4.6640479999999789</c:v>
                  </c:pt>
                  <c:pt idx="1">
                    <c:v>3.9684079999999997</c:v>
                  </c:pt>
                  <c:pt idx="2">
                    <c:v>3.9721179999999996</c:v>
                  </c:pt>
                  <c:pt idx="3">
                    <c:v>4.9770810000000001</c:v>
                  </c:pt>
                  <c:pt idx="4">
                    <c:v>5.4633430000000009</c:v>
                  </c:pt>
                  <c:pt idx="5">
                    <c:v>5.9119680000000008</c:v>
                  </c:pt>
                  <c:pt idx="6">
                    <c:v>6.3206639999999998</c:v>
                  </c:pt>
                  <c:pt idx="7">
                    <c:v>7.1049529999999788</c:v>
                  </c:pt>
                  <c:pt idx="8">
                    <c:v>8.5386199999999981</c:v>
                  </c:pt>
                  <c:pt idx="9">
                    <c:v>9.0338390000000004</c:v>
                  </c:pt>
                  <c:pt idx="10">
                    <c:v>10.240029999999999</c:v>
                  </c:pt>
                  <c:pt idx="11">
                    <c:v>11.149299999999998</c:v>
                  </c:pt>
                  <c:pt idx="12">
                    <c:v>10.538929999999999</c:v>
                  </c:pt>
                  <c:pt idx="13">
                    <c:v>12.598179999999999</c:v>
                  </c:pt>
                  <c:pt idx="14">
                    <c:v>12.88015</c:v>
                  </c:pt>
                  <c:pt idx="15">
                    <c:v>14.330919999999999</c:v>
                  </c:pt>
                </c:numCache>
              </c:numRef>
            </c:plus>
            <c:minus>
              <c:numRef>
                <c:f>'Macintosh HD:Users:ovcarelab:Desktop:Josh Master''s Files:Erlotinib-Sel-Project:MTS and CV:Incucyte Raw Data:20171017-6406-TraErlo:[17Oct17-6406-TraErlo-6500cw-Growth Curves.xlsx]17Oct17-6406-TraErlo-6500cw.txt'!$B$49:$Q$49</c:f>
                <c:numCache>
                  <c:formatCode>General</c:formatCode>
                  <c:ptCount val="16"/>
                  <c:pt idx="0">
                    <c:v>4.6640479999999789</c:v>
                  </c:pt>
                  <c:pt idx="1">
                    <c:v>3.9684079999999997</c:v>
                  </c:pt>
                  <c:pt idx="2">
                    <c:v>3.9721179999999996</c:v>
                  </c:pt>
                  <c:pt idx="3">
                    <c:v>4.9770810000000001</c:v>
                  </c:pt>
                  <c:pt idx="4">
                    <c:v>5.4633430000000009</c:v>
                  </c:pt>
                  <c:pt idx="5">
                    <c:v>5.9119680000000008</c:v>
                  </c:pt>
                  <c:pt idx="6">
                    <c:v>6.3206639999999998</c:v>
                  </c:pt>
                  <c:pt idx="7">
                    <c:v>7.1049529999999788</c:v>
                  </c:pt>
                  <c:pt idx="8">
                    <c:v>8.5386199999999981</c:v>
                  </c:pt>
                  <c:pt idx="9">
                    <c:v>9.0338390000000004</c:v>
                  </c:pt>
                  <c:pt idx="10">
                    <c:v>10.240029999999999</c:v>
                  </c:pt>
                  <c:pt idx="11">
                    <c:v>11.149299999999998</c:v>
                  </c:pt>
                  <c:pt idx="12">
                    <c:v>10.538929999999999</c:v>
                  </c:pt>
                  <c:pt idx="13">
                    <c:v>12.598179999999999</c:v>
                  </c:pt>
                  <c:pt idx="14">
                    <c:v>12.88015</c:v>
                  </c:pt>
                  <c:pt idx="15">
                    <c:v>14.330919999999999</c:v>
                  </c:pt>
                </c:numCache>
              </c:numRef>
            </c:minus>
          </c:errBars>
          <c:errBars>
            <c:errDir val="x"/>
            <c:errBarType val="both"/>
            <c:errValType val="fixedVal"/>
            <c:val val="1"/>
          </c:errBars>
          <c:xVal>
            <c:numRef>
              <c:f>'Macintosh HD:Users:ovcarelab:Desktop:Josh Master''s Files:Erlotinib-Sel-Project:MTS and CV:Incucyte Raw Data:20171017-6406-TraErlo:[17Oct17-6406-TraErlo-6500cw-Growth Curves.xlsx]17Oct17-6406-TraErlo-6500cw.txt'!$B$28:$Q$28</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20171017-6406-TraErlo:[17Oct17-6406-TraErlo-6500cw-Growth Curves.xlsx]17Oct17-6406-TraErlo-6500cw.txt'!$B$31:$Q$31</c:f>
              <c:numCache>
                <c:formatCode>General</c:formatCode>
                <c:ptCount val="16"/>
                <c:pt idx="0">
                  <c:v>18.844950000000004</c:v>
                </c:pt>
                <c:pt idx="1">
                  <c:v>20.743729999999882</c:v>
                </c:pt>
                <c:pt idx="2">
                  <c:v>22.679990000000004</c:v>
                </c:pt>
                <c:pt idx="3">
                  <c:v>25.338480000000001</c:v>
                </c:pt>
                <c:pt idx="4">
                  <c:v>26.890950000000004</c:v>
                </c:pt>
                <c:pt idx="5">
                  <c:v>28.75065</c:v>
                </c:pt>
                <c:pt idx="6">
                  <c:v>31.493970000000001</c:v>
                </c:pt>
                <c:pt idx="7">
                  <c:v>34.373310000000004</c:v>
                </c:pt>
                <c:pt idx="8">
                  <c:v>38.339039999999997</c:v>
                </c:pt>
                <c:pt idx="9">
                  <c:v>42.951729999999998</c:v>
                </c:pt>
                <c:pt idx="10">
                  <c:v>46.879039999999996</c:v>
                </c:pt>
                <c:pt idx="11">
                  <c:v>51.745010000000008</c:v>
                </c:pt>
                <c:pt idx="12">
                  <c:v>59.695080000000011</c:v>
                </c:pt>
                <c:pt idx="13">
                  <c:v>65.282469999999975</c:v>
                </c:pt>
                <c:pt idx="14">
                  <c:v>71.167779999999979</c:v>
                </c:pt>
                <c:pt idx="15">
                  <c:v>75.643170000000012</c:v>
                </c:pt>
              </c:numCache>
            </c:numRef>
          </c:yVal>
          <c:extLst xmlns:c16r2="http://schemas.microsoft.com/office/drawing/2015/06/chart">
            <c:ext xmlns:c16="http://schemas.microsoft.com/office/drawing/2014/chart" uri="{C3380CC4-5D6E-409C-BE32-E72D297353CC}">
              <c16:uniqueId val="{00000001-146C-8E4A-9AAD-AA4254134C9B}"/>
            </c:ext>
          </c:extLst>
        </c:ser>
        <c:ser>
          <c:idx val="3"/>
          <c:order val="2"/>
          <c:tx>
            <c:strRef>
              <c:f>'Macintosh HD:Users:ovcarelab:Desktop:Josh Master''s Files:Erlotinib-Sel-Project:MTS and CV:Incucyte Raw Data:20171017-6406-TraErlo:[17Oct17-6406-TraErlo-6500cw-Growth Curves.xlsx]17Oct17-6406-TraErlo-6500cw.txt'!$A$32</c:f>
              <c:strCache>
                <c:ptCount val="1"/>
                <c:pt idx="0">
                  <c:v>Trametinib 100 nM</c:v>
                </c:pt>
              </c:strCache>
            </c:strRef>
          </c:tx>
          <c:spPr>
            <a:ln w="19050">
              <a:solidFill>
                <a:srgbClr val="C00000"/>
              </a:solidFill>
            </a:ln>
            <a:effectLst/>
          </c:spPr>
          <c:marker>
            <c:symbol val="square"/>
            <c:size val="5"/>
            <c:spPr>
              <a:solidFill>
                <a:srgbClr val="C00000"/>
              </a:solidFill>
              <a:ln>
                <a:solidFill>
                  <a:srgbClr val="C00000"/>
                </a:solidFill>
              </a:ln>
              <a:effectLst/>
            </c:spPr>
          </c:marker>
          <c:errBars>
            <c:errDir val="y"/>
            <c:errBarType val="both"/>
            <c:errValType val="cust"/>
            <c:plus>
              <c:numRef>
                <c:f>'Macintosh HD:Users:ovcarelab:Desktop:Josh Master''s Files:Erlotinib-Sel-Project:MTS and CV:Incucyte Raw Data:20171017-6406-TraErlo:[17Oct17-6406-TraErlo-6500cw-Growth Curves.xlsx]17Oct17-6406-TraErlo-6500cw.txt'!$B$50:$Q$50</c:f>
                <c:numCache>
                  <c:formatCode>General</c:formatCode>
                  <c:ptCount val="16"/>
                  <c:pt idx="0">
                    <c:v>3.7959849999999999</c:v>
                  </c:pt>
                  <c:pt idx="1">
                    <c:v>3.5392929999999976</c:v>
                  </c:pt>
                  <c:pt idx="2">
                    <c:v>4.298216</c:v>
                  </c:pt>
                  <c:pt idx="3">
                    <c:v>3.9001710000000003</c:v>
                  </c:pt>
                  <c:pt idx="4">
                    <c:v>3.7601540000000004</c:v>
                  </c:pt>
                  <c:pt idx="5">
                    <c:v>4.0840499999999986</c:v>
                  </c:pt>
                  <c:pt idx="6">
                    <c:v>3.8796519999999957</c:v>
                  </c:pt>
                  <c:pt idx="7">
                    <c:v>4.7475069999999882</c:v>
                  </c:pt>
                  <c:pt idx="8">
                    <c:v>4.9892500000000011</c:v>
                  </c:pt>
                  <c:pt idx="9">
                    <c:v>4.749753000000001</c:v>
                  </c:pt>
                  <c:pt idx="10">
                    <c:v>4.8786849999999946</c:v>
                  </c:pt>
                  <c:pt idx="11">
                    <c:v>4.5514999999999999</c:v>
                  </c:pt>
                  <c:pt idx="12">
                    <c:v>5.2846320000000002</c:v>
                  </c:pt>
                  <c:pt idx="13">
                    <c:v>4.935835</c:v>
                  </c:pt>
                  <c:pt idx="14">
                    <c:v>6.658714999999976</c:v>
                  </c:pt>
                  <c:pt idx="15">
                    <c:v>7.3541829999999759</c:v>
                  </c:pt>
                </c:numCache>
              </c:numRef>
            </c:plus>
            <c:minus>
              <c:numRef>
                <c:f>'Macintosh HD:Users:ovcarelab:Desktop:Josh Master''s Files:Erlotinib-Sel-Project:MTS and CV:Incucyte Raw Data:20171017-6406-TraErlo:[17Oct17-6406-TraErlo-6500cw-Growth Curves.xlsx]17Oct17-6406-TraErlo-6500cw.txt'!$B$50:$Q$50</c:f>
                <c:numCache>
                  <c:formatCode>General</c:formatCode>
                  <c:ptCount val="16"/>
                  <c:pt idx="0">
                    <c:v>3.7959849999999999</c:v>
                  </c:pt>
                  <c:pt idx="1">
                    <c:v>3.5392929999999976</c:v>
                  </c:pt>
                  <c:pt idx="2">
                    <c:v>4.298216</c:v>
                  </c:pt>
                  <c:pt idx="3">
                    <c:v>3.9001710000000003</c:v>
                  </c:pt>
                  <c:pt idx="4">
                    <c:v>3.7601540000000004</c:v>
                  </c:pt>
                  <c:pt idx="5">
                    <c:v>4.0840499999999986</c:v>
                  </c:pt>
                  <c:pt idx="6">
                    <c:v>3.8796519999999957</c:v>
                  </c:pt>
                  <c:pt idx="7">
                    <c:v>4.7475069999999882</c:v>
                  </c:pt>
                  <c:pt idx="8">
                    <c:v>4.9892500000000011</c:v>
                  </c:pt>
                  <c:pt idx="9">
                    <c:v>4.749753000000001</c:v>
                  </c:pt>
                  <c:pt idx="10">
                    <c:v>4.8786849999999946</c:v>
                  </c:pt>
                  <c:pt idx="11">
                    <c:v>4.5514999999999999</c:v>
                  </c:pt>
                  <c:pt idx="12">
                    <c:v>5.2846320000000002</c:v>
                  </c:pt>
                  <c:pt idx="13">
                    <c:v>4.935835</c:v>
                  </c:pt>
                  <c:pt idx="14">
                    <c:v>6.658714999999976</c:v>
                  </c:pt>
                  <c:pt idx="15">
                    <c:v>7.3541829999999759</c:v>
                  </c:pt>
                </c:numCache>
              </c:numRef>
            </c:minus>
          </c:errBars>
          <c:errBars>
            <c:errDir val="x"/>
            <c:errBarType val="both"/>
            <c:errValType val="fixedVal"/>
            <c:val val="1"/>
          </c:errBars>
          <c:xVal>
            <c:numRef>
              <c:f>'Macintosh HD:Users:ovcarelab:Desktop:Josh Master''s Files:Erlotinib-Sel-Project:MTS and CV:Incucyte Raw Data:20171017-6406-TraErlo:[17Oct17-6406-TraErlo-6500cw-Growth Curves.xlsx]17Oct17-6406-TraErlo-6500cw.txt'!$B$28:$Q$28</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20171017-6406-TraErlo:[17Oct17-6406-TraErlo-6500cw-Growth Curves.xlsx]17Oct17-6406-TraErlo-6500cw.txt'!$B$32:$Q$32</c:f>
              <c:numCache>
                <c:formatCode>General</c:formatCode>
                <c:ptCount val="16"/>
                <c:pt idx="0">
                  <c:v>17.685619999999997</c:v>
                </c:pt>
                <c:pt idx="1">
                  <c:v>18.18591</c:v>
                </c:pt>
                <c:pt idx="2">
                  <c:v>19.14142</c:v>
                </c:pt>
                <c:pt idx="3">
                  <c:v>20.731999999999999</c:v>
                </c:pt>
                <c:pt idx="4">
                  <c:v>20.712489999999999</c:v>
                </c:pt>
                <c:pt idx="5">
                  <c:v>22.428549999999998</c:v>
                </c:pt>
                <c:pt idx="6">
                  <c:v>22.548469999999977</c:v>
                </c:pt>
                <c:pt idx="7">
                  <c:v>24.702099999999998</c:v>
                </c:pt>
                <c:pt idx="8">
                  <c:v>24.963819999999977</c:v>
                </c:pt>
                <c:pt idx="9">
                  <c:v>26.191600000000001</c:v>
                </c:pt>
                <c:pt idx="10">
                  <c:v>27.885850000000001</c:v>
                </c:pt>
                <c:pt idx="11">
                  <c:v>27.447109999999977</c:v>
                </c:pt>
                <c:pt idx="12">
                  <c:v>29.258179999999999</c:v>
                </c:pt>
                <c:pt idx="13">
                  <c:v>30.864940000000001</c:v>
                </c:pt>
                <c:pt idx="14">
                  <c:v>31.615729999999999</c:v>
                </c:pt>
                <c:pt idx="15">
                  <c:v>31.882539999999882</c:v>
                </c:pt>
              </c:numCache>
            </c:numRef>
          </c:yVal>
          <c:extLst xmlns:c16r2="http://schemas.microsoft.com/office/drawing/2015/06/chart">
            <c:ext xmlns:c16="http://schemas.microsoft.com/office/drawing/2014/chart" uri="{C3380CC4-5D6E-409C-BE32-E72D297353CC}">
              <c16:uniqueId val="{00000002-146C-8E4A-9AAD-AA4254134C9B}"/>
            </c:ext>
          </c:extLst>
        </c:ser>
        <c:ser>
          <c:idx val="4"/>
          <c:order val="3"/>
          <c:tx>
            <c:strRef>
              <c:f>'Macintosh HD:Users:ovcarelab:Desktop:Josh Master''s Files:Erlotinib-Sel-Project:MTS and CV:Incucyte Raw Data:20171017-6406-TraErlo:[17Oct17-6406-TraErlo-6500cw-Growth Curves.xlsx]17Oct17-6406-TraErlo-6500cw.txt'!$A$33</c:f>
              <c:strCache>
                <c:ptCount val="1"/>
                <c:pt idx="0">
                  <c:v>Trametinib 50 nM</c:v>
                </c:pt>
              </c:strCache>
            </c:strRef>
          </c:tx>
          <c:spPr>
            <a:ln w="19050">
              <a:solidFill>
                <a:srgbClr val="FF0000"/>
              </a:solidFill>
            </a:ln>
            <a:effectLst/>
          </c:spPr>
          <c:marker>
            <c:symbol val="square"/>
            <c:size val="5"/>
            <c:spPr>
              <a:solidFill>
                <a:srgbClr val="FF0000"/>
              </a:solidFill>
              <a:ln>
                <a:solidFill>
                  <a:srgbClr val="FF0000"/>
                </a:solidFill>
              </a:ln>
              <a:effectLst/>
            </c:spPr>
          </c:marker>
          <c:errBars>
            <c:errDir val="y"/>
            <c:errBarType val="both"/>
            <c:errValType val="cust"/>
            <c:plus>
              <c:numRef>
                <c:f>'Macintosh HD:Users:ovcarelab:Desktop:Josh Master''s Files:Erlotinib-Sel-Project:MTS and CV:Incucyte Raw Data:20171017-6406-TraErlo:[17Oct17-6406-TraErlo-6500cw-Growth Curves.xlsx]17Oct17-6406-TraErlo-6500cw.txt'!$B$51:$Q$51</c:f>
                <c:numCache>
                  <c:formatCode>General</c:formatCode>
                  <c:ptCount val="16"/>
                  <c:pt idx="0">
                    <c:v>3.8166689999999828</c:v>
                  </c:pt>
                  <c:pt idx="1">
                    <c:v>3.3261459999999996</c:v>
                  </c:pt>
                  <c:pt idx="2">
                    <c:v>3.007403</c:v>
                  </c:pt>
                  <c:pt idx="3">
                    <c:v>3.460753</c:v>
                  </c:pt>
                  <c:pt idx="4">
                    <c:v>3.3028569999999831</c:v>
                  </c:pt>
                  <c:pt idx="5">
                    <c:v>3.7843680000000002</c:v>
                  </c:pt>
                  <c:pt idx="6">
                    <c:v>4.3410030000000006</c:v>
                  </c:pt>
                  <c:pt idx="7">
                    <c:v>4.1732410000000009</c:v>
                  </c:pt>
                  <c:pt idx="8">
                    <c:v>3.9199229999999976</c:v>
                  </c:pt>
                  <c:pt idx="9">
                    <c:v>5.3379509999999817</c:v>
                  </c:pt>
                  <c:pt idx="10">
                    <c:v>5.9782240000000009</c:v>
                  </c:pt>
                  <c:pt idx="11">
                    <c:v>5.5296849999999935</c:v>
                  </c:pt>
                  <c:pt idx="12">
                    <c:v>5.3575909999999798</c:v>
                  </c:pt>
                  <c:pt idx="13">
                    <c:v>6.1877709999999881</c:v>
                  </c:pt>
                  <c:pt idx="14">
                    <c:v>6.175188999999988</c:v>
                  </c:pt>
                  <c:pt idx="15">
                    <c:v>3.5630549999999999</c:v>
                  </c:pt>
                </c:numCache>
              </c:numRef>
            </c:plus>
            <c:minus>
              <c:numRef>
                <c:f>'Macintosh HD:Users:ovcarelab:Desktop:Josh Master''s Files:Erlotinib-Sel-Project:MTS and CV:Incucyte Raw Data:20171017-6406-TraErlo:[17Oct17-6406-TraErlo-6500cw-Growth Curves.xlsx]17Oct17-6406-TraErlo-6500cw.txt'!$B$51:$Q$51</c:f>
                <c:numCache>
                  <c:formatCode>General</c:formatCode>
                  <c:ptCount val="16"/>
                  <c:pt idx="0">
                    <c:v>3.8166689999999828</c:v>
                  </c:pt>
                  <c:pt idx="1">
                    <c:v>3.3261459999999996</c:v>
                  </c:pt>
                  <c:pt idx="2">
                    <c:v>3.007403</c:v>
                  </c:pt>
                  <c:pt idx="3">
                    <c:v>3.460753</c:v>
                  </c:pt>
                  <c:pt idx="4">
                    <c:v>3.3028569999999831</c:v>
                  </c:pt>
                  <c:pt idx="5">
                    <c:v>3.7843680000000002</c:v>
                  </c:pt>
                  <c:pt idx="6">
                    <c:v>4.3410030000000006</c:v>
                  </c:pt>
                  <c:pt idx="7">
                    <c:v>4.1732410000000009</c:v>
                  </c:pt>
                  <c:pt idx="8">
                    <c:v>3.9199229999999976</c:v>
                  </c:pt>
                  <c:pt idx="9">
                    <c:v>5.3379509999999817</c:v>
                  </c:pt>
                  <c:pt idx="10">
                    <c:v>5.9782240000000009</c:v>
                  </c:pt>
                  <c:pt idx="11">
                    <c:v>5.5296849999999935</c:v>
                  </c:pt>
                  <c:pt idx="12">
                    <c:v>5.3575909999999798</c:v>
                  </c:pt>
                  <c:pt idx="13">
                    <c:v>6.1877709999999881</c:v>
                  </c:pt>
                  <c:pt idx="14">
                    <c:v>6.175188999999988</c:v>
                  </c:pt>
                  <c:pt idx="15">
                    <c:v>3.5630549999999999</c:v>
                  </c:pt>
                </c:numCache>
              </c:numRef>
            </c:minus>
          </c:errBars>
          <c:errBars>
            <c:errDir val="x"/>
            <c:errBarType val="both"/>
            <c:errValType val="fixedVal"/>
            <c:val val="1"/>
          </c:errBars>
          <c:xVal>
            <c:numRef>
              <c:f>'Macintosh HD:Users:ovcarelab:Desktop:Josh Master''s Files:Erlotinib-Sel-Project:MTS and CV:Incucyte Raw Data:20171017-6406-TraErlo:[17Oct17-6406-TraErlo-6500cw-Growth Curves.xlsx]17Oct17-6406-TraErlo-6500cw.txt'!$B$28:$Q$28</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20171017-6406-TraErlo:[17Oct17-6406-TraErlo-6500cw-Growth Curves.xlsx]17Oct17-6406-TraErlo-6500cw.txt'!$B$33:$Q$33</c:f>
              <c:numCache>
                <c:formatCode>General</c:formatCode>
                <c:ptCount val="16"/>
                <c:pt idx="0">
                  <c:v>16.89077</c:v>
                </c:pt>
                <c:pt idx="1">
                  <c:v>16.719660000000001</c:v>
                </c:pt>
                <c:pt idx="2">
                  <c:v>17.489939999999997</c:v>
                </c:pt>
                <c:pt idx="3">
                  <c:v>18.947800000000001</c:v>
                </c:pt>
                <c:pt idx="4">
                  <c:v>19.038890000000002</c:v>
                </c:pt>
                <c:pt idx="5">
                  <c:v>20.507160000000002</c:v>
                </c:pt>
                <c:pt idx="6">
                  <c:v>21.490929999999999</c:v>
                </c:pt>
                <c:pt idx="7">
                  <c:v>22.507160000000002</c:v>
                </c:pt>
                <c:pt idx="8">
                  <c:v>24.110779999999988</c:v>
                </c:pt>
                <c:pt idx="9">
                  <c:v>25.050509999999999</c:v>
                </c:pt>
                <c:pt idx="10">
                  <c:v>27.287759999999999</c:v>
                </c:pt>
                <c:pt idx="11">
                  <c:v>25.636460000000003</c:v>
                </c:pt>
                <c:pt idx="12">
                  <c:v>28.48533999999983</c:v>
                </c:pt>
                <c:pt idx="13">
                  <c:v>29.193269999999988</c:v>
                </c:pt>
                <c:pt idx="14">
                  <c:v>29.495499999999996</c:v>
                </c:pt>
                <c:pt idx="15">
                  <c:v>29.142589999999977</c:v>
                </c:pt>
              </c:numCache>
            </c:numRef>
          </c:yVal>
          <c:extLst xmlns:c16r2="http://schemas.microsoft.com/office/drawing/2015/06/chart">
            <c:ext xmlns:c16="http://schemas.microsoft.com/office/drawing/2014/chart" uri="{C3380CC4-5D6E-409C-BE32-E72D297353CC}">
              <c16:uniqueId val="{00000003-146C-8E4A-9AAD-AA4254134C9B}"/>
            </c:ext>
          </c:extLst>
        </c:ser>
        <c:ser>
          <c:idx val="12"/>
          <c:order val="4"/>
          <c:tx>
            <c:v>Erl 2.5µM + Tra 50nM</c:v>
          </c:tx>
          <c:spPr>
            <a:ln w="19050">
              <a:solidFill>
                <a:srgbClr val="7030A0"/>
              </a:solidFill>
            </a:ln>
            <a:effectLst/>
          </c:spPr>
          <c:marker>
            <c:symbol val="plus"/>
            <c:size val="5"/>
            <c:spPr>
              <a:noFill/>
              <a:ln>
                <a:solidFill>
                  <a:srgbClr val="7030A0"/>
                </a:solidFill>
              </a:ln>
              <a:effectLst/>
            </c:spPr>
          </c:marker>
          <c:errBars>
            <c:errDir val="y"/>
            <c:errBarType val="both"/>
            <c:errValType val="cust"/>
            <c:plus>
              <c:numRef>
                <c:f>'Macintosh HD:Users:ovcarelab:Desktop:Josh Master''s Files:Erlotinib-Sel-Project:MTS and CV:Incucyte Raw Data:20171017-6406-TraErlo:[17Oct17-6406-TraErlo-6500cw-Growth Curves.xlsx]17Oct17-6406-TraErlo-6500cw.txt'!$B$59:$Q$59</c:f>
                <c:numCache>
                  <c:formatCode>General</c:formatCode>
                  <c:ptCount val="16"/>
                  <c:pt idx="0">
                    <c:v>4.0910000000000002</c:v>
                  </c:pt>
                  <c:pt idx="1">
                    <c:v>3.0628649999999986</c:v>
                  </c:pt>
                  <c:pt idx="2">
                    <c:v>4.0496380000000007</c:v>
                  </c:pt>
                  <c:pt idx="3">
                    <c:v>4.0832700000000006</c:v>
                  </c:pt>
                  <c:pt idx="4">
                    <c:v>4.7536620000000012</c:v>
                  </c:pt>
                  <c:pt idx="5">
                    <c:v>4.5093630000000013</c:v>
                  </c:pt>
                  <c:pt idx="6">
                    <c:v>3.9481810000000004</c:v>
                  </c:pt>
                  <c:pt idx="7">
                    <c:v>4.4216839999999999</c:v>
                  </c:pt>
                  <c:pt idx="8">
                    <c:v>4.039778000000001</c:v>
                  </c:pt>
                  <c:pt idx="9">
                    <c:v>3.7849400000000002</c:v>
                  </c:pt>
                  <c:pt idx="10">
                    <c:v>4.8247419999999881</c:v>
                  </c:pt>
                  <c:pt idx="11">
                    <c:v>5.3671479999999816</c:v>
                  </c:pt>
                  <c:pt idx="12">
                    <c:v>6.3297749999999882</c:v>
                  </c:pt>
                  <c:pt idx="13">
                    <c:v>5.3892190000000006</c:v>
                  </c:pt>
                  <c:pt idx="14">
                    <c:v>5.3193700000000002</c:v>
                  </c:pt>
                  <c:pt idx="15">
                    <c:v>5.0381490000000007</c:v>
                  </c:pt>
                </c:numCache>
              </c:numRef>
            </c:plus>
            <c:minus>
              <c:numRef>
                <c:f>'Macintosh HD:Users:ovcarelab:Desktop:Josh Master''s Files:Erlotinib-Sel-Project:MTS and CV:Incucyte Raw Data:20171017-6406-TraErlo:[17Oct17-6406-TraErlo-6500cw-Growth Curves.xlsx]17Oct17-6406-TraErlo-6500cw.txt'!$B$59:$Q$59</c:f>
                <c:numCache>
                  <c:formatCode>General</c:formatCode>
                  <c:ptCount val="16"/>
                  <c:pt idx="0">
                    <c:v>4.0910000000000002</c:v>
                  </c:pt>
                  <c:pt idx="1">
                    <c:v>3.0628649999999986</c:v>
                  </c:pt>
                  <c:pt idx="2">
                    <c:v>4.0496380000000007</c:v>
                  </c:pt>
                  <c:pt idx="3">
                    <c:v>4.0832700000000006</c:v>
                  </c:pt>
                  <c:pt idx="4">
                    <c:v>4.7536620000000012</c:v>
                  </c:pt>
                  <c:pt idx="5">
                    <c:v>4.5093630000000013</c:v>
                  </c:pt>
                  <c:pt idx="6">
                    <c:v>3.9481810000000004</c:v>
                  </c:pt>
                  <c:pt idx="7">
                    <c:v>4.4216839999999999</c:v>
                  </c:pt>
                  <c:pt idx="8">
                    <c:v>4.039778000000001</c:v>
                  </c:pt>
                  <c:pt idx="9">
                    <c:v>3.7849400000000002</c:v>
                  </c:pt>
                  <c:pt idx="10">
                    <c:v>4.8247419999999881</c:v>
                  </c:pt>
                  <c:pt idx="11">
                    <c:v>5.3671479999999816</c:v>
                  </c:pt>
                  <c:pt idx="12">
                    <c:v>6.3297749999999882</c:v>
                  </c:pt>
                  <c:pt idx="13">
                    <c:v>5.3892190000000006</c:v>
                  </c:pt>
                  <c:pt idx="14">
                    <c:v>5.3193700000000002</c:v>
                  </c:pt>
                  <c:pt idx="15">
                    <c:v>5.0381490000000007</c:v>
                  </c:pt>
                </c:numCache>
              </c:numRef>
            </c:minus>
          </c:errBars>
          <c:errBars>
            <c:errDir val="x"/>
            <c:errBarType val="both"/>
            <c:errValType val="fixedVal"/>
            <c:val val="1"/>
          </c:errBars>
          <c:xVal>
            <c:numRef>
              <c:f>'Macintosh HD:Users:ovcarelab:Desktop:Josh Master''s Files:Erlotinib-Sel-Project:MTS and CV:Incucyte Raw Data:20171017-6406-TraErlo:[17Oct17-6406-TraErlo-6500cw-Growth Curves.xlsx]17Oct17-6406-TraErlo-6500cw.txt'!$B$28:$Q$28</c:f>
              <c:numCache>
                <c:formatCode>General</c:formatCode>
                <c:ptCount val="16"/>
                <c:pt idx="0">
                  <c:v>0</c:v>
                </c:pt>
                <c:pt idx="1">
                  <c:v>6</c:v>
                </c:pt>
                <c:pt idx="2">
                  <c:v>12</c:v>
                </c:pt>
                <c:pt idx="3">
                  <c:v>18</c:v>
                </c:pt>
                <c:pt idx="4">
                  <c:v>24</c:v>
                </c:pt>
                <c:pt idx="5">
                  <c:v>30</c:v>
                </c:pt>
                <c:pt idx="6">
                  <c:v>36</c:v>
                </c:pt>
                <c:pt idx="7">
                  <c:v>42</c:v>
                </c:pt>
                <c:pt idx="8">
                  <c:v>48</c:v>
                </c:pt>
                <c:pt idx="9">
                  <c:v>54</c:v>
                </c:pt>
                <c:pt idx="10">
                  <c:v>60</c:v>
                </c:pt>
                <c:pt idx="11">
                  <c:v>66</c:v>
                </c:pt>
                <c:pt idx="12">
                  <c:v>72</c:v>
                </c:pt>
                <c:pt idx="13">
                  <c:v>78</c:v>
                </c:pt>
                <c:pt idx="14">
                  <c:v>84</c:v>
                </c:pt>
                <c:pt idx="15">
                  <c:v>90</c:v>
                </c:pt>
              </c:numCache>
            </c:numRef>
          </c:xVal>
          <c:yVal>
            <c:numRef>
              <c:f>'Macintosh HD:Users:ovcarelab:Desktop:Josh Master''s Files:Erlotinib-Sel-Project:MTS and CV:Incucyte Raw Data:20171017-6406-TraErlo:[17Oct17-6406-TraErlo-6500cw-Growth Curves.xlsx]17Oct17-6406-TraErlo-6500cw.txt'!$B$41:$Q$41</c:f>
              <c:numCache>
                <c:formatCode>General</c:formatCode>
                <c:ptCount val="16"/>
                <c:pt idx="0">
                  <c:v>18.400009999999998</c:v>
                </c:pt>
                <c:pt idx="1">
                  <c:v>18.307030000000001</c:v>
                </c:pt>
                <c:pt idx="2">
                  <c:v>18.648900000000001</c:v>
                </c:pt>
                <c:pt idx="3">
                  <c:v>20.455970000000001</c:v>
                </c:pt>
                <c:pt idx="4">
                  <c:v>20.420459999999977</c:v>
                </c:pt>
                <c:pt idx="5">
                  <c:v>21.223229999999997</c:v>
                </c:pt>
                <c:pt idx="6">
                  <c:v>20.82507</c:v>
                </c:pt>
                <c:pt idx="7">
                  <c:v>22.241339999999997</c:v>
                </c:pt>
                <c:pt idx="8">
                  <c:v>21.773199999999999</c:v>
                </c:pt>
                <c:pt idx="9">
                  <c:v>23.017950000000006</c:v>
                </c:pt>
                <c:pt idx="10">
                  <c:v>24.004950000000004</c:v>
                </c:pt>
                <c:pt idx="11">
                  <c:v>23.192019999999999</c:v>
                </c:pt>
                <c:pt idx="12">
                  <c:v>24.03623</c:v>
                </c:pt>
                <c:pt idx="13">
                  <c:v>24.005099999999999</c:v>
                </c:pt>
                <c:pt idx="14">
                  <c:v>23.980819999999998</c:v>
                </c:pt>
                <c:pt idx="15">
                  <c:v>23.794180000000001</c:v>
                </c:pt>
              </c:numCache>
            </c:numRef>
          </c:yVal>
          <c:extLst xmlns:c16r2="http://schemas.microsoft.com/office/drawing/2015/06/chart">
            <c:ext xmlns:c16="http://schemas.microsoft.com/office/drawing/2014/chart" uri="{C3380CC4-5D6E-409C-BE32-E72D297353CC}">
              <c16:uniqueId val="{00000004-146C-8E4A-9AAD-AA4254134C9B}"/>
            </c:ext>
          </c:extLst>
        </c:ser>
        <c:dLbls/>
        <c:axId val="113011328"/>
        <c:axId val="113017216"/>
      </c:scatterChart>
      <c:valAx>
        <c:axId val="113011328"/>
        <c:scaling>
          <c:orientation val="minMax"/>
          <c:max val="90"/>
          <c:min val="0"/>
        </c:scaling>
        <c:axPos val="b"/>
        <c:numFmt formatCode="General" sourceLinked="1"/>
        <c:tickLblPos val="nextTo"/>
        <c:crossAx val="113017216"/>
        <c:crosses val="autoZero"/>
        <c:crossBetween val="midCat"/>
        <c:majorUnit val="15"/>
      </c:valAx>
      <c:valAx>
        <c:axId val="113017216"/>
        <c:scaling>
          <c:orientation val="minMax"/>
          <c:max val="100"/>
        </c:scaling>
        <c:axPos val="l"/>
        <c:majorGridlines/>
        <c:title>
          <c:tx>
            <c:rich>
              <a:bodyPr rot="-5400000" vert="horz"/>
              <a:lstStyle/>
              <a:p>
                <a:pPr>
                  <a:defRPr/>
                </a:pPr>
                <a:r>
                  <a:rPr lang="en-US" dirty="0"/>
                  <a:t>% Confluence</a:t>
                </a:r>
              </a:p>
            </c:rich>
          </c:tx>
          <c:layout/>
        </c:title>
        <c:numFmt formatCode="General" sourceLinked="1"/>
        <c:tickLblPos val="nextTo"/>
        <c:crossAx val="113011328"/>
        <c:crosses val="autoZero"/>
        <c:crossBetween val="midCat"/>
        <c:majorUnit val="10"/>
      </c:valAx>
    </c:plotArea>
    <c:plotVisOnly val="1"/>
    <c:dispBlanksAs val="gap"/>
  </c:chart>
  <c:txPr>
    <a:bodyPr/>
    <a:lstStyle/>
    <a:p>
      <a:pPr>
        <a:defRPr sz="800"/>
      </a:pPr>
      <a:endParaRPr lang="en-US"/>
    </a:p>
  </c:tx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30585848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4" name="Date Placeholder 3"/>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7637952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CA"/>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4" name="Date Placeholder 3"/>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18840585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a:t>Click to edit Master title style</a:t>
            </a:r>
            <a:endParaRPr lang="en-US"/>
          </a:p>
        </p:txBody>
      </p:sp>
      <p:sp>
        <p:nvSpPr>
          <p:cNvPr id="3" name="Content Placeholder 2"/>
          <p:cNvSpPr>
            <a:spLocks noGrp="1"/>
          </p:cNvSpPr>
          <p:nvPr>
            <p:ph idx="1"/>
          </p:nvPr>
        </p:nvSpPr>
        <p:spPr/>
        <p:txBody>
          <a:body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4" name="Date Placeholder 3"/>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33291920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CA"/>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CA"/>
              <a:t>Click to edit Master text styles</a:t>
            </a:r>
          </a:p>
        </p:txBody>
      </p:sp>
      <p:sp>
        <p:nvSpPr>
          <p:cNvPr id="4" name="Date Placeholder 3"/>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3423121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5" name="Date Placeholder 4"/>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978929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CA"/>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CA"/>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CA"/>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7" name="Date Placeholder 6"/>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42530475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a:t>Click to edit Master title style</a:t>
            </a:r>
            <a:endParaRPr lang="en-US"/>
          </a:p>
        </p:txBody>
      </p:sp>
      <p:sp>
        <p:nvSpPr>
          <p:cNvPr id="3" name="Date Placeholder 2"/>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17131403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12182549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CA"/>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CA"/>
              <a:t>Click to edit Master text styles</a:t>
            </a:r>
          </a:p>
          <a:p>
            <a:pPr lvl="1"/>
            <a:r>
              <a:rPr lang="en-CA"/>
              <a:t>Second level</a:t>
            </a:r>
          </a:p>
          <a:p>
            <a:pPr lvl="2"/>
            <a:r>
              <a:rPr lang="en-CA"/>
              <a:t>Third level</a:t>
            </a:r>
          </a:p>
          <a:p>
            <a:pPr lvl="3"/>
            <a:r>
              <a:rPr lang="en-CA"/>
              <a:t>Fourth level</a:t>
            </a:r>
          </a:p>
          <a:p>
            <a:pPr lvl="4"/>
            <a:r>
              <a:rPr lang="en-CA"/>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CA"/>
              <a:t>Click to edit Master text styles</a:t>
            </a:r>
          </a:p>
        </p:txBody>
      </p:sp>
      <p:sp>
        <p:nvSpPr>
          <p:cNvPr id="5" name="Date Placeholder 4"/>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1853493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CA"/>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CA"/>
              <a:t>Click to edit Master text styles</a:t>
            </a:r>
          </a:p>
        </p:txBody>
      </p:sp>
      <p:sp>
        <p:nvSpPr>
          <p:cNvPr id="5" name="Date Placeholder 4"/>
          <p:cNvSpPr>
            <a:spLocks noGrp="1"/>
          </p:cNvSpPr>
          <p:nvPr>
            <p:ph type="dt" sz="half" idx="10"/>
          </p:nvPr>
        </p:nvSpPr>
        <p:spPr/>
        <p:txBody>
          <a:bodyPr/>
          <a:lstStyle/>
          <a:p>
            <a:fld id="{2AF24929-0B65-F04B-BEE9-A437E70851AA}" type="datetimeFigureOut">
              <a:rPr lang="en-US" smtClean="0"/>
              <a:pPr/>
              <a:t>1/4/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10418009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F24929-0B65-F04B-BEE9-A437E70851AA}" type="datetimeFigureOut">
              <a:rPr lang="en-US" smtClean="0"/>
              <a:pPr/>
              <a:t>1/4/2019</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E0A8B6C-C7E0-5D43-A622-82395A35FB32}" type="slidenum">
              <a:rPr lang="en-US" smtClean="0"/>
              <a:pPr/>
              <a:t>‹#›</a:t>
            </a:fld>
            <a:endParaRPr lang="en-US" dirty="0"/>
          </a:p>
        </p:txBody>
      </p:sp>
    </p:spTree>
    <p:extLst>
      <p:ext uri="{BB962C8B-B14F-4D97-AF65-F5344CB8AC3E}">
        <p14:creationId xmlns:p14="http://schemas.microsoft.com/office/powerpoint/2010/main" xmlns="" val="20218618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7.xml"/><Relationship Id="rId13" Type="http://schemas.openxmlformats.org/officeDocument/2006/relationships/image" Target="../media/image4.png"/><Relationship Id="rId3" Type="http://schemas.openxmlformats.org/officeDocument/2006/relationships/chart" Target="../charts/chart2.xml"/><Relationship Id="rId7" Type="http://schemas.openxmlformats.org/officeDocument/2006/relationships/chart" Target="../charts/chart6.xml"/><Relationship Id="rId12" Type="http://schemas.openxmlformats.org/officeDocument/2006/relationships/image" Target="../media/image3.png"/><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5.xml"/><Relationship Id="rId11" Type="http://schemas.openxmlformats.org/officeDocument/2006/relationships/image" Target="../media/image2.png"/><Relationship Id="rId5" Type="http://schemas.openxmlformats.org/officeDocument/2006/relationships/chart" Target="../charts/chart4.xml"/><Relationship Id="rId10" Type="http://schemas.openxmlformats.org/officeDocument/2006/relationships/image" Target="../media/image1.png"/><Relationship Id="rId4" Type="http://schemas.openxmlformats.org/officeDocument/2006/relationships/chart" Target="../charts/chart3.xml"/><Relationship Id="rId9" Type="http://schemas.openxmlformats.org/officeDocument/2006/relationships/chart" Target="../charts/chart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1" name="Chart 70"/>
          <p:cNvGraphicFramePr>
            <a:graphicFrameLocks/>
          </p:cNvGraphicFramePr>
          <p:nvPr>
            <p:extLst>
              <p:ext uri="{D42A27DB-BD31-4B8C-83A1-F6EECF244321}">
                <p14:modId xmlns:p14="http://schemas.microsoft.com/office/powerpoint/2010/main" xmlns="" val="1315802268"/>
              </p:ext>
            </p:extLst>
          </p:nvPr>
        </p:nvGraphicFramePr>
        <p:xfrm>
          <a:off x="4215836" y="397519"/>
          <a:ext cx="2876444" cy="159132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0" name="Chart 69"/>
          <p:cNvGraphicFramePr>
            <a:graphicFrameLocks/>
          </p:cNvGraphicFramePr>
          <p:nvPr>
            <p:extLst>
              <p:ext uri="{D42A27DB-BD31-4B8C-83A1-F6EECF244321}">
                <p14:modId xmlns:p14="http://schemas.microsoft.com/office/powerpoint/2010/main" xmlns="" val="2424033802"/>
              </p:ext>
            </p:extLst>
          </p:nvPr>
        </p:nvGraphicFramePr>
        <p:xfrm>
          <a:off x="4211959" y="1988840"/>
          <a:ext cx="2620299" cy="156713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6" name="Chart 65"/>
          <p:cNvGraphicFramePr>
            <a:graphicFrameLocks/>
          </p:cNvGraphicFramePr>
          <p:nvPr>
            <p:extLst>
              <p:ext uri="{D42A27DB-BD31-4B8C-83A1-F6EECF244321}">
                <p14:modId xmlns:p14="http://schemas.microsoft.com/office/powerpoint/2010/main" xmlns="" val="992743181"/>
              </p:ext>
            </p:extLst>
          </p:nvPr>
        </p:nvGraphicFramePr>
        <p:xfrm>
          <a:off x="4296792" y="4326357"/>
          <a:ext cx="2673352" cy="248701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9" name="Chart 68"/>
          <p:cNvGraphicFramePr>
            <a:graphicFrameLocks/>
          </p:cNvGraphicFramePr>
          <p:nvPr>
            <p:extLst>
              <p:ext uri="{D42A27DB-BD31-4B8C-83A1-F6EECF244321}">
                <p14:modId xmlns:p14="http://schemas.microsoft.com/office/powerpoint/2010/main" xmlns="" val="866262438"/>
              </p:ext>
            </p:extLst>
          </p:nvPr>
        </p:nvGraphicFramePr>
        <p:xfrm>
          <a:off x="4211961" y="3107841"/>
          <a:ext cx="2690774" cy="1855786"/>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5" name="Chart 14"/>
          <p:cNvGraphicFramePr>
            <a:graphicFrameLocks/>
          </p:cNvGraphicFramePr>
          <p:nvPr>
            <p:extLst>
              <p:ext uri="{D42A27DB-BD31-4B8C-83A1-F6EECF244321}">
                <p14:modId xmlns:p14="http://schemas.microsoft.com/office/powerpoint/2010/main" xmlns="" val="864173352"/>
              </p:ext>
            </p:extLst>
          </p:nvPr>
        </p:nvGraphicFramePr>
        <p:xfrm>
          <a:off x="170182" y="4608512"/>
          <a:ext cx="4641076" cy="2204864"/>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3" name="Chart 12"/>
          <p:cNvGraphicFramePr>
            <a:graphicFrameLocks/>
          </p:cNvGraphicFramePr>
          <p:nvPr>
            <p:extLst>
              <p:ext uri="{D42A27DB-BD31-4B8C-83A1-F6EECF244321}">
                <p14:modId xmlns:p14="http://schemas.microsoft.com/office/powerpoint/2010/main" xmlns="" val="583647414"/>
              </p:ext>
            </p:extLst>
          </p:nvPr>
        </p:nvGraphicFramePr>
        <p:xfrm>
          <a:off x="220611" y="3310185"/>
          <a:ext cx="4582547" cy="1656184"/>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2" name="Chart 11"/>
          <p:cNvGraphicFramePr>
            <a:graphicFrameLocks/>
          </p:cNvGraphicFramePr>
          <p:nvPr>
            <p:extLst>
              <p:ext uri="{D42A27DB-BD31-4B8C-83A1-F6EECF244321}">
                <p14:modId xmlns:p14="http://schemas.microsoft.com/office/powerpoint/2010/main" xmlns="" val="113878160"/>
              </p:ext>
            </p:extLst>
          </p:nvPr>
        </p:nvGraphicFramePr>
        <p:xfrm>
          <a:off x="220611" y="1755773"/>
          <a:ext cx="4614103" cy="18002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1" name="Chart 10"/>
          <p:cNvGraphicFramePr>
            <a:graphicFrameLocks/>
          </p:cNvGraphicFramePr>
          <p:nvPr>
            <p:extLst>
              <p:ext uri="{D42A27DB-BD31-4B8C-83A1-F6EECF244321}">
                <p14:modId xmlns:p14="http://schemas.microsoft.com/office/powerpoint/2010/main" xmlns="" val="1597373614"/>
              </p:ext>
            </p:extLst>
          </p:nvPr>
        </p:nvGraphicFramePr>
        <p:xfrm>
          <a:off x="179512" y="421720"/>
          <a:ext cx="4542732" cy="1664830"/>
        </p:xfrm>
        <a:graphic>
          <a:graphicData uri="http://schemas.openxmlformats.org/drawingml/2006/chart">
            <c:chart xmlns:c="http://schemas.openxmlformats.org/drawingml/2006/chart" xmlns:r="http://schemas.openxmlformats.org/officeDocument/2006/relationships" r:id="rId9"/>
          </a:graphicData>
        </a:graphic>
      </p:graphicFrame>
      <p:sp>
        <p:nvSpPr>
          <p:cNvPr id="20" name="TextBox 19"/>
          <p:cNvSpPr txBox="1"/>
          <p:nvPr/>
        </p:nvSpPr>
        <p:spPr>
          <a:xfrm rot="16200000">
            <a:off x="-204769" y="1048104"/>
            <a:ext cx="809687" cy="276999"/>
          </a:xfrm>
          <a:prstGeom prst="rect">
            <a:avLst/>
          </a:prstGeom>
          <a:noFill/>
        </p:spPr>
        <p:txBody>
          <a:bodyPr wrap="none" rtlCol="0">
            <a:spAutoFit/>
          </a:bodyPr>
          <a:lstStyle/>
          <a:p>
            <a:r>
              <a:rPr lang="en-US" sz="1200" dirty="0"/>
              <a:t>VOA 6406</a:t>
            </a:r>
          </a:p>
        </p:txBody>
      </p:sp>
      <p:sp>
        <p:nvSpPr>
          <p:cNvPr id="22" name="TextBox 21"/>
          <p:cNvSpPr txBox="1"/>
          <p:nvPr/>
        </p:nvSpPr>
        <p:spPr>
          <a:xfrm>
            <a:off x="42039" y="523367"/>
            <a:ext cx="324128" cy="369332"/>
          </a:xfrm>
          <a:prstGeom prst="rect">
            <a:avLst/>
          </a:prstGeom>
          <a:noFill/>
        </p:spPr>
        <p:txBody>
          <a:bodyPr wrap="none" rtlCol="0">
            <a:spAutoFit/>
          </a:bodyPr>
          <a:lstStyle/>
          <a:p>
            <a:r>
              <a:rPr lang="en-US" b="1" dirty="0"/>
              <a:t>A</a:t>
            </a:r>
          </a:p>
        </p:txBody>
      </p:sp>
      <p:sp>
        <p:nvSpPr>
          <p:cNvPr id="24" name="TextBox 23"/>
          <p:cNvSpPr txBox="1"/>
          <p:nvPr/>
        </p:nvSpPr>
        <p:spPr>
          <a:xfrm rot="16200000">
            <a:off x="-202949" y="2390197"/>
            <a:ext cx="813043" cy="276999"/>
          </a:xfrm>
          <a:prstGeom prst="rect">
            <a:avLst/>
          </a:prstGeom>
          <a:noFill/>
        </p:spPr>
        <p:txBody>
          <a:bodyPr wrap="none" rtlCol="0">
            <a:spAutoFit/>
          </a:bodyPr>
          <a:lstStyle/>
          <a:p>
            <a:r>
              <a:rPr lang="en-US" sz="1200" dirty="0"/>
              <a:t>VOA 3723</a:t>
            </a:r>
          </a:p>
        </p:txBody>
      </p:sp>
      <p:sp>
        <p:nvSpPr>
          <p:cNvPr id="25" name="TextBox 24"/>
          <p:cNvSpPr txBox="1"/>
          <p:nvPr/>
        </p:nvSpPr>
        <p:spPr>
          <a:xfrm rot="16200000">
            <a:off x="-206447" y="3893114"/>
            <a:ext cx="813043" cy="276999"/>
          </a:xfrm>
          <a:prstGeom prst="rect">
            <a:avLst/>
          </a:prstGeom>
          <a:noFill/>
        </p:spPr>
        <p:txBody>
          <a:bodyPr wrap="none" rtlCol="0">
            <a:spAutoFit/>
          </a:bodyPr>
          <a:lstStyle/>
          <a:p>
            <a:r>
              <a:rPr lang="en-US" sz="1200" dirty="0"/>
              <a:t>VOA 4627</a:t>
            </a:r>
          </a:p>
        </p:txBody>
      </p:sp>
      <p:sp>
        <p:nvSpPr>
          <p:cNvPr id="26" name="TextBox 25"/>
          <p:cNvSpPr txBox="1"/>
          <p:nvPr/>
        </p:nvSpPr>
        <p:spPr>
          <a:xfrm rot="16200000">
            <a:off x="-206447" y="5231649"/>
            <a:ext cx="813043" cy="276999"/>
          </a:xfrm>
          <a:prstGeom prst="rect">
            <a:avLst/>
          </a:prstGeom>
          <a:noFill/>
        </p:spPr>
        <p:txBody>
          <a:bodyPr wrap="none" rtlCol="0">
            <a:spAutoFit/>
          </a:bodyPr>
          <a:lstStyle/>
          <a:p>
            <a:r>
              <a:rPr lang="en-US" sz="1200" dirty="0"/>
              <a:t>VOA 3993</a:t>
            </a:r>
          </a:p>
        </p:txBody>
      </p:sp>
      <p:sp>
        <p:nvSpPr>
          <p:cNvPr id="27" name="TextBox 26"/>
          <p:cNvSpPr txBox="1"/>
          <p:nvPr/>
        </p:nvSpPr>
        <p:spPr>
          <a:xfrm>
            <a:off x="4067944" y="523367"/>
            <a:ext cx="314510" cy="369332"/>
          </a:xfrm>
          <a:prstGeom prst="rect">
            <a:avLst/>
          </a:prstGeom>
          <a:noFill/>
        </p:spPr>
        <p:txBody>
          <a:bodyPr wrap="none" rtlCol="0">
            <a:spAutoFit/>
          </a:bodyPr>
          <a:lstStyle/>
          <a:p>
            <a:r>
              <a:rPr lang="en-US" b="1" dirty="0"/>
              <a:t>B</a:t>
            </a:r>
          </a:p>
        </p:txBody>
      </p:sp>
      <p:sp>
        <p:nvSpPr>
          <p:cNvPr id="3" name="TextBox 2">
            <a:extLst>
              <a:ext uri="{FF2B5EF4-FFF2-40B4-BE49-F238E27FC236}">
                <a16:creationId xmlns="" xmlns:a16="http://schemas.microsoft.com/office/drawing/2014/main" id="{D1CA2805-C55E-464C-BBA9-5664DDC384A9}"/>
              </a:ext>
            </a:extLst>
          </p:cNvPr>
          <p:cNvSpPr txBox="1"/>
          <p:nvPr/>
        </p:nvSpPr>
        <p:spPr>
          <a:xfrm>
            <a:off x="1636935" y="6352734"/>
            <a:ext cx="1008112" cy="404213"/>
          </a:xfrm>
          <a:prstGeom prst="rect">
            <a:avLst/>
          </a:prstGeom>
          <a:solidFill>
            <a:schemeClr val="bg1"/>
          </a:solidFill>
        </p:spPr>
        <p:txBody>
          <a:bodyPr wrap="square" lIns="0" tIns="0" rIns="0" bIns="0" rtlCol="0">
            <a:spAutoFit/>
          </a:bodyPr>
          <a:lstStyle/>
          <a:p>
            <a:pPr>
              <a:lnSpc>
                <a:spcPct val="110000"/>
              </a:lnSpc>
            </a:pPr>
            <a:r>
              <a:rPr lang="en-US" sz="800" dirty="0"/>
              <a:t>DMSO </a:t>
            </a:r>
            <a:endParaRPr lang="en-US" sz="800" dirty="0" smtClean="0"/>
          </a:p>
          <a:p>
            <a:pPr>
              <a:lnSpc>
                <a:spcPct val="110000"/>
              </a:lnSpc>
            </a:pPr>
            <a:r>
              <a:rPr lang="en-US" sz="800" dirty="0" err="1" smtClean="0"/>
              <a:t>Tra</a:t>
            </a:r>
            <a:r>
              <a:rPr lang="en-US" sz="800" dirty="0" smtClean="0"/>
              <a:t> </a:t>
            </a:r>
            <a:r>
              <a:rPr lang="en-US" sz="800" dirty="0"/>
              <a:t>0.1µM</a:t>
            </a:r>
          </a:p>
          <a:p>
            <a:pPr>
              <a:lnSpc>
                <a:spcPct val="110000"/>
              </a:lnSpc>
            </a:pPr>
            <a:r>
              <a:rPr lang="en-US" sz="800" dirty="0" err="1"/>
              <a:t>Erl</a:t>
            </a:r>
            <a:r>
              <a:rPr lang="en-US" sz="800" dirty="0"/>
              <a:t> 2.5µM + </a:t>
            </a:r>
            <a:r>
              <a:rPr lang="en-US" sz="800" dirty="0" err="1"/>
              <a:t>Tra</a:t>
            </a:r>
            <a:r>
              <a:rPr lang="en-US" sz="800" dirty="0"/>
              <a:t> </a:t>
            </a:r>
            <a:r>
              <a:rPr lang="en-US" sz="800" dirty="0" smtClean="0"/>
              <a:t>0.05µM</a:t>
            </a:r>
          </a:p>
        </p:txBody>
      </p:sp>
      <p:sp>
        <p:nvSpPr>
          <p:cNvPr id="31" name="TextBox 30">
            <a:extLst>
              <a:ext uri="{FF2B5EF4-FFF2-40B4-BE49-F238E27FC236}">
                <a16:creationId xmlns="" xmlns:a16="http://schemas.microsoft.com/office/drawing/2014/main" id="{9EDF2D6F-481F-E040-82ED-A5D17C7EA4C2}"/>
              </a:ext>
            </a:extLst>
          </p:cNvPr>
          <p:cNvSpPr txBox="1"/>
          <p:nvPr/>
        </p:nvSpPr>
        <p:spPr>
          <a:xfrm>
            <a:off x="3150507" y="6355322"/>
            <a:ext cx="936104" cy="404213"/>
          </a:xfrm>
          <a:prstGeom prst="rect">
            <a:avLst/>
          </a:prstGeom>
          <a:solidFill>
            <a:schemeClr val="bg1"/>
          </a:solidFill>
        </p:spPr>
        <p:txBody>
          <a:bodyPr wrap="square" lIns="0" tIns="0" rIns="0" bIns="0" rtlCol="0">
            <a:spAutoFit/>
          </a:bodyPr>
          <a:lstStyle/>
          <a:p>
            <a:pPr>
              <a:lnSpc>
                <a:spcPct val="110000"/>
              </a:lnSpc>
            </a:pPr>
            <a:r>
              <a:rPr lang="en-US" sz="800" dirty="0" err="1"/>
              <a:t>Erl</a:t>
            </a:r>
            <a:r>
              <a:rPr lang="en-US" sz="800" dirty="0"/>
              <a:t> 2.5µM</a:t>
            </a:r>
          </a:p>
          <a:p>
            <a:pPr>
              <a:lnSpc>
                <a:spcPct val="110000"/>
              </a:lnSpc>
            </a:pPr>
            <a:r>
              <a:rPr lang="en-US" sz="800" dirty="0" err="1"/>
              <a:t>Tra</a:t>
            </a:r>
            <a:r>
              <a:rPr lang="en-US" sz="800" dirty="0"/>
              <a:t> 0.05µM</a:t>
            </a:r>
          </a:p>
          <a:p>
            <a:pPr>
              <a:lnSpc>
                <a:spcPct val="110000"/>
              </a:lnSpc>
            </a:pPr>
            <a:endParaRPr lang="en-US" sz="800" dirty="0"/>
          </a:p>
        </p:txBody>
      </p:sp>
      <p:graphicFrame>
        <p:nvGraphicFramePr>
          <p:cNvPr id="35" name="Table 34">
            <a:extLst>
              <a:ext uri="{FF2B5EF4-FFF2-40B4-BE49-F238E27FC236}">
                <a16:creationId xmlns="" xmlns:a16="http://schemas.microsoft.com/office/drawing/2014/main" id="{725EAA19-CC36-A544-9DF6-B47E125E6048}"/>
              </a:ext>
            </a:extLst>
          </p:cNvPr>
          <p:cNvGraphicFramePr>
            <a:graphicFrameLocks noGrp="1"/>
          </p:cNvGraphicFramePr>
          <p:nvPr>
            <p:extLst>
              <p:ext uri="{D42A27DB-BD31-4B8C-83A1-F6EECF244321}">
                <p14:modId xmlns:p14="http://schemas.microsoft.com/office/powerpoint/2010/main" xmlns="" val="2824836870"/>
              </p:ext>
            </p:extLst>
          </p:nvPr>
        </p:nvGraphicFramePr>
        <p:xfrm>
          <a:off x="4714758" y="1746174"/>
          <a:ext cx="2009996" cy="356972"/>
        </p:xfrm>
        <a:graphic>
          <a:graphicData uri="http://schemas.openxmlformats.org/drawingml/2006/table">
            <a:tbl>
              <a:tblPr>
                <a:tableStyleId>{2D5ABB26-0587-4C30-8999-92F81FD0307C}</a:tableStyleId>
              </a:tblPr>
              <a:tblGrid>
                <a:gridCol w="281804">
                  <a:extLst>
                    <a:ext uri="{9D8B030D-6E8A-4147-A177-3AD203B41FA5}">
                      <a16:colId xmlns="" xmlns:a16="http://schemas.microsoft.com/office/drawing/2014/main" val="407198424"/>
                    </a:ext>
                  </a:extLst>
                </a:gridCol>
                <a:gridCol w="432048">
                  <a:extLst>
                    <a:ext uri="{9D8B030D-6E8A-4147-A177-3AD203B41FA5}">
                      <a16:colId xmlns="" xmlns:a16="http://schemas.microsoft.com/office/drawing/2014/main" val="3026516401"/>
                    </a:ext>
                  </a:extLst>
                </a:gridCol>
                <a:gridCol w="360040">
                  <a:extLst>
                    <a:ext uri="{9D8B030D-6E8A-4147-A177-3AD203B41FA5}">
                      <a16:colId xmlns="" xmlns:a16="http://schemas.microsoft.com/office/drawing/2014/main" val="3710803770"/>
                    </a:ext>
                  </a:extLst>
                </a:gridCol>
                <a:gridCol w="360040">
                  <a:extLst>
                    <a:ext uri="{9D8B030D-6E8A-4147-A177-3AD203B41FA5}">
                      <a16:colId xmlns="" xmlns:a16="http://schemas.microsoft.com/office/drawing/2014/main" val="882409696"/>
                    </a:ext>
                  </a:extLst>
                </a:gridCol>
                <a:gridCol w="576064">
                  <a:extLst>
                    <a:ext uri="{9D8B030D-6E8A-4147-A177-3AD203B41FA5}">
                      <a16:colId xmlns="" xmlns:a16="http://schemas.microsoft.com/office/drawing/2014/main" val="939334229"/>
                    </a:ext>
                  </a:extLst>
                </a:gridCol>
              </a:tblGrid>
              <a:tr h="356972">
                <a:tc>
                  <a:txBody>
                    <a:bodyPr/>
                    <a:lstStyle/>
                    <a:p>
                      <a:pPr algn="r" fontAlgn="b"/>
                      <a:r>
                        <a:rPr lang="en-CA" sz="800" u="none" strike="noStrike" dirty="0" smtClean="0">
                          <a:effectLst/>
                        </a:rPr>
                        <a:t>DMSO</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1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 + 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extLst>
                  <a:ext uri="{0D108BD9-81ED-4DB2-BD59-A6C34878D82A}">
                    <a16:rowId xmlns="" xmlns:a16="http://schemas.microsoft.com/office/drawing/2014/main" val="3172836226"/>
                  </a:ext>
                </a:extLst>
              </a:tr>
            </a:tbl>
          </a:graphicData>
        </a:graphic>
      </p:graphicFrame>
      <p:pic>
        <p:nvPicPr>
          <p:cNvPr id="9" name="Picture 8"/>
          <p:cNvPicPr>
            <a:picLocks noChangeAspect="1"/>
          </p:cNvPicPr>
          <p:nvPr/>
        </p:nvPicPr>
        <p:blipFill>
          <a:blip r:embed="rId10"/>
          <a:stretch>
            <a:fillRect/>
          </a:stretch>
        </p:blipFill>
        <p:spPr>
          <a:xfrm>
            <a:off x="7020272" y="3591056"/>
            <a:ext cx="1718574" cy="1152127"/>
          </a:xfrm>
          <a:prstGeom prst="rect">
            <a:avLst/>
          </a:prstGeom>
          <a:ln w="12700" cmpd="sng">
            <a:solidFill>
              <a:schemeClr val="tx1"/>
            </a:solidFill>
          </a:ln>
        </p:spPr>
      </p:pic>
      <p:pic>
        <p:nvPicPr>
          <p:cNvPr id="14" name="Picture 13"/>
          <p:cNvPicPr>
            <a:picLocks/>
          </p:cNvPicPr>
          <p:nvPr/>
        </p:nvPicPr>
        <p:blipFill>
          <a:blip r:embed="rId11"/>
          <a:stretch>
            <a:fillRect/>
          </a:stretch>
        </p:blipFill>
        <p:spPr>
          <a:xfrm>
            <a:off x="7014344" y="2101983"/>
            <a:ext cx="1728000" cy="1152000"/>
          </a:xfrm>
          <a:prstGeom prst="rect">
            <a:avLst/>
          </a:prstGeom>
          <a:ln w="12700" cmpd="sng">
            <a:solidFill>
              <a:srgbClr val="000000"/>
            </a:solidFill>
          </a:ln>
        </p:spPr>
      </p:pic>
      <p:pic>
        <p:nvPicPr>
          <p:cNvPr id="17" name="Picture 16"/>
          <p:cNvPicPr>
            <a:picLocks/>
          </p:cNvPicPr>
          <p:nvPr/>
        </p:nvPicPr>
        <p:blipFill>
          <a:blip r:embed="rId12"/>
          <a:stretch>
            <a:fillRect/>
          </a:stretch>
        </p:blipFill>
        <p:spPr>
          <a:xfrm>
            <a:off x="7010846" y="709752"/>
            <a:ext cx="1718182" cy="1152000"/>
          </a:xfrm>
          <a:prstGeom prst="rect">
            <a:avLst/>
          </a:prstGeom>
          <a:ln w="12700" cmpd="sng">
            <a:solidFill>
              <a:schemeClr val="tx1"/>
            </a:solidFill>
          </a:ln>
        </p:spPr>
      </p:pic>
      <p:sp>
        <p:nvSpPr>
          <p:cNvPr id="36" name="TextBox 35"/>
          <p:cNvSpPr txBox="1"/>
          <p:nvPr/>
        </p:nvSpPr>
        <p:spPr>
          <a:xfrm>
            <a:off x="7275752" y="6137290"/>
            <a:ext cx="1224136" cy="215444"/>
          </a:xfrm>
          <a:prstGeom prst="rect">
            <a:avLst/>
          </a:prstGeom>
          <a:noFill/>
        </p:spPr>
        <p:txBody>
          <a:bodyPr wrap="square" rtlCol="0">
            <a:spAutoFit/>
          </a:bodyPr>
          <a:lstStyle/>
          <a:p>
            <a:r>
              <a:rPr lang="en-US" sz="800" dirty="0" err="1" smtClean="0"/>
              <a:t>Erl</a:t>
            </a:r>
            <a:r>
              <a:rPr lang="en-US" sz="800" dirty="0" smtClean="0"/>
              <a:t> 2.5µM + </a:t>
            </a:r>
            <a:r>
              <a:rPr lang="en-US" sz="800" dirty="0" err="1" smtClean="0"/>
              <a:t>Tra</a:t>
            </a:r>
            <a:r>
              <a:rPr lang="en-US" sz="800" dirty="0" smtClean="0"/>
              <a:t> 0.05µM</a:t>
            </a:r>
            <a:endParaRPr lang="en-US" sz="800" dirty="0"/>
          </a:p>
        </p:txBody>
      </p:sp>
      <p:sp>
        <p:nvSpPr>
          <p:cNvPr id="37" name="TextBox 36"/>
          <p:cNvSpPr txBox="1"/>
          <p:nvPr/>
        </p:nvSpPr>
        <p:spPr>
          <a:xfrm>
            <a:off x="7275752" y="4725144"/>
            <a:ext cx="1224136" cy="215444"/>
          </a:xfrm>
          <a:prstGeom prst="rect">
            <a:avLst/>
          </a:prstGeom>
          <a:noFill/>
        </p:spPr>
        <p:txBody>
          <a:bodyPr wrap="square" rtlCol="0">
            <a:spAutoFit/>
          </a:bodyPr>
          <a:lstStyle/>
          <a:p>
            <a:r>
              <a:rPr lang="en-US" sz="800" dirty="0" err="1" smtClean="0"/>
              <a:t>Erl</a:t>
            </a:r>
            <a:r>
              <a:rPr lang="en-US" sz="800" dirty="0" smtClean="0"/>
              <a:t> 2.5µM + </a:t>
            </a:r>
            <a:r>
              <a:rPr lang="en-US" sz="800" dirty="0" err="1" smtClean="0"/>
              <a:t>Tra</a:t>
            </a:r>
            <a:r>
              <a:rPr lang="en-US" sz="800" dirty="0" smtClean="0"/>
              <a:t> 0.05µM</a:t>
            </a:r>
            <a:endParaRPr lang="en-US" sz="800" dirty="0"/>
          </a:p>
        </p:txBody>
      </p:sp>
      <p:sp>
        <p:nvSpPr>
          <p:cNvPr id="38" name="TextBox 37"/>
          <p:cNvSpPr txBox="1"/>
          <p:nvPr/>
        </p:nvSpPr>
        <p:spPr>
          <a:xfrm>
            <a:off x="7279250" y="3234105"/>
            <a:ext cx="1224136" cy="215444"/>
          </a:xfrm>
          <a:prstGeom prst="rect">
            <a:avLst/>
          </a:prstGeom>
          <a:noFill/>
        </p:spPr>
        <p:txBody>
          <a:bodyPr wrap="square" rtlCol="0">
            <a:spAutoFit/>
          </a:bodyPr>
          <a:lstStyle/>
          <a:p>
            <a:r>
              <a:rPr lang="en-US" sz="800" dirty="0" err="1" smtClean="0"/>
              <a:t>Erl</a:t>
            </a:r>
            <a:r>
              <a:rPr lang="en-US" sz="800" dirty="0" smtClean="0"/>
              <a:t> 2.5µM + </a:t>
            </a:r>
            <a:r>
              <a:rPr lang="en-US" sz="800" dirty="0" err="1" smtClean="0"/>
              <a:t>Tra</a:t>
            </a:r>
            <a:r>
              <a:rPr lang="en-US" sz="800" dirty="0" smtClean="0"/>
              <a:t> 0.05µM</a:t>
            </a:r>
            <a:endParaRPr lang="en-US" sz="800" dirty="0"/>
          </a:p>
        </p:txBody>
      </p:sp>
      <p:sp>
        <p:nvSpPr>
          <p:cNvPr id="39" name="TextBox 38"/>
          <p:cNvSpPr txBox="1"/>
          <p:nvPr/>
        </p:nvSpPr>
        <p:spPr>
          <a:xfrm>
            <a:off x="7275752" y="1839276"/>
            <a:ext cx="1224136" cy="215444"/>
          </a:xfrm>
          <a:prstGeom prst="rect">
            <a:avLst/>
          </a:prstGeom>
          <a:noFill/>
        </p:spPr>
        <p:txBody>
          <a:bodyPr wrap="square" rtlCol="0">
            <a:spAutoFit/>
          </a:bodyPr>
          <a:lstStyle/>
          <a:p>
            <a:r>
              <a:rPr lang="en-US" sz="800" dirty="0" err="1" smtClean="0"/>
              <a:t>Erl</a:t>
            </a:r>
            <a:r>
              <a:rPr lang="en-US" sz="800" dirty="0" smtClean="0"/>
              <a:t> 2.5µM + </a:t>
            </a:r>
            <a:r>
              <a:rPr lang="en-US" sz="800" dirty="0" err="1" smtClean="0"/>
              <a:t>Tra</a:t>
            </a:r>
            <a:r>
              <a:rPr lang="en-US" sz="800" dirty="0" smtClean="0"/>
              <a:t> 0.05µM</a:t>
            </a:r>
            <a:endParaRPr lang="en-US" sz="800" dirty="0"/>
          </a:p>
        </p:txBody>
      </p:sp>
      <p:sp>
        <p:nvSpPr>
          <p:cNvPr id="40" name="TextBox 39"/>
          <p:cNvSpPr txBox="1"/>
          <p:nvPr/>
        </p:nvSpPr>
        <p:spPr>
          <a:xfrm>
            <a:off x="6633754" y="523367"/>
            <a:ext cx="314510" cy="369332"/>
          </a:xfrm>
          <a:prstGeom prst="rect">
            <a:avLst/>
          </a:prstGeom>
          <a:noFill/>
        </p:spPr>
        <p:txBody>
          <a:bodyPr wrap="none" rtlCol="0">
            <a:spAutoFit/>
          </a:bodyPr>
          <a:lstStyle/>
          <a:p>
            <a:r>
              <a:rPr lang="en-US" b="1" dirty="0" smtClean="0"/>
              <a:t>C</a:t>
            </a:r>
            <a:endParaRPr lang="en-US" b="1" dirty="0"/>
          </a:p>
        </p:txBody>
      </p:sp>
      <p:sp>
        <p:nvSpPr>
          <p:cNvPr id="32" name="TextBox 31">
            <a:extLst>
              <a:ext uri="{FF2B5EF4-FFF2-40B4-BE49-F238E27FC236}">
                <a16:creationId xmlns="" xmlns:a16="http://schemas.microsoft.com/office/drawing/2014/main" id="{1561971E-EECA-4AEF-9A6F-48D03B80CDD4}"/>
              </a:ext>
            </a:extLst>
          </p:cNvPr>
          <p:cNvSpPr txBox="1"/>
          <p:nvPr/>
        </p:nvSpPr>
        <p:spPr>
          <a:xfrm>
            <a:off x="4997" y="0"/>
            <a:ext cx="9139003" cy="646331"/>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smtClean="0"/>
              <a:t>Figure </a:t>
            </a:r>
            <a:r>
              <a:rPr lang="en-US" sz="1200" b="1" smtClean="0"/>
              <a:t>S2</a:t>
            </a:r>
            <a:r>
              <a:rPr lang="en-US" sz="1200" b="1" dirty="0"/>
              <a:t>. </a:t>
            </a:r>
            <a:r>
              <a:rPr lang="en-US" sz="1200" dirty="0"/>
              <a:t>Effects of </a:t>
            </a:r>
            <a:r>
              <a:rPr lang="en-US" sz="1200" dirty="0" err="1"/>
              <a:t>trametinib</a:t>
            </a:r>
            <a:r>
              <a:rPr lang="en-US" sz="1200" dirty="0"/>
              <a:t> and </a:t>
            </a:r>
            <a:r>
              <a:rPr lang="en-US" sz="1200" dirty="0" err="1"/>
              <a:t>erlotinib</a:t>
            </a:r>
            <a:r>
              <a:rPr lang="en-US" sz="1200" dirty="0"/>
              <a:t> single and combined drug treatments in four </a:t>
            </a:r>
            <a:r>
              <a:rPr lang="en-US" sz="1200" dirty="0" err="1"/>
              <a:t>MEKi</a:t>
            </a:r>
            <a:r>
              <a:rPr lang="en-US" sz="1200" dirty="0"/>
              <a:t>-Re LGSC cell lines. The graphed curves represent the results from the proliferation experiments and the bar graphs represent the results from the viability (MTS and CV) assays performed at the end of the proliferation experiments. </a:t>
            </a:r>
          </a:p>
        </p:txBody>
      </p:sp>
      <p:sp>
        <p:nvSpPr>
          <p:cNvPr id="45" name="Right Bracket 44"/>
          <p:cNvSpPr/>
          <p:nvPr/>
        </p:nvSpPr>
        <p:spPr>
          <a:xfrm rot="16200000">
            <a:off x="5994179" y="835779"/>
            <a:ext cx="144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aphicFrame>
        <p:nvGraphicFramePr>
          <p:cNvPr id="62" name="Table 61">
            <a:extLst>
              <a:ext uri="{FF2B5EF4-FFF2-40B4-BE49-F238E27FC236}">
                <a16:creationId xmlns="" xmlns:a16="http://schemas.microsoft.com/office/drawing/2014/main" id="{725EAA19-CC36-A544-9DF6-B47E125E6048}"/>
              </a:ext>
            </a:extLst>
          </p:cNvPr>
          <p:cNvGraphicFramePr>
            <a:graphicFrameLocks noGrp="1"/>
          </p:cNvGraphicFramePr>
          <p:nvPr>
            <p:extLst>
              <p:ext uri="{D42A27DB-BD31-4B8C-83A1-F6EECF244321}">
                <p14:modId xmlns:p14="http://schemas.microsoft.com/office/powerpoint/2010/main" xmlns="" val="2944596549"/>
              </p:ext>
            </p:extLst>
          </p:nvPr>
        </p:nvGraphicFramePr>
        <p:xfrm>
          <a:off x="4714758" y="3216044"/>
          <a:ext cx="2009996" cy="356972"/>
        </p:xfrm>
        <a:graphic>
          <a:graphicData uri="http://schemas.openxmlformats.org/drawingml/2006/table">
            <a:tbl>
              <a:tblPr>
                <a:tableStyleId>{2D5ABB26-0587-4C30-8999-92F81FD0307C}</a:tableStyleId>
              </a:tblPr>
              <a:tblGrid>
                <a:gridCol w="281804">
                  <a:extLst>
                    <a:ext uri="{9D8B030D-6E8A-4147-A177-3AD203B41FA5}">
                      <a16:colId xmlns="" xmlns:a16="http://schemas.microsoft.com/office/drawing/2014/main" val="407198424"/>
                    </a:ext>
                  </a:extLst>
                </a:gridCol>
                <a:gridCol w="432048">
                  <a:extLst>
                    <a:ext uri="{9D8B030D-6E8A-4147-A177-3AD203B41FA5}">
                      <a16:colId xmlns="" xmlns:a16="http://schemas.microsoft.com/office/drawing/2014/main" val="3026516401"/>
                    </a:ext>
                  </a:extLst>
                </a:gridCol>
                <a:gridCol w="360040">
                  <a:extLst>
                    <a:ext uri="{9D8B030D-6E8A-4147-A177-3AD203B41FA5}">
                      <a16:colId xmlns="" xmlns:a16="http://schemas.microsoft.com/office/drawing/2014/main" val="3710803770"/>
                    </a:ext>
                  </a:extLst>
                </a:gridCol>
                <a:gridCol w="360040">
                  <a:extLst>
                    <a:ext uri="{9D8B030D-6E8A-4147-A177-3AD203B41FA5}">
                      <a16:colId xmlns="" xmlns:a16="http://schemas.microsoft.com/office/drawing/2014/main" val="882409696"/>
                    </a:ext>
                  </a:extLst>
                </a:gridCol>
                <a:gridCol w="576064">
                  <a:extLst>
                    <a:ext uri="{9D8B030D-6E8A-4147-A177-3AD203B41FA5}">
                      <a16:colId xmlns="" xmlns:a16="http://schemas.microsoft.com/office/drawing/2014/main" val="939334229"/>
                    </a:ext>
                  </a:extLst>
                </a:gridCol>
              </a:tblGrid>
              <a:tr h="356972">
                <a:tc>
                  <a:txBody>
                    <a:bodyPr/>
                    <a:lstStyle/>
                    <a:p>
                      <a:pPr algn="r" fontAlgn="b"/>
                      <a:r>
                        <a:rPr lang="en-CA" sz="800" u="none" strike="noStrike" dirty="0" smtClean="0">
                          <a:effectLst/>
                        </a:rPr>
                        <a:t>DMSO</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1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 + 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extLst>
                  <a:ext uri="{0D108BD9-81ED-4DB2-BD59-A6C34878D82A}">
                    <a16:rowId xmlns="" xmlns:a16="http://schemas.microsoft.com/office/drawing/2014/main" val="3172836226"/>
                  </a:ext>
                </a:extLst>
              </a:tr>
            </a:tbl>
          </a:graphicData>
        </a:graphic>
      </p:graphicFrame>
      <p:graphicFrame>
        <p:nvGraphicFramePr>
          <p:cNvPr id="63" name="Table 62">
            <a:extLst>
              <a:ext uri="{FF2B5EF4-FFF2-40B4-BE49-F238E27FC236}">
                <a16:creationId xmlns="" xmlns:a16="http://schemas.microsoft.com/office/drawing/2014/main" id="{725EAA19-CC36-A544-9DF6-B47E125E6048}"/>
              </a:ext>
            </a:extLst>
          </p:cNvPr>
          <p:cNvGraphicFramePr>
            <a:graphicFrameLocks noGrp="1"/>
          </p:cNvGraphicFramePr>
          <p:nvPr>
            <p:extLst>
              <p:ext uri="{D42A27DB-BD31-4B8C-83A1-F6EECF244321}">
                <p14:modId xmlns:p14="http://schemas.microsoft.com/office/powerpoint/2010/main" xmlns="" val="2818678799"/>
              </p:ext>
            </p:extLst>
          </p:nvPr>
        </p:nvGraphicFramePr>
        <p:xfrm>
          <a:off x="4714758" y="4656204"/>
          <a:ext cx="2009996" cy="356972"/>
        </p:xfrm>
        <a:graphic>
          <a:graphicData uri="http://schemas.openxmlformats.org/drawingml/2006/table">
            <a:tbl>
              <a:tblPr>
                <a:tableStyleId>{2D5ABB26-0587-4C30-8999-92F81FD0307C}</a:tableStyleId>
              </a:tblPr>
              <a:tblGrid>
                <a:gridCol w="281804">
                  <a:extLst>
                    <a:ext uri="{9D8B030D-6E8A-4147-A177-3AD203B41FA5}">
                      <a16:colId xmlns="" xmlns:a16="http://schemas.microsoft.com/office/drawing/2014/main" val="407198424"/>
                    </a:ext>
                  </a:extLst>
                </a:gridCol>
                <a:gridCol w="432048">
                  <a:extLst>
                    <a:ext uri="{9D8B030D-6E8A-4147-A177-3AD203B41FA5}">
                      <a16:colId xmlns="" xmlns:a16="http://schemas.microsoft.com/office/drawing/2014/main" val="3026516401"/>
                    </a:ext>
                  </a:extLst>
                </a:gridCol>
                <a:gridCol w="360040">
                  <a:extLst>
                    <a:ext uri="{9D8B030D-6E8A-4147-A177-3AD203B41FA5}">
                      <a16:colId xmlns="" xmlns:a16="http://schemas.microsoft.com/office/drawing/2014/main" val="3710803770"/>
                    </a:ext>
                  </a:extLst>
                </a:gridCol>
                <a:gridCol w="360040">
                  <a:extLst>
                    <a:ext uri="{9D8B030D-6E8A-4147-A177-3AD203B41FA5}">
                      <a16:colId xmlns="" xmlns:a16="http://schemas.microsoft.com/office/drawing/2014/main" val="882409696"/>
                    </a:ext>
                  </a:extLst>
                </a:gridCol>
                <a:gridCol w="576064">
                  <a:extLst>
                    <a:ext uri="{9D8B030D-6E8A-4147-A177-3AD203B41FA5}">
                      <a16:colId xmlns="" xmlns:a16="http://schemas.microsoft.com/office/drawing/2014/main" val="939334229"/>
                    </a:ext>
                  </a:extLst>
                </a:gridCol>
              </a:tblGrid>
              <a:tr h="356972">
                <a:tc>
                  <a:txBody>
                    <a:bodyPr/>
                    <a:lstStyle/>
                    <a:p>
                      <a:pPr algn="r" fontAlgn="b"/>
                      <a:r>
                        <a:rPr lang="en-CA" sz="800" u="none" strike="noStrike" dirty="0" smtClean="0">
                          <a:effectLst/>
                        </a:rPr>
                        <a:t>DMSO</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1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 + 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extLst>
                  <a:ext uri="{0D108BD9-81ED-4DB2-BD59-A6C34878D82A}">
                    <a16:rowId xmlns="" xmlns:a16="http://schemas.microsoft.com/office/drawing/2014/main" val="3172836226"/>
                  </a:ext>
                </a:extLst>
              </a:tr>
            </a:tbl>
          </a:graphicData>
        </a:graphic>
      </p:graphicFrame>
      <p:graphicFrame>
        <p:nvGraphicFramePr>
          <p:cNvPr id="64" name="Table 63">
            <a:extLst>
              <a:ext uri="{FF2B5EF4-FFF2-40B4-BE49-F238E27FC236}">
                <a16:creationId xmlns="" xmlns:a16="http://schemas.microsoft.com/office/drawing/2014/main" id="{725EAA19-CC36-A544-9DF6-B47E125E6048}"/>
              </a:ext>
            </a:extLst>
          </p:cNvPr>
          <p:cNvGraphicFramePr>
            <a:graphicFrameLocks noGrp="1"/>
          </p:cNvGraphicFramePr>
          <p:nvPr>
            <p:extLst>
              <p:ext uri="{D42A27DB-BD31-4B8C-83A1-F6EECF244321}">
                <p14:modId xmlns:p14="http://schemas.microsoft.com/office/powerpoint/2010/main" xmlns="" val="3178059922"/>
              </p:ext>
            </p:extLst>
          </p:nvPr>
        </p:nvGraphicFramePr>
        <p:xfrm>
          <a:off x="4714758" y="6041896"/>
          <a:ext cx="2009996" cy="356972"/>
        </p:xfrm>
        <a:graphic>
          <a:graphicData uri="http://schemas.openxmlformats.org/drawingml/2006/table">
            <a:tbl>
              <a:tblPr>
                <a:tableStyleId>{2D5ABB26-0587-4C30-8999-92F81FD0307C}</a:tableStyleId>
              </a:tblPr>
              <a:tblGrid>
                <a:gridCol w="281804">
                  <a:extLst>
                    <a:ext uri="{9D8B030D-6E8A-4147-A177-3AD203B41FA5}">
                      <a16:colId xmlns="" xmlns:a16="http://schemas.microsoft.com/office/drawing/2014/main" val="407198424"/>
                    </a:ext>
                  </a:extLst>
                </a:gridCol>
                <a:gridCol w="432048">
                  <a:extLst>
                    <a:ext uri="{9D8B030D-6E8A-4147-A177-3AD203B41FA5}">
                      <a16:colId xmlns="" xmlns:a16="http://schemas.microsoft.com/office/drawing/2014/main" val="3026516401"/>
                    </a:ext>
                  </a:extLst>
                </a:gridCol>
                <a:gridCol w="360040">
                  <a:extLst>
                    <a:ext uri="{9D8B030D-6E8A-4147-A177-3AD203B41FA5}">
                      <a16:colId xmlns="" xmlns:a16="http://schemas.microsoft.com/office/drawing/2014/main" val="3710803770"/>
                    </a:ext>
                  </a:extLst>
                </a:gridCol>
                <a:gridCol w="360040">
                  <a:extLst>
                    <a:ext uri="{9D8B030D-6E8A-4147-A177-3AD203B41FA5}">
                      <a16:colId xmlns="" xmlns:a16="http://schemas.microsoft.com/office/drawing/2014/main" val="882409696"/>
                    </a:ext>
                  </a:extLst>
                </a:gridCol>
                <a:gridCol w="576064">
                  <a:extLst>
                    <a:ext uri="{9D8B030D-6E8A-4147-A177-3AD203B41FA5}">
                      <a16:colId xmlns="" xmlns:a16="http://schemas.microsoft.com/office/drawing/2014/main" val="939334229"/>
                    </a:ext>
                  </a:extLst>
                </a:gridCol>
              </a:tblGrid>
              <a:tr h="356972">
                <a:tc>
                  <a:txBody>
                    <a:bodyPr/>
                    <a:lstStyle/>
                    <a:p>
                      <a:pPr algn="r" fontAlgn="b"/>
                      <a:r>
                        <a:rPr lang="en-CA" sz="800" u="none" strike="noStrike" dirty="0" smtClean="0">
                          <a:effectLst/>
                        </a:rPr>
                        <a:t>DMSO</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1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tc>
                  <a:txBody>
                    <a:bodyPr/>
                    <a:lstStyle/>
                    <a:p>
                      <a:pPr algn="r" fontAlgn="b"/>
                      <a:r>
                        <a:rPr lang="en-CA" sz="800" u="none" strike="noStrike" dirty="0">
                          <a:effectLst/>
                        </a:rPr>
                        <a:t>Erl 2.5µM + Tra 0.05µM</a:t>
                      </a:r>
                      <a:endParaRPr lang="en-CA" sz="800" b="0" i="0" u="none" strike="noStrike" dirty="0">
                        <a:solidFill>
                          <a:srgbClr val="000000"/>
                        </a:solidFill>
                        <a:effectLst/>
                        <a:latin typeface="Calibri" panose="020F0502020204030204" pitchFamily="34" charset="0"/>
                      </a:endParaRPr>
                    </a:p>
                  </a:txBody>
                  <a:tcPr marL="9525" marR="9525" marT="9525" marB="0" vert="vert270" anchor="b"/>
                </a:tc>
                <a:extLst>
                  <a:ext uri="{0D108BD9-81ED-4DB2-BD59-A6C34878D82A}">
                    <a16:rowId xmlns="" xmlns:a16="http://schemas.microsoft.com/office/drawing/2014/main" val="3172836226"/>
                  </a:ext>
                </a:extLst>
              </a:tr>
            </a:tbl>
          </a:graphicData>
        </a:graphic>
      </p:graphicFrame>
      <p:pic>
        <p:nvPicPr>
          <p:cNvPr id="65" name="Picture 64"/>
          <p:cNvPicPr>
            <a:picLocks noChangeAspect="1"/>
          </p:cNvPicPr>
          <p:nvPr/>
        </p:nvPicPr>
        <p:blipFill rotWithShape="1">
          <a:blip r:embed="rId13"/>
          <a:srcRect l="2782" t="9602"/>
          <a:stretch/>
        </p:blipFill>
        <p:spPr>
          <a:xfrm>
            <a:off x="7020272" y="5013176"/>
            <a:ext cx="1718574" cy="1139001"/>
          </a:xfrm>
          <a:prstGeom prst="rect">
            <a:avLst/>
          </a:prstGeom>
          <a:ln w="12700" cmpd="sng">
            <a:solidFill>
              <a:schemeClr val="tx1"/>
            </a:solidFill>
          </a:ln>
        </p:spPr>
      </p:pic>
      <p:grpSp>
        <p:nvGrpSpPr>
          <p:cNvPr id="77" name="Group 76"/>
          <p:cNvGrpSpPr/>
          <p:nvPr/>
        </p:nvGrpSpPr>
        <p:grpSpPr>
          <a:xfrm>
            <a:off x="5652120" y="5400064"/>
            <a:ext cx="756086" cy="216039"/>
            <a:chOff x="5868144" y="-675456"/>
            <a:chExt cx="360041" cy="216039"/>
          </a:xfrm>
        </p:grpSpPr>
        <p:cxnSp>
          <p:nvCxnSpPr>
            <p:cNvPr id="78" name="Straight Connector 77"/>
            <p:cNvCxnSpPr/>
            <p:nvPr/>
          </p:nvCxnSpPr>
          <p:spPr>
            <a:xfrm>
              <a:off x="5868144" y="-675456"/>
              <a:ext cx="360040" cy="0"/>
            </a:xfrm>
            <a:prstGeom prst="line">
              <a:avLst/>
            </a:prstGeom>
          </p:spPr>
          <p:style>
            <a:lnRef idx="1">
              <a:schemeClr val="dk1"/>
            </a:lnRef>
            <a:fillRef idx="0">
              <a:schemeClr val="dk1"/>
            </a:fillRef>
            <a:effectRef idx="0">
              <a:schemeClr val="dk1"/>
            </a:effectRef>
            <a:fontRef idx="minor">
              <a:schemeClr val="tx1"/>
            </a:fontRef>
          </p:style>
        </p:cxnSp>
        <p:cxnSp>
          <p:nvCxnSpPr>
            <p:cNvPr id="79" name="Straight Connector 78"/>
            <p:cNvCxnSpPr/>
            <p:nvPr/>
          </p:nvCxnSpPr>
          <p:spPr>
            <a:xfrm rot="5400000">
              <a:off x="6174167" y="-621436"/>
              <a:ext cx="108035" cy="0"/>
            </a:xfrm>
            <a:prstGeom prst="line">
              <a:avLst/>
            </a:prstGeom>
          </p:spPr>
          <p:style>
            <a:lnRef idx="1">
              <a:schemeClr val="dk1"/>
            </a:lnRef>
            <a:fillRef idx="0">
              <a:schemeClr val="dk1"/>
            </a:fillRef>
            <a:effectRef idx="0">
              <a:schemeClr val="dk1"/>
            </a:effectRef>
            <a:fontRef idx="minor">
              <a:schemeClr val="tx1"/>
            </a:fontRef>
          </p:style>
        </p:cxnSp>
        <p:cxnSp>
          <p:nvCxnSpPr>
            <p:cNvPr id="80" name="Straight Connector 79"/>
            <p:cNvCxnSpPr/>
            <p:nvPr/>
          </p:nvCxnSpPr>
          <p:spPr>
            <a:xfrm rot="5400000">
              <a:off x="5760125" y="-567436"/>
              <a:ext cx="216038" cy="0"/>
            </a:xfrm>
            <a:prstGeom prst="line">
              <a:avLst/>
            </a:prstGeom>
          </p:spPr>
          <p:style>
            <a:lnRef idx="1">
              <a:schemeClr val="dk1"/>
            </a:lnRef>
            <a:fillRef idx="0">
              <a:schemeClr val="dk1"/>
            </a:fillRef>
            <a:effectRef idx="0">
              <a:schemeClr val="dk1"/>
            </a:effectRef>
            <a:fontRef idx="minor">
              <a:schemeClr val="tx1"/>
            </a:fontRef>
          </p:style>
        </p:cxnSp>
      </p:grpSp>
      <p:grpSp>
        <p:nvGrpSpPr>
          <p:cNvPr id="81" name="Group 80"/>
          <p:cNvGrpSpPr/>
          <p:nvPr/>
        </p:nvGrpSpPr>
        <p:grpSpPr>
          <a:xfrm>
            <a:off x="5760134" y="5560631"/>
            <a:ext cx="756086" cy="216039"/>
            <a:chOff x="5868144" y="-675456"/>
            <a:chExt cx="360041" cy="216039"/>
          </a:xfrm>
        </p:grpSpPr>
        <p:cxnSp>
          <p:nvCxnSpPr>
            <p:cNvPr id="82" name="Straight Connector 81"/>
            <p:cNvCxnSpPr/>
            <p:nvPr/>
          </p:nvCxnSpPr>
          <p:spPr>
            <a:xfrm>
              <a:off x="5868144" y="-675456"/>
              <a:ext cx="360040" cy="0"/>
            </a:xfrm>
            <a:prstGeom prst="line">
              <a:avLst/>
            </a:prstGeom>
          </p:spPr>
          <p:style>
            <a:lnRef idx="1">
              <a:schemeClr val="dk1"/>
            </a:lnRef>
            <a:fillRef idx="0">
              <a:schemeClr val="dk1"/>
            </a:fillRef>
            <a:effectRef idx="0">
              <a:schemeClr val="dk1"/>
            </a:effectRef>
            <a:fontRef idx="minor">
              <a:schemeClr val="tx1"/>
            </a:fontRef>
          </p:style>
        </p:cxnSp>
        <p:cxnSp>
          <p:nvCxnSpPr>
            <p:cNvPr id="83" name="Straight Connector 82"/>
            <p:cNvCxnSpPr/>
            <p:nvPr/>
          </p:nvCxnSpPr>
          <p:spPr>
            <a:xfrm rot="5400000">
              <a:off x="6174167" y="-621436"/>
              <a:ext cx="108035" cy="0"/>
            </a:xfrm>
            <a:prstGeom prst="line">
              <a:avLst/>
            </a:prstGeom>
          </p:spPr>
          <p:style>
            <a:lnRef idx="1">
              <a:schemeClr val="dk1"/>
            </a:lnRef>
            <a:fillRef idx="0">
              <a:schemeClr val="dk1"/>
            </a:fillRef>
            <a:effectRef idx="0">
              <a:schemeClr val="dk1"/>
            </a:effectRef>
            <a:fontRef idx="minor">
              <a:schemeClr val="tx1"/>
            </a:fontRef>
          </p:style>
        </p:cxnSp>
        <p:cxnSp>
          <p:nvCxnSpPr>
            <p:cNvPr id="84" name="Straight Connector 83"/>
            <p:cNvCxnSpPr/>
            <p:nvPr/>
          </p:nvCxnSpPr>
          <p:spPr>
            <a:xfrm rot="5400000">
              <a:off x="5760125" y="-567436"/>
              <a:ext cx="216038" cy="0"/>
            </a:xfrm>
            <a:prstGeom prst="line">
              <a:avLst/>
            </a:prstGeom>
          </p:spPr>
          <p:style>
            <a:lnRef idx="1">
              <a:schemeClr val="dk1"/>
            </a:lnRef>
            <a:fillRef idx="0">
              <a:schemeClr val="dk1"/>
            </a:fillRef>
            <a:effectRef idx="0">
              <a:schemeClr val="dk1"/>
            </a:effectRef>
            <a:fontRef idx="minor">
              <a:schemeClr val="tx1"/>
            </a:fontRef>
          </p:style>
        </p:cxnSp>
      </p:grpSp>
      <p:sp>
        <p:nvSpPr>
          <p:cNvPr id="53" name="TextBox 52"/>
          <p:cNvSpPr txBox="1"/>
          <p:nvPr/>
        </p:nvSpPr>
        <p:spPr>
          <a:xfrm>
            <a:off x="5937293" y="925776"/>
            <a:ext cx="254923" cy="261610"/>
          </a:xfrm>
          <a:prstGeom prst="rect">
            <a:avLst/>
          </a:prstGeom>
          <a:noFill/>
        </p:spPr>
        <p:txBody>
          <a:bodyPr wrap="none" rtlCol="0">
            <a:spAutoFit/>
          </a:bodyPr>
          <a:lstStyle/>
          <a:p>
            <a:r>
              <a:rPr lang="en-US" sz="1050" dirty="0" smtClean="0"/>
              <a:t>§</a:t>
            </a:r>
            <a:endParaRPr lang="en-US" sz="1050" dirty="0"/>
          </a:p>
        </p:txBody>
      </p:sp>
      <p:sp>
        <p:nvSpPr>
          <p:cNvPr id="67" name="TextBox 66"/>
          <p:cNvSpPr txBox="1"/>
          <p:nvPr/>
        </p:nvSpPr>
        <p:spPr>
          <a:xfrm>
            <a:off x="6832259" y="6381328"/>
            <a:ext cx="2311741" cy="461665"/>
          </a:xfrm>
          <a:prstGeom prst="rect">
            <a:avLst/>
          </a:prstGeom>
          <a:noFill/>
        </p:spPr>
        <p:txBody>
          <a:bodyPr wrap="square" rtlCol="0">
            <a:spAutoFit/>
          </a:bodyPr>
          <a:lstStyle/>
          <a:p>
            <a:r>
              <a:rPr lang="en-US" sz="800" dirty="0" smtClean="0">
                <a:latin typeface="Arial"/>
                <a:cs typeface="Arial"/>
              </a:rPr>
              <a:t>(*) Statistically significant, p&lt;0.05</a:t>
            </a:r>
          </a:p>
          <a:p>
            <a:r>
              <a:rPr lang="en-US" sz="800" dirty="0" smtClean="0">
                <a:latin typeface="Arial"/>
                <a:cs typeface="Arial"/>
              </a:rPr>
              <a:t>(</a:t>
            </a:r>
            <a:r>
              <a:rPr lang="en-US" sz="800" dirty="0" smtClean="0">
                <a:solidFill>
                  <a:srgbClr val="000000"/>
                </a:solidFill>
              </a:rPr>
              <a:t>¶</a:t>
            </a:r>
            <a:r>
              <a:rPr lang="en-US" sz="800" dirty="0" smtClean="0">
                <a:latin typeface="Arial"/>
                <a:cs typeface="Arial"/>
              </a:rPr>
              <a:t>) </a:t>
            </a:r>
            <a:r>
              <a:rPr lang="en-US" sz="800" dirty="0">
                <a:latin typeface="Arial"/>
                <a:cs typeface="Arial"/>
              </a:rPr>
              <a:t>Statistically significant, </a:t>
            </a:r>
            <a:r>
              <a:rPr lang="en-US" sz="800" dirty="0" smtClean="0">
                <a:latin typeface="Arial"/>
                <a:cs typeface="Arial"/>
              </a:rPr>
              <a:t>cell debris detected</a:t>
            </a:r>
          </a:p>
          <a:p>
            <a:pPr lvl="0"/>
            <a:r>
              <a:rPr lang="en-US" sz="800" dirty="0">
                <a:latin typeface="Arial"/>
                <a:cs typeface="Arial"/>
              </a:rPr>
              <a:t>(</a:t>
            </a:r>
            <a:r>
              <a:rPr lang="en-US" sz="800" dirty="0">
                <a:solidFill>
                  <a:srgbClr val="000000"/>
                </a:solidFill>
                <a:latin typeface="Arial"/>
                <a:cs typeface="Arial"/>
              </a:rPr>
              <a:t>§</a:t>
            </a:r>
            <a:r>
              <a:rPr lang="en-US" sz="800" dirty="0">
                <a:latin typeface="Arial"/>
                <a:cs typeface="Arial"/>
              </a:rPr>
              <a:t>) Non-</a:t>
            </a:r>
            <a:r>
              <a:rPr lang="en-US" sz="800" dirty="0" smtClean="0">
                <a:latin typeface="Arial"/>
                <a:cs typeface="Arial"/>
              </a:rPr>
              <a:t>significant</a:t>
            </a:r>
            <a:endParaRPr lang="en-US" sz="800" dirty="0">
              <a:latin typeface="Arial"/>
              <a:cs typeface="Arial"/>
            </a:endParaRPr>
          </a:p>
        </p:txBody>
      </p:sp>
      <p:sp>
        <p:nvSpPr>
          <p:cNvPr id="68" name="TextBox 67"/>
          <p:cNvSpPr txBox="1"/>
          <p:nvPr/>
        </p:nvSpPr>
        <p:spPr>
          <a:xfrm>
            <a:off x="5808421" y="1133791"/>
            <a:ext cx="574647" cy="215444"/>
          </a:xfrm>
          <a:prstGeom prst="rect">
            <a:avLst/>
          </a:prstGeom>
          <a:noFill/>
        </p:spPr>
        <p:txBody>
          <a:bodyPr wrap="none" rtlCol="0">
            <a:spAutoFit/>
          </a:bodyPr>
          <a:lstStyle>
            <a:defPPr>
              <a:defRPr lang="en-US"/>
            </a:defPPr>
            <a:lvl1pPr>
              <a:defRPr sz="800"/>
            </a:lvl1pPr>
          </a:lstStyle>
          <a:p>
            <a:r>
              <a:rPr lang="en-US" dirty="0"/>
              <a:t>*p</a:t>
            </a:r>
            <a:r>
              <a:rPr lang="en-US" dirty="0" smtClean="0"/>
              <a:t>=0.002</a:t>
            </a:r>
            <a:endParaRPr lang="en-US" dirty="0"/>
          </a:p>
        </p:txBody>
      </p:sp>
      <p:sp>
        <p:nvSpPr>
          <p:cNvPr id="73" name="TextBox 72"/>
          <p:cNvSpPr txBox="1"/>
          <p:nvPr/>
        </p:nvSpPr>
        <p:spPr>
          <a:xfrm>
            <a:off x="4038680" y="2694616"/>
            <a:ext cx="261610" cy="246221"/>
          </a:xfrm>
          <a:prstGeom prst="rect">
            <a:avLst/>
          </a:prstGeom>
          <a:noFill/>
        </p:spPr>
        <p:txBody>
          <a:bodyPr wrap="none" rtlCol="0">
            <a:spAutoFit/>
          </a:bodyPr>
          <a:lstStyle/>
          <a:p>
            <a:pPr lvl="0"/>
            <a:r>
              <a:rPr lang="en-US" sz="1000" dirty="0" smtClean="0">
                <a:solidFill>
                  <a:srgbClr val="000000"/>
                </a:solidFill>
              </a:rPr>
              <a:t>¶</a:t>
            </a:r>
            <a:endParaRPr lang="en-US" sz="1000" dirty="0">
              <a:solidFill>
                <a:srgbClr val="000000"/>
              </a:solidFill>
            </a:endParaRPr>
          </a:p>
        </p:txBody>
      </p:sp>
      <p:sp>
        <p:nvSpPr>
          <p:cNvPr id="74" name="Right Bracket 73"/>
          <p:cNvSpPr/>
          <p:nvPr/>
        </p:nvSpPr>
        <p:spPr>
          <a:xfrm>
            <a:off x="4054790" y="2756282"/>
            <a:ext cx="58860" cy="144022"/>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75" name="TextBox 74"/>
          <p:cNvSpPr txBox="1"/>
          <p:nvPr/>
        </p:nvSpPr>
        <p:spPr>
          <a:xfrm>
            <a:off x="4035182" y="1296924"/>
            <a:ext cx="248786" cy="246221"/>
          </a:xfrm>
          <a:prstGeom prst="rect">
            <a:avLst/>
          </a:prstGeom>
          <a:noFill/>
        </p:spPr>
        <p:txBody>
          <a:bodyPr wrap="none" rtlCol="0">
            <a:spAutoFit/>
          </a:bodyPr>
          <a:lstStyle/>
          <a:p>
            <a:pPr lvl="0"/>
            <a:r>
              <a:rPr lang="en-US" sz="1000" dirty="0">
                <a:solidFill>
                  <a:srgbClr val="000000"/>
                </a:solidFill>
              </a:rPr>
              <a:t>§</a:t>
            </a:r>
          </a:p>
        </p:txBody>
      </p:sp>
      <p:sp>
        <p:nvSpPr>
          <p:cNvPr id="86" name="Right Bracket 85"/>
          <p:cNvSpPr/>
          <p:nvPr/>
        </p:nvSpPr>
        <p:spPr>
          <a:xfrm>
            <a:off x="4051292" y="1358590"/>
            <a:ext cx="58860" cy="144022"/>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87" name="TextBox 86"/>
          <p:cNvSpPr txBox="1"/>
          <p:nvPr/>
        </p:nvSpPr>
        <p:spPr>
          <a:xfrm>
            <a:off x="4035182" y="4018281"/>
            <a:ext cx="248786" cy="246221"/>
          </a:xfrm>
          <a:prstGeom prst="rect">
            <a:avLst/>
          </a:prstGeom>
          <a:noFill/>
        </p:spPr>
        <p:txBody>
          <a:bodyPr wrap="none" rtlCol="0">
            <a:spAutoFit/>
          </a:bodyPr>
          <a:lstStyle/>
          <a:p>
            <a:pPr lvl="0"/>
            <a:r>
              <a:rPr lang="en-US" sz="1000" dirty="0">
                <a:solidFill>
                  <a:srgbClr val="000000"/>
                </a:solidFill>
              </a:rPr>
              <a:t>§</a:t>
            </a:r>
          </a:p>
        </p:txBody>
      </p:sp>
      <p:sp>
        <p:nvSpPr>
          <p:cNvPr id="88" name="Right Bracket 87"/>
          <p:cNvSpPr/>
          <p:nvPr/>
        </p:nvSpPr>
        <p:spPr>
          <a:xfrm>
            <a:off x="4051292" y="4079947"/>
            <a:ext cx="58860" cy="144022"/>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89" name="TextBox 88"/>
          <p:cNvSpPr txBox="1"/>
          <p:nvPr/>
        </p:nvSpPr>
        <p:spPr>
          <a:xfrm>
            <a:off x="4035182" y="5344622"/>
            <a:ext cx="248786" cy="246221"/>
          </a:xfrm>
          <a:prstGeom prst="rect">
            <a:avLst/>
          </a:prstGeom>
          <a:noFill/>
        </p:spPr>
        <p:txBody>
          <a:bodyPr wrap="none" rtlCol="0">
            <a:spAutoFit/>
          </a:bodyPr>
          <a:lstStyle/>
          <a:p>
            <a:pPr lvl="0"/>
            <a:r>
              <a:rPr lang="en-US" sz="1000" dirty="0">
                <a:solidFill>
                  <a:srgbClr val="000000"/>
                </a:solidFill>
              </a:rPr>
              <a:t>§</a:t>
            </a:r>
          </a:p>
        </p:txBody>
      </p:sp>
      <p:sp>
        <p:nvSpPr>
          <p:cNvPr id="90" name="Right Bracket 89"/>
          <p:cNvSpPr/>
          <p:nvPr/>
        </p:nvSpPr>
        <p:spPr>
          <a:xfrm>
            <a:off x="4051292" y="5406288"/>
            <a:ext cx="58860" cy="144022"/>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91" name="Right Bracket 90"/>
          <p:cNvSpPr/>
          <p:nvPr/>
        </p:nvSpPr>
        <p:spPr>
          <a:xfrm rot="16200000">
            <a:off x="6120157" y="997803"/>
            <a:ext cx="108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97" name="Right Bracket 96"/>
          <p:cNvSpPr/>
          <p:nvPr/>
        </p:nvSpPr>
        <p:spPr>
          <a:xfrm rot="16200000">
            <a:off x="5958141" y="2325778"/>
            <a:ext cx="144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99" name="TextBox 98"/>
          <p:cNvSpPr txBox="1"/>
          <p:nvPr/>
        </p:nvSpPr>
        <p:spPr>
          <a:xfrm>
            <a:off x="5746806" y="2420888"/>
            <a:ext cx="673031" cy="215444"/>
          </a:xfrm>
          <a:prstGeom prst="rect">
            <a:avLst/>
          </a:prstGeom>
          <a:noFill/>
        </p:spPr>
        <p:txBody>
          <a:bodyPr wrap="none" rtlCol="0">
            <a:spAutoFit/>
          </a:bodyPr>
          <a:lstStyle>
            <a:defPPr>
              <a:defRPr lang="en-US"/>
            </a:defPPr>
            <a:lvl1pPr>
              <a:defRPr sz="800"/>
            </a:lvl1pPr>
          </a:lstStyle>
          <a:p>
            <a:r>
              <a:rPr lang="en-US" dirty="0"/>
              <a:t>*</a:t>
            </a:r>
            <a:r>
              <a:rPr lang="en-US" dirty="0" smtClean="0"/>
              <a:t>p</a:t>
            </a:r>
            <a:r>
              <a:rPr lang="en-US" dirty="0"/>
              <a:t> </a:t>
            </a:r>
            <a:r>
              <a:rPr lang="en-US" dirty="0" smtClean="0"/>
              <a:t>&lt; 0.0001</a:t>
            </a:r>
            <a:endParaRPr lang="en-US" dirty="0"/>
          </a:p>
        </p:txBody>
      </p:sp>
      <p:sp>
        <p:nvSpPr>
          <p:cNvPr id="100" name="Right Bracket 99"/>
          <p:cNvSpPr/>
          <p:nvPr/>
        </p:nvSpPr>
        <p:spPr>
          <a:xfrm rot="16200000">
            <a:off x="6084119" y="2487802"/>
            <a:ext cx="108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101" name="TextBox 100"/>
          <p:cNvSpPr txBox="1"/>
          <p:nvPr/>
        </p:nvSpPr>
        <p:spPr>
          <a:xfrm>
            <a:off x="5890822" y="2592918"/>
            <a:ext cx="574647" cy="215444"/>
          </a:xfrm>
          <a:prstGeom prst="rect">
            <a:avLst/>
          </a:prstGeom>
          <a:noFill/>
        </p:spPr>
        <p:txBody>
          <a:bodyPr wrap="none" rtlCol="0">
            <a:spAutoFit/>
          </a:bodyPr>
          <a:lstStyle>
            <a:defPPr>
              <a:defRPr lang="en-US"/>
            </a:defPPr>
            <a:lvl1pPr>
              <a:defRPr sz="800"/>
            </a:lvl1pPr>
          </a:lstStyle>
          <a:p>
            <a:r>
              <a:rPr lang="en-US" dirty="0"/>
              <a:t>*p</a:t>
            </a:r>
            <a:r>
              <a:rPr lang="en-US" dirty="0" smtClean="0"/>
              <a:t>=0.003</a:t>
            </a:r>
            <a:endParaRPr lang="en-US" dirty="0"/>
          </a:p>
        </p:txBody>
      </p:sp>
      <p:sp>
        <p:nvSpPr>
          <p:cNvPr id="102" name="TextBox 101"/>
          <p:cNvSpPr txBox="1"/>
          <p:nvPr/>
        </p:nvSpPr>
        <p:spPr>
          <a:xfrm>
            <a:off x="7566158" y="716574"/>
            <a:ext cx="1224136" cy="215444"/>
          </a:xfrm>
          <a:prstGeom prst="rect">
            <a:avLst/>
          </a:prstGeom>
          <a:noFill/>
        </p:spPr>
        <p:txBody>
          <a:bodyPr wrap="square" rtlCol="0">
            <a:spAutoFit/>
          </a:bodyPr>
          <a:lstStyle/>
          <a:p>
            <a:pPr algn="r"/>
            <a:r>
              <a:rPr lang="en-US" sz="800" dirty="0" smtClean="0">
                <a:solidFill>
                  <a:schemeClr val="bg1"/>
                </a:solidFill>
              </a:rPr>
              <a:t>Cytostatic cells</a:t>
            </a:r>
            <a:endParaRPr lang="en-US" sz="800" dirty="0">
              <a:solidFill>
                <a:schemeClr val="bg1"/>
              </a:solidFill>
            </a:endParaRPr>
          </a:p>
        </p:txBody>
      </p:sp>
      <p:sp>
        <p:nvSpPr>
          <p:cNvPr id="103" name="TextBox 102"/>
          <p:cNvSpPr txBox="1"/>
          <p:nvPr/>
        </p:nvSpPr>
        <p:spPr>
          <a:xfrm>
            <a:off x="7569656" y="2107458"/>
            <a:ext cx="1224136" cy="215444"/>
          </a:xfrm>
          <a:prstGeom prst="rect">
            <a:avLst/>
          </a:prstGeom>
          <a:noFill/>
        </p:spPr>
        <p:txBody>
          <a:bodyPr wrap="square" rtlCol="0">
            <a:spAutoFit/>
          </a:bodyPr>
          <a:lstStyle/>
          <a:p>
            <a:pPr algn="r"/>
            <a:r>
              <a:rPr lang="en-US" sz="800" dirty="0" smtClean="0">
                <a:solidFill>
                  <a:schemeClr val="bg1"/>
                </a:solidFill>
              </a:rPr>
              <a:t>Dead cells</a:t>
            </a:r>
            <a:endParaRPr lang="en-US" sz="800" dirty="0">
              <a:solidFill>
                <a:schemeClr val="bg1"/>
              </a:solidFill>
            </a:endParaRPr>
          </a:p>
        </p:txBody>
      </p:sp>
      <p:sp>
        <p:nvSpPr>
          <p:cNvPr id="104" name="TextBox 103"/>
          <p:cNvSpPr txBox="1"/>
          <p:nvPr/>
        </p:nvSpPr>
        <p:spPr>
          <a:xfrm>
            <a:off x="7566158" y="3611641"/>
            <a:ext cx="1224136" cy="215444"/>
          </a:xfrm>
          <a:prstGeom prst="rect">
            <a:avLst/>
          </a:prstGeom>
          <a:noFill/>
        </p:spPr>
        <p:txBody>
          <a:bodyPr wrap="square" rtlCol="0">
            <a:spAutoFit/>
          </a:bodyPr>
          <a:lstStyle/>
          <a:p>
            <a:pPr algn="r"/>
            <a:r>
              <a:rPr lang="en-US" sz="800" dirty="0" smtClean="0">
                <a:solidFill>
                  <a:schemeClr val="bg1"/>
                </a:solidFill>
              </a:rPr>
              <a:t>Proliferative cells</a:t>
            </a:r>
            <a:endParaRPr lang="en-US" sz="800" dirty="0">
              <a:solidFill>
                <a:schemeClr val="bg1"/>
              </a:solidFill>
            </a:endParaRPr>
          </a:p>
        </p:txBody>
      </p:sp>
      <p:sp>
        <p:nvSpPr>
          <p:cNvPr id="105" name="TextBox 104"/>
          <p:cNvSpPr txBox="1"/>
          <p:nvPr/>
        </p:nvSpPr>
        <p:spPr>
          <a:xfrm>
            <a:off x="7566158" y="5043682"/>
            <a:ext cx="1224136" cy="215444"/>
          </a:xfrm>
          <a:prstGeom prst="rect">
            <a:avLst/>
          </a:prstGeom>
          <a:noFill/>
        </p:spPr>
        <p:txBody>
          <a:bodyPr wrap="square" rtlCol="0">
            <a:spAutoFit/>
          </a:bodyPr>
          <a:lstStyle/>
          <a:p>
            <a:pPr algn="r"/>
            <a:r>
              <a:rPr lang="en-US" sz="800" dirty="0" smtClean="0">
                <a:solidFill>
                  <a:schemeClr val="bg1"/>
                </a:solidFill>
              </a:rPr>
              <a:t>Proliferative cells</a:t>
            </a:r>
            <a:endParaRPr lang="en-US" sz="800" dirty="0">
              <a:solidFill>
                <a:schemeClr val="bg1"/>
              </a:solidFill>
            </a:endParaRPr>
          </a:p>
        </p:txBody>
      </p:sp>
      <p:sp>
        <p:nvSpPr>
          <p:cNvPr id="106" name="Right Bracket 105"/>
          <p:cNvSpPr/>
          <p:nvPr/>
        </p:nvSpPr>
        <p:spPr>
          <a:xfrm rot="16200000">
            <a:off x="6030217" y="3621922"/>
            <a:ext cx="144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107" name="TextBox 106"/>
          <p:cNvSpPr txBox="1"/>
          <p:nvPr/>
        </p:nvSpPr>
        <p:spPr>
          <a:xfrm>
            <a:off x="5818882" y="3717032"/>
            <a:ext cx="522649" cy="215444"/>
          </a:xfrm>
          <a:prstGeom prst="rect">
            <a:avLst/>
          </a:prstGeom>
          <a:noFill/>
        </p:spPr>
        <p:txBody>
          <a:bodyPr wrap="none" rtlCol="0">
            <a:spAutoFit/>
          </a:bodyPr>
          <a:lstStyle>
            <a:defPPr>
              <a:defRPr lang="en-US"/>
            </a:defPPr>
            <a:lvl1pPr>
              <a:defRPr sz="800"/>
            </a:lvl1pPr>
          </a:lstStyle>
          <a:p>
            <a:r>
              <a:rPr lang="en-US" dirty="0"/>
              <a:t>*p</a:t>
            </a:r>
            <a:r>
              <a:rPr lang="en-US" dirty="0" smtClean="0"/>
              <a:t>=0.02</a:t>
            </a:r>
            <a:endParaRPr lang="en-US" dirty="0"/>
          </a:p>
        </p:txBody>
      </p:sp>
      <p:sp>
        <p:nvSpPr>
          <p:cNvPr id="108" name="Right Bracket 107"/>
          <p:cNvSpPr/>
          <p:nvPr/>
        </p:nvSpPr>
        <p:spPr>
          <a:xfrm rot="16200000">
            <a:off x="6156195" y="3783946"/>
            <a:ext cx="108008" cy="756050"/>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110" name="TextBox 109"/>
          <p:cNvSpPr txBox="1"/>
          <p:nvPr/>
        </p:nvSpPr>
        <p:spPr>
          <a:xfrm>
            <a:off x="6047262" y="3894682"/>
            <a:ext cx="254923" cy="261610"/>
          </a:xfrm>
          <a:prstGeom prst="rect">
            <a:avLst/>
          </a:prstGeom>
          <a:noFill/>
        </p:spPr>
        <p:txBody>
          <a:bodyPr wrap="none" rtlCol="0">
            <a:spAutoFit/>
          </a:bodyPr>
          <a:lstStyle/>
          <a:p>
            <a:r>
              <a:rPr lang="en-US" sz="1050" dirty="0" smtClean="0"/>
              <a:t>§</a:t>
            </a:r>
            <a:endParaRPr lang="en-US" sz="1050" dirty="0"/>
          </a:p>
        </p:txBody>
      </p:sp>
      <p:sp>
        <p:nvSpPr>
          <p:cNvPr id="113" name="TextBox 112"/>
          <p:cNvSpPr txBox="1"/>
          <p:nvPr/>
        </p:nvSpPr>
        <p:spPr>
          <a:xfrm>
            <a:off x="5738837" y="5184622"/>
            <a:ext cx="574647" cy="215444"/>
          </a:xfrm>
          <a:prstGeom prst="rect">
            <a:avLst/>
          </a:prstGeom>
          <a:noFill/>
        </p:spPr>
        <p:txBody>
          <a:bodyPr wrap="none" rtlCol="0">
            <a:spAutoFit/>
          </a:bodyPr>
          <a:lstStyle>
            <a:defPPr>
              <a:defRPr lang="en-US"/>
            </a:defPPr>
            <a:lvl1pPr>
              <a:defRPr sz="800"/>
            </a:lvl1pPr>
          </a:lstStyle>
          <a:p>
            <a:r>
              <a:rPr lang="en-US" dirty="0"/>
              <a:t>*p</a:t>
            </a:r>
            <a:r>
              <a:rPr lang="en-US" dirty="0" smtClean="0"/>
              <a:t>=0.001</a:t>
            </a:r>
            <a:endParaRPr lang="en-US" dirty="0"/>
          </a:p>
        </p:txBody>
      </p:sp>
      <p:sp>
        <p:nvSpPr>
          <p:cNvPr id="115" name="TextBox 114"/>
          <p:cNvSpPr txBox="1"/>
          <p:nvPr/>
        </p:nvSpPr>
        <p:spPr>
          <a:xfrm>
            <a:off x="5869561" y="5373796"/>
            <a:ext cx="522649" cy="215444"/>
          </a:xfrm>
          <a:prstGeom prst="rect">
            <a:avLst/>
          </a:prstGeom>
          <a:noFill/>
        </p:spPr>
        <p:txBody>
          <a:bodyPr wrap="none" rtlCol="0">
            <a:spAutoFit/>
          </a:bodyPr>
          <a:lstStyle>
            <a:defPPr>
              <a:defRPr lang="en-US"/>
            </a:defPPr>
            <a:lvl1pPr>
              <a:defRPr sz="800"/>
            </a:lvl1pPr>
          </a:lstStyle>
          <a:p>
            <a:r>
              <a:rPr lang="en-US" dirty="0"/>
              <a:t>*p</a:t>
            </a:r>
            <a:r>
              <a:rPr lang="en-US" dirty="0" smtClean="0"/>
              <a:t>=0.01</a:t>
            </a:r>
            <a:endParaRPr lang="en-US" dirty="0"/>
          </a:p>
        </p:txBody>
      </p:sp>
    </p:spTree>
    <p:extLst>
      <p:ext uri="{BB962C8B-B14F-4D97-AF65-F5344CB8AC3E}">
        <p14:creationId xmlns:p14="http://schemas.microsoft.com/office/powerpoint/2010/main" xmlns="" val="355283086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Custom 3">
      <a:dk1>
        <a:srgbClr val="000000"/>
      </a:dk1>
      <a:lt1>
        <a:srgbClr val="FFFFFF"/>
      </a:lt1>
      <a:dk2>
        <a:srgbClr val="242852"/>
      </a:dk2>
      <a:lt2>
        <a:srgbClr val="ACCBF9"/>
      </a:lt2>
      <a:accent1>
        <a:srgbClr val="000000"/>
      </a:accent1>
      <a:accent2>
        <a:srgbClr val="521B92"/>
      </a:accent2>
      <a:accent3>
        <a:srgbClr val="0432FF"/>
      </a:accent3>
      <a:accent4>
        <a:srgbClr val="008E00"/>
      </a:accent4>
      <a:accent5>
        <a:srgbClr val="FEFB00"/>
      </a:accent5>
      <a:accent6>
        <a:srgbClr val="FF9300"/>
      </a:accent6>
      <a:hlink>
        <a:srgbClr val="9454C3"/>
      </a:hlink>
      <a:folHlink>
        <a:srgbClr val="3EBBF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817</TotalTime>
  <Words>218</Words>
  <Application>Microsoft Office PowerPoint</Application>
  <PresentationFormat>On-screen Show (4:3)</PresentationFormat>
  <Paragraphs>6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vCaRe Lab</dc:creator>
  <cp:lastModifiedBy>0013357</cp:lastModifiedBy>
  <cp:revision>114</cp:revision>
  <cp:lastPrinted>2018-08-29T23:14:01Z</cp:lastPrinted>
  <dcterms:created xsi:type="dcterms:W3CDTF">2018-04-30T18:03:31Z</dcterms:created>
  <dcterms:modified xsi:type="dcterms:W3CDTF">2019-01-04T04:09:01Z</dcterms:modified>
</cp:coreProperties>
</file>